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38" y="1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Promotion\Aromatische%20Amine%20Esquire\160115_ionensupression\160115_ionensupression_ohne_Ausrei&#223;er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Promotion\Aromatische%20Amine%20Esquire\160115_ionensupression\160115_ionensupression_ohne_Ausrei&#223;er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DE"/>
              <a:t>50/50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H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abelle1!$F$5:$F$14</c:f>
                <c:numCache>
                  <c:formatCode>General</c:formatCode>
                  <c:ptCount val="10"/>
                  <c:pt idx="0">
                    <c:v>306937.37604355061</c:v>
                  </c:pt>
                  <c:pt idx="1">
                    <c:v>20659.53882592736</c:v>
                  </c:pt>
                  <c:pt idx="2">
                    <c:v>118377.01080164732</c:v>
                  </c:pt>
                  <c:pt idx="3">
                    <c:v>72569.456559446087</c:v>
                  </c:pt>
                  <c:pt idx="4">
                    <c:v>6250.5858125458926</c:v>
                  </c:pt>
                  <c:pt idx="5">
                    <c:v>5318.7931275180599</c:v>
                  </c:pt>
                  <c:pt idx="6">
                    <c:v>22577.19307177046</c:v>
                  </c:pt>
                  <c:pt idx="7">
                    <c:v>14333.757962702362</c:v>
                  </c:pt>
                  <c:pt idx="8">
                    <c:v>174620.18208385879</c:v>
                  </c:pt>
                  <c:pt idx="9">
                    <c:v>65048.715752119198</c:v>
                  </c:pt>
                </c:numCache>
              </c:numRef>
            </c:plus>
            <c:minus>
              <c:numRef>
                <c:f>Tabelle1!$F$5:$F$14</c:f>
                <c:numCache>
                  <c:formatCode>General</c:formatCode>
                  <c:ptCount val="10"/>
                  <c:pt idx="0">
                    <c:v>306937.37604355061</c:v>
                  </c:pt>
                  <c:pt idx="1">
                    <c:v>20659.53882592736</c:v>
                  </c:pt>
                  <c:pt idx="2">
                    <c:v>118377.01080164732</c:v>
                  </c:pt>
                  <c:pt idx="3">
                    <c:v>72569.456559446087</c:v>
                  </c:pt>
                  <c:pt idx="4">
                    <c:v>6250.5858125458926</c:v>
                  </c:pt>
                  <c:pt idx="5">
                    <c:v>5318.7931275180599</c:v>
                  </c:pt>
                  <c:pt idx="6">
                    <c:v>22577.19307177046</c:v>
                  </c:pt>
                  <c:pt idx="7">
                    <c:v>14333.757962702362</c:v>
                  </c:pt>
                  <c:pt idx="8">
                    <c:v>174620.18208385879</c:v>
                  </c:pt>
                  <c:pt idx="9">
                    <c:v>65048.7157521191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abelle1!$A$5:$A$14</c:f>
              <c:strCache>
                <c:ptCount val="10"/>
                <c:pt idx="0">
                  <c:v>degased</c:v>
                </c:pt>
                <c:pt idx="1">
                  <c:v>not degased</c:v>
                </c:pt>
                <c:pt idx="2">
                  <c:v>NaCl</c:v>
                </c:pt>
                <c:pt idx="3">
                  <c:v>NH4Cl</c:v>
                </c:pt>
                <c:pt idx="4">
                  <c:v>NaHCOO </c:v>
                </c:pt>
                <c:pt idx="5">
                  <c:v>NH4HCOO</c:v>
                </c:pt>
                <c:pt idx="6">
                  <c:v>NaF</c:v>
                </c:pt>
                <c:pt idx="7">
                  <c:v>NH4F</c:v>
                </c:pt>
                <c:pt idx="8">
                  <c:v>HCOOH</c:v>
                </c:pt>
                <c:pt idx="9">
                  <c:v>HCl </c:v>
                </c:pt>
              </c:strCache>
            </c:strRef>
          </c:cat>
          <c:val>
            <c:numRef>
              <c:f>Tabelle1!$E$5:$E$14</c:f>
              <c:numCache>
                <c:formatCode>General</c:formatCode>
                <c:ptCount val="10"/>
                <c:pt idx="0">
                  <c:v>491663.5</c:v>
                </c:pt>
                <c:pt idx="1">
                  <c:v>288307.5</c:v>
                </c:pt>
                <c:pt idx="2">
                  <c:v>234385.66666666666</c:v>
                </c:pt>
                <c:pt idx="3">
                  <c:v>149539.33333333334</c:v>
                </c:pt>
                <c:pt idx="4">
                  <c:v>6432</c:v>
                </c:pt>
                <c:pt idx="5">
                  <c:v>10231.666666666666</c:v>
                </c:pt>
                <c:pt idx="6">
                  <c:v>25623</c:v>
                </c:pt>
                <c:pt idx="7">
                  <c:v>25356.333333333332</c:v>
                </c:pt>
                <c:pt idx="8">
                  <c:v>1111167</c:v>
                </c:pt>
                <c:pt idx="9">
                  <c:v>76968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2B3-42C7-95D2-DFF95D54C06C}"/>
            </c:ext>
          </c:extLst>
        </c:ser>
        <c:ser>
          <c:idx val="1"/>
          <c:order val="1"/>
          <c:tx>
            <c:v>4-pyridine</c:v>
          </c:tx>
          <c:spPr>
            <a:pattFill prst="pct2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abelle1!$N$5:$N$14</c:f>
                <c:numCache>
                  <c:formatCode>General</c:formatCode>
                  <c:ptCount val="10"/>
                  <c:pt idx="0">
                    <c:v>313021.62732682441</c:v>
                  </c:pt>
                  <c:pt idx="1">
                    <c:v>256318.35090826667</c:v>
                  </c:pt>
                  <c:pt idx="2">
                    <c:v>44566.828475148795</c:v>
                  </c:pt>
                  <c:pt idx="3">
                    <c:v>81314.588865303464</c:v>
                  </c:pt>
                  <c:pt idx="4">
                    <c:v>6025.3456609005707</c:v>
                  </c:pt>
                  <c:pt idx="5">
                    <c:v>32566.090047778227</c:v>
                  </c:pt>
                  <c:pt idx="6">
                    <c:v>55328.544588967219</c:v>
                  </c:pt>
                  <c:pt idx="7">
                    <c:v>34218.069217885452</c:v>
                  </c:pt>
                  <c:pt idx="8">
                    <c:v>109239.66359798075</c:v>
                  </c:pt>
                  <c:pt idx="9">
                    <c:v>47031.164150309247</c:v>
                  </c:pt>
                </c:numCache>
              </c:numRef>
            </c:plus>
            <c:minus>
              <c:numRef>
                <c:f>Tabelle1!$N$5:$N$14</c:f>
                <c:numCache>
                  <c:formatCode>General</c:formatCode>
                  <c:ptCount val="10"/>
                  <c:pt idx="0">
                    <c:v>313021.62732682441</c:v>
                  </c:pt>
                  <c:pt idx="1">
                    <c:v>256318.35090826667</c:v>
                  </c:pt>
                  <c:pt idx="2">
                    <c:v>44566.828475148795</c:v>
                  </c:pt>
                  <c:pt idx="3">
                    <c:v>81314.588865303464</c:v>
                  </c:pt>
                  <c:pt idx="4">
                    <c:v>6025.3456609005707</c:v>
                  </c:pt>
                  <c:pt idx="5">
                    <c:v>32566.090047778227</c:v>
                  </c:pt>
                  <c:pt idx="6">
                    <c:v>55328.544588967219</c:v>
                  </c:pt>
                  <c:pt idx="7">
                    <c:v>34218.069217885452</c:v>
                  </c:pt>
                  <c:pt idx="8">
                    <c:v>109239.66359798075</c:v>
                  </c:pt>
                  <c:pt idx="9">
                    <c:v>47031.16415030924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Tabelle1!$M$5:$M$14</c:f>
              <c:numCache>
                <c:formatCode>General</c:formatCode>
                <c:ptCount val="10"/>
                <c:pt idx="0">
                  <c:v>3053785.6666666665</c:v>
                </c:pt>
                <c:pt idx="1">
                  <c:v>3124944.3333333335</c:v>
                </c:pt>
                <c:pt idx="2">
                  <c:v>1327419.3333333333</c:v>
                </c:pt>
                <c:pt idx="3">
                  <c:v>1422290.3333333333</c:v>
                </c:pt>
                <c:pt idx="4">
                  <c:v>1204479.3333333333</c:v>
                </c:pt>
                <c:pt idx="5">
                  <c:v>1663238</c:v>
                </c:pt>
                <c:pt idx="6">
                  <c:v>1312138.3333333333</c:v>
                </c:pt>
                <c:pt idx="7">
                  <c:v>1767342</c:v>
                </c:pt>
                <c:pt idx="8">
                  <c:v>1881895</c:v>
                </c:pt>
                <c:pt idx="9">
                  <c:v>1681668.666666666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C2B3-42C7-95D2-DFF95D54C06C}"/>
            </c:ext>
          </c:extLst>
        </c:ser>
        <c:ser>
          <c:idx val="2"/>
          <c:order val="2"/>
          <c:tx>
            <c:v>4-CN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abelle1!$V$5:$V$14</c:f>
                <c:numCache>
                  <c:formatCode>General</c:formatCode>
                  <c:ptCount val="10"/>
                  <c:pt idx="0">
                    <c:v>303141.52184582036</c:v>
                  </c:pt>
                  <c:pt idx="1">
                    <c:v>413416.24776488892</c:v>
                  </c:pt>
                  <c:pt idx="2">
                    <c:v>99405.550128417555</c:v>
                  </c:pt>
                  <c:pt idx="3">
                    <c:v>48974.289013045847</c:v>
                  </c:pt>
                  <c:pt idx="4">
                    <c:v>827.05441175293902</c:v>
                  </c:pt>
                  <c:pt idx="5">
                    <c:v>93910.397690209546</c:v>
                  </c:pt>
                  <c:pt idx="6">
                    <c:v>2099.9184111134718</c:v>
                  </c:pt>
                  <c:pt idx="7">
                    <c:v>104425.15889861026</c:v>
                  </c:pt>
                  <c:pt idx="8">
                    <c:v>68639.709136427264</c:v>
                  </c:pt>
                  <c:pt idx="9">
                    <c:v>67073.547761642461</c:v>
                  </c:pt>
                </c:numCache>
              </c:numRef>
            </c:plus>
            <c:minus>
              <c:numRef>
                <c:f>Tabelle1!$V$5:$V$14</c:f>
                <c:numCache>
                  <c:formatCode>General</c:formatCode>
                  <c:ptCount val="10"/>
                  <c:pt idx="0">
                    <c:v>303141.52184582036</c:v>
                  </c:pt>
                  <c:pt idx="1">
                    <c:v>413416.24776488892</c:v>
                  </c:pt>
                  <c:pt idx="2">
                    <c:v>99405.550128417555</c:v>
                  </c:pt>
                  <c:pt idx="3">
                    <c:v>48974.289013045847</c:v>
                  </c:pt>
                  <c:pt idx="4">
                    <c:v>827.05441175293902</c:v>
                  </c:pt>
                  <c:pt idx="5">
                    <c:v>93910.397690209546</c:v>
                  </c:pt>
                  <c:pt idx="6">
                    <c:v>2099.9184111134718</c:v>
                  </c:pt>
                  <c:pt idx="7">
                    <c:v>104425.15889861026</c:v>
                  </c:pt>
                  <c:pt idx="8">
                    <c:v>68639.709136427264</c:v>
                  </c:pt>
                  <c:pt idx="9">
                    <c:v>67073.54776164246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Tabelle1!$U$5:$U$14</c:f>
              <c:numCache>
                <c:formatCode>General</c:formatCode>
                <c:ptCount val="10"/>
                <c:pt idx="0">
                  <c:v>457670</c:v>
                </c:pt>
                <c:pt idx="1">
                  <c:v>490365</c:v>
                </c:pt>
                <c:pt idx="2">
                  <c:v>174090.33333333334</c:v>
                </c:pt>
                <c:pt idx="3">
                  <c:v>331295.66666666669</c:v>
                </c:pt>
                <c:pt idx="4">
                  <c:v>4053</c:v>
                </c:pt>
                <c:pt idx="5">
                  <c:v>471599.33333333331</c:v>
                </c:pt>
                <c:pt idx="6">
                  <c:v>6915.666666666667</c:v>
                </c:pt>
                <c:pt idx="7">
                  <c:v>495644</c:v>
                </c:pt>
                <c:pt idx="8">
                  <c:v>209629.33333333334</c:v>
                </c:pt>
                <c:pt idx="9">
                  <c:v>1033801.666666666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C2B3-42C7-95D2-DFF95D54C06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0368032"/>
        <c:axId val="188960448"/>
      </c:barChart>
      <c:catAx>
        <c:axId val="1403680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88960448"/>
        <c:crosses val="autoZero"/>
        <c:auto val="1"/>
        <c:lblAlgn val="ctr"/>
        <c:lblOffset val="100"/>
        <c:noMultiLvlLbl val="0"/>
      </c:catAx>
      <c:valAx>
        <c:axId val="188960448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/>
                  <a:t>intensity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0.00E+0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40368032"/>
        <c:crosses val="autoZero"/>
        <c:crossBetween val="between"/>
        <c:majorUnit val="2000000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2233447663554271"/>
          <c:y val="0.19842260381880858"/>
          <c:w val="0.14819775312829325"/>
          <c:h val="0.22721648828740001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DE"/>
              <a:t>80/20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H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abelle1!$F$20:$F$29</c:f>
                <c:numCache>
                  <c:formatCode>General</c:formatCode>
                  <c:ptCount val="10"/>
                  <c:pt idx="0">
                    <c:v>53270.596467469746</c:v>
                  </c:pt>
                  <c:pt idx="1">
                    <c:v>62645.418172440994</c:v>
                  </c:pt>
                  <c:pt idx="2">
                    <c:v>50517.680759644376</c:v>
                  </c:pt>
                  <c:pt idx="3">
                    <c:v>53518.862628049188</c:v>
                  </c:pt>
                  <c:pt idx="4">
                    <c:v>8698.4826837788205</c:v>
                  </c:pt>
                  <c:pt idx="5">
                    <c:v>60411.653563971689</c:v>
                  </c:pt>
                  <c:pt idx="6">
                    <c:v>22843.402264111184</c:v>
                  </c:pt>
                  <c:pt idx="7">
                    <c:v>18464.485885071375</c:v>
                  </c:pt>
                  <c:pt idx="8">
                    <c:v>66205.996805425413</c:v>
                  </c:pt>
                  <c:pt idx="9">
                    <c:v>39388.833155265376</c:v>
                  </c:pt>
                </c:numCache>
              </c:numRef>
            </c:plus>
            <c:minus>
              <c:numRef>
                <c:f>Tabelle1!$F$20:$F$29</c:f>
                <c:numCache>
                  <c:formatCode>General</c:formatCode>
                  <c:ptCount val="10"/>
                  <c:pt idx="0">
                    <c:v>53270.596467469746</c:v>
                  </c:pt>
                  <c:pt idx="1">
                    <c:v>62645.418172440994</c:v>
                  </c:pt>
                  <c:pt idx="2">
                    <c:v>50517.680759644376</c:v>
                  </c:pt>
                  <c:pt idx="3">
                    <c:v>53518.862628049188</c:v>
                  </c:pt>
                  <c:pt idx="4">
                    <c:v>8698.4826837788205</c:v>
                  </c:pt>
                  <c:pt idx="5">
                    <c:v>60411.653563971689</c:v>
                  </c:pt>
                  <c:pt idx="6">
                    <c:v>22843.402264111184</c:v>
                  </c:pt>
                  <c:pt idx="7">
                    <c:v>18464.485885071375</c:v>
                  </c:pt>
                  <c:pt idx="8">
                    <c:v>66205.996805425413</c:v>
                  </c:pt>
                  <c:pt idx="9">
                    <c:v>39388.83315526537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abelle1!$A$5:$A$14</c:f>
              <c:strCache>
                <c:ptCount val="10"/>
                <c:pt idx="0">
                  <c:v>degased</c:v>
                </c:pt>
                <c:pt idx="1">
                  <c:v>not degased</c:v>
                </c:pt>
                <c:pt idx="2">
                  <c:v>NaCl</c:v>
                </c:pt>
                <c:pt idx="3">
                  <c:v>NH4Cl</c:v>
                </c:pt>
                <c:pt idx="4">
                  <c:v>NaHCOO </c:v>
                </c:pt>
                <c:pt idx="5">
                  <c:v>NH4HCOO</c:v>
                </c:pt>
                <c:pt idx="6">
                  <c:v>NaF</c:v>
                </c:pt>
                <c:pt idx="7">
                  <c:v>NH4F</c:v>
                </c:pt>
                <c:pt idx="8">
                  <c:v>HCOOH</c:v>
                </c:pt>
                <c:pt idx="9">
                  <c:v>HCl </c:v>
                </c:pt>
              </c:strCache>
            </c:strRef>
          </c:cat>
          <c:val>
            <c:numRef>
              <c:f>Tabelle1!$E$20:$E$29</c:f>
              <c:numCache>
                <c:formatCode>General</c:formatCode>
                <c:ptCount val="10"/>
                <c:pt idx="0">
                  <c:v>1009757</c:v>
                </c:pt>
                <c:pt idx="1">
                  <c:v>868169</c:v>
                </c:pt>
                <c:pt idx="2">
                  <c:v>358431.66666666669</c:v>
                </c:pt>
                <c:pt idx="3">
                  <c:v>259294</c:v>
                </c:pt>
                <c:pt idx="4">
                  <c:v>24672</c:v>
                </c:pt>
                <c:pt idx="5">
                  <c:v>67099.333333333328</c:v>
                </c:pt>
                <c:pt idx="6">
                  <c:v>55423</c:v>
                </c:pt>
                <c:pt idx="7">
                  <c:v>32376</c:v>
                </c:pt>
                <c:pt idx="8">
                  <c:v>1369734</c:v>
                </c:pt>
                <c:pt idx="9">
                  <c:v>908658.6666666666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2B3-42C7-95D2-DFF95D54C06C}"/>
            </c:ext>
          </c:extLst>
        </c:ser>
        <c:ser>
          <c:idx val="1"/>
          <c:order val="1"/>
          <c:tx>
            <c:v>4-pyridine</c:v>
          </c:tx>
          <c:spPr>
            <a:pattFill prst="pct2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abelle1!$N$20:$N$29</c:f>
                <c:numCache>
                  <c:formatCode>General</c:formatCode>
                  <c:ptCount val="10"/>
                  <c:pt idx="0">
                    <c:v>222099.58464691765</c:v>
                  </c:pt>
                  <c:pt idx="1">
                    <c:v>155508.73841149037</c:v>
                  </c:pt>
                  <c:pt idx="2">
                    <c:v>108234.92142711305</c:v>
                  </c:pt>
                  <c:pt idx="3">
                    <c:v>118221.0335783499</c:v>
                  </c:pt>
                  <c:pt idx="4">
                    <c:v>75792.955407038549</c:v>
                  </c:pt>
                  <c:pt idx="5">
                    <c:v>163531.804723118</c:v>
                  </c:pt>
                  <c:pt idx="6">
                    <c:v>78684.626986470495</c:v>
                  </c:pt>
                  <c:pt idx="7">
                    <c:v>84276.545493591111</c:v>
                  </c:pt>
                  <c:pt idx="8">
                    <c:v>219723.42389695279</c:v>
                  </c:pt>
                  <c:pt idx="9">
                    <c:v>93548.056721309462</c:v>
                  </c:pt>
                </c:numCache>
              </c:numRef>
            </c:plus>
            <c:minus>
              <c:numRef>
                <c:f>Tabelle1!$N$20:$N$29</c:f>
                <c:numCache>
                  <c:formatCode>General</c:formatCode>
                  <c:ptCount val="10"/>
                  <c:pt idx="0">
                    <c:v>222099.58464691765</c:v>
                  </c:pt>
                  <c:pt idx="1">
                    <c:v>155508.73841149037</c:v>
                  </c:pt>
                  <c:pt idx="2">
                    <c:v>108234.92142711305</c:v>
                  </c:pt>
                  <c:pt idx="3">
                    <c:v>118221.0335783499</c:v>
                  </c:pt>
                  <c:pt idx="4">
                    <c:v>75792.955407038549</c:v>
                  </c:pt>
                  <c:pt idx="5">
                    <c:v>163531.804723118</c:v>
                  </c:pt>
                  <c:pt idx="6">
                    <c:v>78684.626986470495</c:v>
                  </c:pt>
                  <c:pt idx="7">
                    <c:v>84276.545493591111</c:v>
                  </c:pt>
                  <c:pt idx="8">
                    <c:v>219723.42389695279</c:v>
                  </c:pt>
                  <c:pt idx="9">
                    <c:v>93548.05672130946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Tabelle1!$M$20:$M$29</c:f>
              <c:numCache>
                <c:formatCode>General</c:formatCode>
                <c:ptCount val="10"/>
                <c:pt idx="0">
                  <c:v>3070444.3333333335</c:v>
                </c:pt>
                <c:pt idx="1">
                  <c:v>3323622.6666666665</c:v>
                </c:pt>
                <c:pt idx="2">
                  <c:v>1429264.6666666667</c:v>
                </c:pt>
                <c:pt idx="3">
                  <c:v>1495688.6666666667</c:v>
                </c:pt>
                <c:pt idx="4">
                  <c:v>1295499.3333333333</c:v>
                </c:pt>
                <c:pt idx="5">
                  <c:v>1815796</c:v>
                </c:pt>
                <c:pt idx="6">
                  <c:v>1450702</c:v>
                </c:pt>
                <c:pt idx="7">
                  <c:v>1848045.3333333333</c:v>
                </c:pt>
                <c:pt idx="8">
                  <c:v>2280676</c:v>
                </c:pt>
                <c:pt idx="9">
                  <c:v>1842752.333333333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C2B3-42C7-95D2-DFF95D54C06C}"/>
            </c:ext>
          </c:extLst>
        </c:ser>
        <c:ser>
          <c:idx val="2"/>
          <c:order val="2"/>
          <c:tx>
            <c:v>4-CN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abelle1!$V$20:$V$29</c:f>
                <c:numCache>
                  <c:formatCode>General</c:formatCode>
                  <c:ptCount val="10"/>
                  <c:pt idx="0">
                    <c:v>35070.553550426514</c:v>
                  </c:pt>
                  <c:pt idx="1">
                    <c:v>4584.9358774142083</c:v>
                  </c:pt>
                  <c:pt idx="2">
                    <c:v>30186.574604173555</c:v>
                  </c:pt>
                  <c:pt idx="3">
                    <c:v>19183.906232395249</c:v>
                  </c:pt>
                  <c:pt idx="4">
                    <c:v>1222.9539375353972</c:v>
                  </c:pt>
                  <c:pt idx="5">
                    <c:v>35062.194188803071</c:v>
                  </c:pt>
                  <c:pt idx="6">
                    <c:v>991.83063070264166</c:v>
                  </c:pt>
                  <c:pt idx="7">
                    <c:v>34969.783661517387</c:v>
                  </c:pt>
                  <c:pt idx="8">
                    <c:v>26017.560896440697</c:v>
                  </c:pt>
                  <c:pt idx="9">
                    <c:v>57152.804165675021</c:v>
                  </c:pt>
                </c:numCache>
              </c:numRef>
            </c:plus>
            <c:minus>
              <c:numRef>
                <c:f>Tabelle1!$V$20:$V$29</c:f>
                <c:numCache>
                  <c:formatCode>General</c:formatCode>
                  <c:ptCount val="10"/>
                  <c:pt idx="0">
                    <c:v>35070.553550426514</c:v>
                  </c:pt>
                  <c:pt idx="1">
                    <c:v>4584.9358774142083</c:v>
                  </c:pt>
                  <c:pt idx="2">
                    <c:v>30186.574604173555</c:v>
                  </c:pt>
                  <c:pt idx="3">
                    <c:v>19183.906232395249</c:v>
                  </c:pt>
                  <c:pt idx="4">
                    <c:v>1222.9539375353972</c:v>
                  </c:pt>
                  <c:pt idx="5">
                    <c:v>35062.194188803071</c:v>
                  </c:pt>
                  <c:pt idx="6">
                    <c:v>991.83063070264166</c:v>
                  </c:pt>
                  <c:pt idx="7">
                    <c:v>34969.783661517387</c:v>
                  </c:pt>
                  <c:pt idx="8">
                    <c:v>26017.560896440697</c:v>
                  </c:pt>
                  <c:pt idx="9">
                    <c:v>57152.80416567502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Tabelle1!$U$20:$U$29</c:f>
              <c:numCache>
                <c:formatCode>General</c:formatCode>
                <c:ptCount val="10"/>
                <c:pt idx="0">
                  <c:v>644561.33333333337</c:v>
                </c:pt>
                <c:pt idx="1">
                  <c:v>542627</c:v>
                </c:pt>
                <c:pt idx="2">
                  <c:v>197029.33333333334</c:v>
                </c:pt>
                <c:pt idx="3">
                  <c:v>177466.33333333334</c:v>
                </c:pt>
                <c:pt idx="4">
                  <c:v>4686.333333333333</c:v>
                </c:pt>
                <c:pt idx="5">
                  <c:v>208931.66666666666</c:v>
                </c:pt>
                <c:pt idx="6">
                  <c:v>4351</c:v>
                </c:pt>
                <c:pt idx="7">
                  <c:v>269190.33333333331</c:v>
                </c:pt>
                <c:pt idx="8">
                  <c:v>240706</c:v>
                </c:pt>
                <c:pt idx="9">
                  <c:v>95712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C2B3-42C7-95D2-DFF95D54C06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8963248"/>
        <c:axId val="188963808"/>
      </c:barChart>
      <c:catAx>
        <c:axId val="1889632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88963808"/>
        <c:crosses val="autoZero"/>
        <c:auto val="1"/>
        <c:lblAlgn val="ctr"/>
        <c:lblOffset val="100"/>
        <c:noMultiLvlLbl val="0"/>
      </c:catAx>
      <c:valAx>
        <c:axId val="1889638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/>
                  <a:t>intensity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0.00E+0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88963248"/>
        <c:crosses val="autoZero"/>
        <c:crossBetween val="between"/>
        <c:majorUnit val="2000000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1125534474917926"/>
          <c:y val="0.1899173834031482"/>
          <c:w val="0.1478241469816273"/>
          <c:h val="0.2343766404199475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8CDC2-EA54-4E6F-9B40-A3A519426447}" type="datetimeFigureOut">
              <a:rPr lang="de-DE" smtClean="0"/>
              <a:t>26.10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B40769-BA91-45F4-A1BD-C6101B4EABE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306156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8CDC2-EA54-4E6F-9B40-A3A519426447}" type="datetimeFigureOut">
              <a:rPr lang="de-DE" smtClean="0"/>
              <a:t>26.10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B40769-BA91-45F4-A1BD-C6101B4EABE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00814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8CDC2-EA54-4E6F-9B40-A3A519426447}" type="datetimeFigureOut">
              <a:rPr lang="de-DE" smtClean="0"/>
              <a:t>26.10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B40769-BA91-45F4-A1BD-C6101B4EABE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63425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8CDC2-EA54-4E6F-9B40-A3A519426447}" type="datetimeFigureOut">
              <a:rPr lang="de-DE" smtClean="0"/>
              <a:t>26.10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B40769-BA91-45F4-A1BD-C6101B4EABE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359093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8CDC2-EA54-4E6F-9B40-A3A519426447}" type="datetimeFigureOut">
              <a:rPr lang="de-DE" smtClean="0"/>
              <a:t>26.10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B40769-BA91-45F4-A1BD-C6101B4EABE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561721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8CDC2-EA54-4E6F-9B40-A3A519426447}" type="datetimeFigureOut">
              <a:rPr lang="de-DE" smtClean="0"/>
              <a:t>26.10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B40769-BA91-45F4-A1BD-C6101B4EABE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06238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8CDC2-EA54-4E6F-9B40-A3A519426447}" type="datetimeFigureOut">
              <a:rPr lang="de-DE" smtClean="0"/>
              <a:t>26.10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B40769-BA91-45F4-A1BD-C6101B4EABE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206968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8CDC2-EA54-4E6F-9B40-A3A519426447}" type="datetimeFigureOut">
              <a:rPr lang="de-DE" smtClean="0"/>
              <a:t>26.10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B40769-BA91-45F4-A1BD-C6101B4EABE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976477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8CDC2-EA54-4E6F-9B40-A3A519426447}" type="datetimeFigureOut">
              <a:rPr lang="de-DE" smtClean="0"/>
              <a:t>26.10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B40769-BA91-45F4-A1BD-C6101B4EABE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725742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8CDC2-EA54-4E6F-9B40-A3A519426447}" type="datetimeFigureOut">
              <a:rPr lang="de-DE" smtClean="0"/>
              <a:t>26.10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B40769-BA91-45F4-A1BD-C6101B4EABE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763889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8CDC2-EA54-4E6F-9B40-A3A519426447}" type="datetimeFigureOut">
              <a:rPr lang="de-DE" smtClean="0"/>
              <a:t>26.10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B40769-BA91-45F4-A1BD-C6101B4EABE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881582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F8CDC2-EA54-4E6F-9B40-A3A519426447}" type="datetimeFigureOut">
              <a:rPr lang="de-DE" smtClean="0"/>
              <a:t>26.10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B40769-BA91-45F4-A1BD-C6101B4EABE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2930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m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41036597"/>
              </p:ext>
            </p:extLst>
          </p:nvPr>
        </p:nvGraphicFramePr>
        <p:xfrm>
          <a:off x="665651" y="732942"/>
          <a:ext cx="4560474" cy="23764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Diagramm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96035439"/>
              </p:ext>
            </p:extLst>
          </p:nvPr>
        </p:nvGraphicFramePr>
        <p:xfrm>
          <a:off x="631176" y="3075440"/>
          <a:ext cx="4569438" cy="22819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extfeld 1"/>
          <p:cNvSpPr txBox="1"/>
          <p:nvPr/>
        </p:nvSpPr>
        <p:spPr>
          <a:xfrm>
            <a:off x="6217310" y="734259"/>
            <a:ext cx="541610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S2 Fig. Ion </a:t>
            </a:r>
            <a:r>
              <a:rPr lang="de-DE" sz="1200" b="1" dirty="0" err="1" smtClean="0"/>
              <a:t>suppression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for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aniline</a:t>
            </a:r>
            <a:r>
              <a:rPr lang="de-DE" sz="1200" b="1" dirty="0" smtClean="0"/>
              <a:t>, </a:t>
            </a:r>
            <a:r>
              <a:rPr lang="de-DE" sz="1200" b="1" dirty="0" smtClean="0"/>
              <a:t>4-aminopyridine </a:t>
            </a:r>
            <a:r>
              <a:rPr lang="de-DE" sz="1200" b="1" dirty="0" err="1" smtClean="0"/>
              <a:t>and</a:t>
            </a:r>
            <a:r>
              <a:rPr lang="de-DE" sz="1200" b="1" dirty="0" smtClean="0"/>
              <a:t> 4-aminobenzontrile</a:t>
            </a:r>
          </a:p>
          <a:p>
            <a:endParaRPr lang="de-DE" sz="1200" i="1" dirty="0" smtClean="0"/>
          </a:p>
          <a:p>
            <a:r>
              <a:rPr lang="de-DE" sz="1200" i="1" dirty="0" err="1" smtClean="0"/>
              <a:t>Left</a:t>
            </a:r>
            <a:r>
              <a:rPr lang="de-DE" sz="1200" i="1" dirty="0" smtClean="0"/>
              <a:t>: </a:t>
            </a:r>
            <a:r>
              <a:rPr lang="en-US" sz="1200" dirty="0" smtClean="0"/>
              <a:t>ESI-MS </a:t>
            </a:r>
            <a:r>
              <a:rPr lang="en-US" sz="1200" dirty="0"/>
              <a:t>response </a:t>
            </a:r>
            <a:r>
              <a:rPr lang="en-US" sz="1200" dirty="0" smtClean="0"/>
              <a:t>in </a:t>
            </a:r>
            <a:r>
              <a:rPr lang="en-US" sz="1200" dirty="0"/>
              <a:t>presence of </a:t>
            </a:r>
            <a:r>
              <a:rPr lang="en-US" sz="1200" dirty="0" smtClean="0"/>
              <a:t>1 </a:t>
            </a:r>
            <a:r>
              <a:rPr lang="en-US" sz="1200" dirty="0" err="1" smtClean="0"/>
              <a:t>mM</a:t>
            </a:r>
            <a:r>
              <a:rPr lang="en-US" sz="1200" dirty="0" smtClean="0"/>
              <a:t> different</a:t>
            </a:r>
            <a:r>
              <a:rPr lang="en-US" sz="1200" dirty="0"/>
              <a:t>, pH-modifying electrolytes. Analyses carried out a) </a:t>
            </a:r>
            <a:r>
              <a:rPr lang="en-US" sz="1200" dirty="0" smtClean="0"/>
              <a:t>by </a:t>
            </a:r>
            <a:r>
              <a:rPr lang="en-US" sz="1200" dirty="0"/>
              <a:t>sample flow injection in 50% ACN on the Esquire 3000+ </a:t>
            </a:r>
            <a:r>
              <a:rPr lang="en-US" sz="1200" dirty="0" smtClean="0"/>
              <a:t>or b) </a:t>
            </a:r>
            <a:r>
              <a:rPr lang="en-US" sz="1200" dirty="0"/>
              <a:t>by sample flow injection in 80% ACN on the Esquire 3000+ </a:t>
            </a:r>
            <a:endParaRPr lang="de-DE" sz="1200" dirty="0" smtClean="0"/>
          </a:p>
          <a:p>
            <a:endParaRPr lang="de-DE" sz="1200" dirty="0"/>
          </a:p>
          <a:p>
            <a:r>
              <a:rPr lang="de-DE" sz="1200" i="1" dirty="0" err="1" smtClean="0"/>
              <a:t>Bottom</a:t>
            </a:r>
            <a:r>
              <a:rPr lang="de-DE" sz="1200" i="1" dirty="0" smtClean="0"/>
              <a:t>: </a:t>
            </a:r>
            <a:r>
              <a:rPr lang="de-DE" sz="1200" dirty="0" err="1" smtClean="0"/>
              <a:t>mass</a:t>
            </a:r>
            <a:r>
              <a:rPr lang="de-DE" sz="1200" dirty="0" smtClean="0"/>
              <a:t> </a:t>
            </a:r>
            <a:r>
              <a:rPr lang="de-DE" sz="1200" dirty="0" err="1" smtClean="0"/>
              <a:t>spectrum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the</a:t>
            </a:r>
            <a:r>
              <a:rPr lang="de-DE" sz="1200" dirty="0" smtClean="0"/>
              <a:t> </a:t>
            </a:r>
            <a:r>
              <a:rPr lang="de-DE" sz="1200" dirty="0" err="1" smtClean="0"/>
              <a:t>sodium</a:t>
            </a:r>
            <a:r>
              <a:rPr lang="de-DE" sz="1200" dirty="0" smtClean="0"/>
              <a:t> </a:t>
            </a:r>
            <a:r>
              <a:rPr lang="de-DE" sz="1200" dirty="0" err="1" smtClean="0"/>
              <a:t>adduct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4-aminobenzonitrile in 1 </a:t>
            </a:r>
            <a:r>
              <a:rPr lang="de-DE" sz="1200" dirty="0" err="1" smtClean="0"/>
              <a:t>mM</a:t>
            </a:r>
            <a:r>
              <a:rPr lang="de-DE" sz="1200" dirty="0" smtClean="0"/>
              <a:t> NaCl on </a:t>
            </a:r>
            <a:r>
              <a:rPr lang="de-DE" sz="1200" dirty="0" err="1" smtClean="0"/>
              <a:t>the</a:t>
            </a:r>
            <a:r>
              <a:rPr lang="de-DE" sz="1200" dirty="0" smtClean="0"/>
              <a:t> Esquire 3000+</a:t>
            </a:r>
            <a:endParaRPr lang="de-DE" sz="1200" dirty="0"/>
          </a:p>
        </p:txBody>
      </p:sp>
      <p:grpSp>
        <p:nvGrpSpPr>
          <p:cNvPr id="385" name="Gruppieren 384"/>
          <p:cNvGrpSpPr/>
          <p:nvPr/>
        </p:nvGrpSpPr>
        <p:grpSpPr>
          <a:xfrm>
            <a:off x="6217310" y="2552219"/>
            <a:ext cx="5451913" cy="2794558"/>
            <a:chOff x="6498389" y="3330753"/>
            <a:chExt cx="5451913" cy="2794558"/>
          </a:xfrm>
        </p:grpSpPr>
        <p:grpSp>
          <p:nvGrpSpPr>
            <p:cNvPr id="382" name="Gruppieren 381"/>
            <p:cNvGrpSpPr/>
            <p:nvPr/>
          </p:nvGrpSpPr>
          <p:grpSpPr>
            <a:xfrm>
              <a:off x="6498389" y="3330753"/>
              <a:ext cx="5451913" cy="2794558"/>
              <a:chOff x="6497871" y="3330753"/>
              <a:chExt cx="4230684" cy="2794558"/>
            </a:xfrm>
          </p:grpSpPr>
          <p:sp>
            <p:nvSpPr>
              <p:cNvPr id="10" name="Freeform 206"/>
              <p:cNvSpPr>
                <a:spLocks/>
              </p:cNvSpPr>
              <p:nvPr/>
            </p:nvSpPr>
            <p:spPr bwMode="auto">
              <a:xfrm>
                <a:off x="9785419" y="5652699"/>
                <a:ext cx="12454" cy="24250"/>
              </a:xfrm>
              <a:custGeom>
                <a:avLst/>
                <a:gdLst>
                  <a:gd name="T0" fmla="*/ 0 w 8"/>
                  <a:gd name="T1" fmla="*/ 20 h 20"/>
                  <a:gd name="T2" fmla="*/ 4 w 8"/>
                  <a:gd name="T3" fmla="*/ 20 h 20"/>
                  <a:gd name="T4" fmla="*/ 4 w 8"/>
                  <a:gd name="T5" fmla="*/ 0 h 20"/>
                  <a:gd name="T6" fmla="*/ 8 w 8"/>
                  <a:gd name="T7" fmla="*/ 12 h 20"/>
                  <a:gd name="T8" fmla="*/ 8 w 8"/>
                  <a:gd name="T9" fmla="*/ 20 h 20"/>
                  <a:gd name="T10" fmla="*/ 8 w 8"/>
                  <a:gd name="T11" fmla="*/ 12 h 20"/>
                  <a:gd name="T12" fmla="*/ 8 w 8"/>
                  <a:gd name="T13" fmla="*/ 20 h 20"/>
                  <a:gd name="T14" fmla="*/ 8 w 8"/>
                  <a:gd name="T15" fmla="*/ 20 h 20"/>
                  <a:gd name="T16" fmla="*/ 0 w 8"/>
                  <a:gd name="T17" fmla="*/ 20 h 20"/>
                  <a:gd name="T18" fmla="*/ 0 w 8"/>
                  <a:gd name="T19" fmla="*/ 20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8" h="20">
                    <a:moveTo>
                      <a:pt x="0" y="20"/>
                    </a:moveTo>
                    <a:lnTo>
                      <a:pt x="4" y="20"/>
                    </a:lnTo>
                    <a:lnTo>
                      <a:pt x="4" y="0"/>
                    </a:lnTo>
                    <a:lnTo>
                      <a:pt x="8" y="12"/>
                    </a:lnTo>
                    <a:lnTo>
                      <a:pt x="8" y="20"/>
                    </a:lnTo>
                    <a:lnTo>
                      <a:pt x="8" y="12"/>
                    </a:lnTo>
                    <a:lnTo>
                      <a:pt x="8" y="20"/>
                    </a:lnTo>
                    <a:lnTo>
                      <a:pt x="8" y="20"/>
                    </a:lnTo>
                    <a:lnTo>
                      <a:pt x="0" y="20"/>
                    </a:lnTo>
                    <a:lnTo>
                      <a:pt x="0" y="20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1" name="Freeform 207"/>
              <p:cNvSpPr>
                <a:spLocks/>
              </p:cNvSpPr>
              <p:nvPr/>
            </p:nvSpPr>
            <p:spPr bwMode="auto">
              <a:xfrm>
                <a:off x="9785419" y="5676949"/>
                <a:ext cx="12454" cy="0"/>
              </a:xfrm>
              <a:custGeom>
                <a:avLst/>
                <a:gdLst>
                  <a:gd name="T0" fmla="*/ 8 w 8"/>
                  <a:gd name="T1" fmla="*/ 8 w 8"/>
                  <a:gd name="T2" fmla="*/ 0 w 8"/>
                  <a:gd name="T3" fmla="*/ 0 w 8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8">
                    <a:moveTo>
                      <a:pt x="8" y="0"/>
                    </a:moveTo>
                    <a:lnTo>
                      <a:pt x="8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2" name="Freeform 208"/>
              <p:cNvSpPr>
                <a:spLocks/>
              </p:cNvSpPr>
              <p:nvPr/>
            </p:nvSpPr>
            <p:spPr bwMode="auto">
              <a:xfrm>
                <a:off x="9804099" y="5676949"/>
                <a:ext cx="12454" cy="0"/>
              </a:xfrm>
              <a:custGeom>
                <a:avLst/>
                <a:gdLst>
                  <a:gd name="T0" fmla="*/ 8 w 8"/>
                  <a:gd name="T1" fmla="*/ 8 w 8"/>
                  <a:gd name="T2" fmla="*/ 0 w 8"/>
                  <a:gd name="T3" fmla="*/ 0 w 8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8">
                    <a:moveTo>
                      <a:pt x="8" y="0"/>
                    </a:moveTo>
                    <a:lnTo>
                      <a:pt x="8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3" name="Freeform 209"/>
              <p:cNvSpPr>
                <a:spLocks/>
              </p:cNvSpPr>
              <p:nvPr/>
            </p:nvSpPr>
            <p:spPr bwMode="auto">
              <a:xfrm>
                <a:off x="9822780" y="5657549"/>
                <a:ext cx="14010" cy="19400"/>
              </a:xfrm>
              <a:custGeom>
                <a:avLst/>
                <a:gdLst>
                  <a:gd name="T0" fmla="*/ 0 w 9"/>
                  <a:gd name="T1" fmla="*/ 16 h 16"/>
                  <a:gd name="T2" fmla="*/ 5 w 9"/>
                  <a:gd name="T3" fmla="*/ 12 h 16"/>
                  <a:gd name="T4" fmla="*/ 5 w 9"/>
                  <a:gd name="T5" fmla="*/ 0 h 16"/>
                  <a:gd name="T6" fmla="*/ 9 w 9"/>
                  <a:gd name="T7" fmla="*/ 0 h 16"/>
                  <a:gd name="T8" fmla="*/ 9 w 9"/>
                  <a:gd name="T9" fmla="*/ 16 h 16"/>
                  <a:gd name="T10" fmla="*/ 9 w 9"/>
                  <a:gd name="T11" fmla="*/ 0 h 16"/>
                  <a:gd name="T12" fmla="*/ 9 w 9"/>
                  <a:gd name="T13" fmla="*/ 16 h 16"/>
                  <a:gd name="T14" fmla="*/ 9 w 9"/>
                  <a:gd name="T15" fmla="*/ 16 h 16"/>
                  <a:gd name="T16" fmla="*/ 0 w 9"/>
                  <a:gd name="T17" fmla="*/ 16 h 16"/>
                  <a:gd name="T18" fmla="*/ 0 w 9"/>
                  <a:gd name="T19" fmla="*/ 16 h 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9" h="16">
                    <a:moveTo>
                      <a:pt x="0" y="16"/>
                    </a:moveTo>
                    <a:lnTo>
                      <a:pt x="5" y="12"/>
                    </a:lnTo>
                    <a:lnTo>
                      <a:pt x="5" y="0"/>
                    </a:lnTo>
                    <a:lnTo>
                      <a:pt x="9" y="0"/>
                    </a:lnTo>
                    <a:lnTo>
                      <a:pt x="9" y="16"/>
                    </a:lnTo>
                    <a:lnTo>
                      <a:pt x="9" y="0"/>
                    </a:lnTo>
                    <a:lnTo>
                      <a:pt x="9" y="16"/>
                    </a:lnTo>
                    <a:lnTo>
                      <a:pt x="9" y="16"/>
                    </a:lnTo>
                    <a:lnTo>
                      <a:pt x="0" y="16"/>
                    </a:lnTo>
                    <a:lnTo>
                      <a:pt x="0" y="16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4" name="Freeform 210"/>
              <p:cNvSpPr>
                <a:spLocks/>
              </p:cNvSpPr>
              <p:nvPr/>
            </p:nvSpPr>
            <p:spPr bwMode="auto">
              <a:xfrm>
                <a:off x="9822780" y="5676949"/>
                <a:ext cx="14010" cy="0"/>
              </a:xfrm>
              <a:custGeom>
                <a:avLst/>
                <a:gdLst>
                  <a:gd name="T0" fmla="*/ 9 w 9"/>
                  <a:gd name="T1" fmla="*/ 9 w 9"/>
                  <a:gd name="T2" fmla="*/ 0 w 9"/>
                  <a:gd name="T3" fmla="*/ 0 w 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9">
                    <a:moveTo>
                      <a:pt x="9" y="0"/>
                    </a:moveTo>
                    <a:lnTo>
                      <a:pt x="9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5" name="Freeform 211"/>
              <p:cNvSpPr>
                <a:spLocks/>
              </p:cNvSpPr>
              <p:nvPr/>
            </p:nvSpPr>
            <p:spPr bwMode="auto">
              <a:xfrm>
                <a:off x="9843017" y="5662399"/>
                <a:ext cx="18681" cy="14550"/>
              </a:xfrm>
              <a:custGeom>
                <a:avLst/>
                <a:gdLst>
                  <a:gd name="T0" fmla="*/ 0 w 12"/>
                  <a:gd name="T1" fmla="*/ 12 h 12"/>
                  <a:gd name="T2" fmla="*/ 4 w 12"/>
                  <a:gd name="T3" fmla="*/ 12 h 12"/>
                  <a:gd name="T4" fmla="*/ 4 w 12"/>
                  <a:gd name="T5" fmla="*/ 4 h 12"/>
                  <a:gd name="T6" fmla="*/ 8 w 12"/>
                  <a:gd name="T7" fmla="*/ 0 h 12"/>
                  <a:gd name="T8" fmla="*/ 8 w 12"/>
                  <a:gd name="T9" fmla="*/ 12 h 12"/>
                  <a:gd name="T10" fmla="*/ 8 w 12"/>
                  <a:gd name="T11" fmla="*/ 0 h 12"/>
                  <a:gd name="T12" fmla="*/ 12 w 12"/>
                  <a:gd name="T13" fmla="*/ 12 h 12"/>
                  <a:gd name="T14" fmla="*/ 12 w 12"/>
                  <a:gd name="T15" fmla="*/ 12 h 12"/>
                  <a:gd name="T16" fmla="*/ 0 w 12"/>
                  <a:gd name="T17" fmla="*/ 12 h 12"/>
                  <a:gd name="T18" fmla="*/ 0 w 12"/>
                  <a:gd name="T19" fmla="*/ 12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12" h="12">
                    <a:moveTo>
                      <a:pt x="0" y="12"/>
                    </a:moveTo>
                    <a:lnTo>
                      <a:pt x="4" y="12"/>
                    </a:lnTo>
                    <a:lnTo>
                      <a:pt x="4" y="4"/>
                    </a:lnTo>
                    <a:lnTo>
                      <a:pt x="8" y="0"/>
                    </a:lnTo>
                    <a:lnTo>
                      <a:pt x="8" y="12"/>
                    </a:lnTo>
                    <a:lnTo>
                      <a:pt x="8" y="0"/>
                    </a:lnTo>
                    <a:lnTo>
                      <a:pt x="12" y="12"/>
                    </a:lnTo>
                    <a:lnTo>
                      <a:pt x="12" y="12"/>
                    </a:lnTo>
                    <a:lnTo>
                      <a:pt x="0" y="12"/>
                    </a:lnTo>
                    <a:lnTo>
                      <a:pt x="0" y="12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6" name="Freeform 212"/>
              <p:cNvSpPr>
                <a:spLocks/>
              </p:cNvSpPr>
              <p:nvPr/>
            </p:nvSpPr>
            <p:spPr bwMode="auto">
              <a:xfrm>
                <a:off x="9843017" y="5676949"/>
                <a:ext cx="18681" cy="0"/>
              </a:xfrm>
              <a:custGeom>
                <a:avLst/>
                <a:gdLst>
                  <a:gd name="T0" fmla="*/ 12 w 12"/>
                  <a:gd name="T1" fmla="*/ 12 w 12"/>
                  <a:gd name="T2" fmla="*/ 0 w 12"/>
                  <a:gd name="T3" fmla="*/ 0 w 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12">
                    <a:moveTo>
                      <a:pt x="12" y="0"/>
                    </a:moveTo>
                    <a:lnTo>
                      <a:pt x="12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7" name="Freeform 213"/>
              <p:cNvSpPr>
                <a:spLocks/>
              </p:cNvSpPr>
              <p:nvPr/>
            </p:nvSpPr>
            <p:spPr bwMode="auto">
              <a:xfrm>
                <a:off x="9861698" y="5657549"/>
                <a:ext cx="18681" cy="19400"/>
              </a:xfrm>
              <a:custGeom>
                <a:avLst/>
                <a:gdLst>
                  <a:gd name="T0" fmla="*/ 0 w 12"/>
                  <a:gd name="T1" fmla="*/ 16 h 16"/>
                  <a:gd name="T2" fmla="*/ 4 w 12"/>
                  <a:gd name="T3" fmla="*/ 16 h 16"/>
                  <a:gd name="T4" fmla="*/ 4 w 12"/>
                  <a:gd name="T5" fmla="*/ 0 h 16"/>
                  <a:gd name="T6" fmla="*/ 8 w 12"/>
                  <a:gd name="T7" fmla="*/ 0 h 16"/>
                  <a:gd name="T8" fmla="*/ 8 w 12"/>
                  <a:gd name="T9" fmla="*/ 16 h 16"/>
                  <a:gd name="T10" fmla="*/ 8 w 12"/>
                  <a:gd name="T11" fmla="*/ 0 h 16"/>
                  <a:gd name="T12" fmla="*/ 12 w 12"/>
                  <a:gd name="T13" fmla="*/ 16 h 16"/>
                  <a:gd name="T14" fmla="*/ 12 w 12"/>
                  <a:gd name="T15" fmla="*/ 16 h 16"/>
                  <a:gd name="T16" fmla="*/ 0 w 12"/>
                  <a:gd name="T17" fmla="*/ 16 h 16"/>
                  <a:gd name="T18" fmla="*/ 0 w 12"/>
                  <a:gd name="T19" fmla="*/ 16 h 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12" h="16">
                    <a:moveTo>
                      <a:pt x="0" y="16"/>
                    </a:moveTo>
                    <a:lnTo>
                      <a:pt x="4" y="16"/>
                    </a:lnTo>
                    <a:lnTo>
                      <a:pt x="4" y="0"/>
                    </a:lnTo>
                    <a:lnTo>
                      <a:pt x="8" y="0"/>
                    </a:lnTo>
                    <a:lnTo>
                      <a:pt x="8" y="16"/>
                    </a:lnTo>
                    <a:lnTo>
                      <a:pt x="8" y="0"/>
                    </a:lnTo>
                    <a:lnTo>
                      <a:pt x="12" y="16"/>
                    </a:lnTo>
                    <a:lnTo>
                      <a:pt x="12" y="16"/>
                    </a:lnTo>
                    <a:lnTo>
                      <a:pt x="0" y="16"/>
                    </a:lnTo>
                    <a:lnTo>
                      <a:pt x="0" y="16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8" name="Freeform 214"/>
              <p:cNvSpPr>
                <a:spLocks/>
              </p:cNvSpPr>
              <p:nvPr/>
            </p:nvSpPr>
            <p:spPr bwMode="auto">
              <a:xfrm>
                <a:off x="9861698" y="5676949"/>
                <a:ext cx="18681" cy="0"/>
              </a:xfrm>
              <a:custGeom>
                <a:avLst/>
                <a:gdLst>
                  <a:gd name="T0" fmla="*/ 12 w 12"/>
                  <a:gd name="T1" fmla="*/ 12 w 12"/>
                  <a:gd name="T2" fmla="*/ 0 w 12"/>
                  <a:gd name="T3" fmla="*/ 0 w 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12">
                    <a:moveTo>
                      <a:pt x="12" y="0"/>
                    </a:moveTo>
                    <a:lnTo>
                      <a:pt x="12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9" name="Freeform 215"/>
              <p:cNvSpPr>
                <a:spLocks/>
              </p:cNvSpPr>
              <p:nvPr/>
            </p:nvSpPr>
            <p:spPr bwMode="auto">
              <a:xfrm>
                <a:off x="9880379" y="5657549"/>
                <a:ext cx="18681" cy="19400"/>
              </a:xfrm>
              <a:custGeom>
                <a:avLst/>
                <a:gdLst>
                  <a:gd name="T0" fmla="*/ 0 w 12"/>
                  <a:gd name="T1" fmla="*/ 16 h 16"/>
                  <a:gd name="T2" fmla="*/ 4 w 12"/>
                  <a:gd name="T3" fmla="*/ 16 h 16"/>
                  <a:gd name="T4" fmla="*/ 4 w 12"/>
                  <a:gd name="T5" fmla="*/ 8 h 16"/>
                  <a:gd name="T6" fmla="*/ 8 w 12"/>
                  <a:gd name="T7" fmla="*/ 0 h 16"/>
                  <a:gd name="T8" fmla="*/ 8 w 12"/>
                  <a:gd name="T9" fmla="*/ 16 h 16"/>
                  <a:gd name="T10" fmla="*/ 8 w 12"/>
                  <a:gd name="T11" fmla="*/ 0 h 16"/>
                  <a:gd name="T12" fmla="*/ 12 w 12"/>
                  <a:gd name="T13" fmla="*/ 16 h 16"/>
                  <a:gd name="T14" fmla="*/ 12 w 12"/>
                  <a:gd name="T15" fmla="*/ 16 h 16"/>
                  <a:gd name="T16" fmla="*/ 0 w 12"/>
                  <a:gd name="T17" fmla="*/ 16 h 16"/>
                  <a:gd name="T18" fmla="*/ 0 w 12"/>
                  <a:gd name="T19" fmla="*/ 16 h 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12" h="16">
                    <a:moveTo>
                      <a:pt x="0" y="16"/>
                    </a:moveTo>
                    <a:lnTo>
                      <a:pt x="4" y="16"/>
                    </a:lnTo>
                    <a:lnTo>
                      <a:pt x="4" y="8"/>
                    </a:lnTo>
                    <a:lnTo>
                      <a:pt x="8" y="0"/>
                    </a:lnTo>
                    <a:lnTo>
                      <a:pt x="8" y="16"/>
                    </a:lnTo>
                    <a:lnTo>
                      <a:pt x="8" y="0"/>
                    </a:lnTo>
                    <a:lnTo>
                      <a:pt x="12" y="16"/>
                    </a:lnTo>
                    <a:lnTo>
                      <a:pt x="12" y="16"/>
                    </a:lnTo>
                    <a:lnTo>
                      <a:pt x="0" y="16"/>
                    </a:lnTo>
                    <a:lnTo>
                      <a:pt x="0" y="16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20" name="Freeform 216"/>
              <p:cNvSpPr>
                <a:spLocks/>
              </p:cNvSpPr>
              <p:nvPr/>
            </p:nvSpPr>
            <p:spPr bwMode="auto">
              <a:xfrm>
                <a:off x="9880379" y="5676949"/>
                <a:ext cx="18681" cy="0"/>
              </a:xfrm>
              <a:custGeom>
                <a:avLst/>
                <a:gdLst>
                  <a:gd name="T0" fmla="*/ 12 w 12"/>
                  <a:gd name="T1" fmla="*/ 12 w 12"/>
                  <a:gd name="T2" fmla="*/ 0 w 12"/>
                  <a:gd name="T3" fmla="*/ 0 w 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12">
                    <a:moveTo>
                      <a:pt x="12" y="0"/>
                    </a:moveTo>
                    <a:lnTo>
                      <a:pt x="12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21" name="Freeform 217"/>
              <p:cNvSpPr>
                <a:spLocks/>
              </p:cNvSpPr>
              <p:nvPr/>
            </p:nvSpPr>
            <p:spPr bwMode="auto">
              <a:xfrm>
                <a:off x="9899059" y="5657549"/>
                <a:ext cx="18681" cy="19400"/>
              </a:xfrm>
              <a:custGeom>
                <a:avLst/>
                <a:gdLst>
                  <a:gd name="T0" fmla="*/ 0 w 12"/>
                  <a:gd name="T1" fmla="*/ 16 h 16"/>
                  <a:gd name="T2" fmla="*/ 4 w 12"/>
                  <a:gd name="T3" fmla="*/ 16 h 16"/>
                  <a:gd name="T4" fmla="*/ 4 w 12"/>
                  <a:gd name="T5" fmla="*/ 8 h 16"/>
                  <a:gd name="T6" fmla="*/ 8 w 12"/>
                  <a:gd name="T7" fmla="*/ 0 h 16"/>
                  <a:gd name="T8" fmla="*/ 8 w 12"/>
                  <a:gd name="T9" fmla="*/ 16 h 16"/>
                  <a:gd name="T10" fmla="*/ 8 w 12"/>
                  <a:gd name="T11" fmla="*/ 0 h 16"/>
                  <a:gd name="T12" fmla="*/ 12 w 12"/>
                  <a:gd name="T13" fmla="*/ 16 h 16"/>
                  <a:gd name="T14" fmla="*/ 12 w 12"/>
                  <a:gd name="T15" fmla="*/ 16 h 16"/>
                  <a:gd name="T16" fmla="*/ 0 w 12"/>
                  <a:gd name="T17" fmla="*/ 16 h 16"/>
                  <a:gd name="T18" fmla="*/ 0 w 12"/>
                  <a:gd name="T19" fmla="*/ 16 h 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12" h="16">
                    <a:moveTo>
                      <a:pt x="0" y="16"/>
                    </a:moveTo>
                    <a:lnTo>
                      <a:pt x="4" y="16"/>
                    </a:lnTo>
                    <a:lnTo>
                      <a:pt x="4" y="8"/>
                    </a:lnTo>
                    <a:lnTo>
                      <a:pt x="8" y="0"/>
                    </a:lnTo>
                    <a:lnTo>
                      <a:pt x="8" y="16"/>
                    </a:lnTo>
                    <a:lnTo>
                      <a:pt x="8" y="0"/>
                    </a:lnTo>
                    <a:lnTo>
                      <a:pt x="12" y="16"/>
                    </a:lnTo>
                    <a:lnTo>
                      <a:pt x="12" y="16"/>
                    </a:lnTo>
                    <a:lnTo>
                      <a:pt x="0" y="16"/>
                    </a:lnTo>
                    <a:lnTo>
                      <a:pt x="0" y="16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22" name="Freeform 218"/>
              <p:cNvSpPr>
                <a:spLocks/>
              </p:cNvSpPr>
              <p:nvPr/>
            </p:nvSpPr>
            <p:spPr bwMode="auto">
              <a:xfrm>
                <a:off x="9899059" y="5676949"/>
                <a:ext cx="18681" cy="0"/>
              </a:xfrm>
              <a:custGeom>
                <a:avLst/>
                <a:gdLst>
                  <a:gd name="T0" fmla="*/ 12 w 12"/>
                  <a:gd name="T1" fmla="*/ 12 w 12"/>
                  <a:gd name="T2" fmla="*/ 0 w 12"/>
                  <a:gd name="T3" fmla="*/ 0 w 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12">
                    <a:moveTo>
                      <a:pt x="12" y="0"/>
                    </a:moveTo>
                    <a:lnTo>
                      <a:pt x="12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23" name="Freeform 219"/>
              <p:cNvSpPr>
                <a:spLocks/>
              </p:cNvSpPr>
              <p:nvPr/>
            </p:nvSpPr>
            <p:spPr bwMode="auto">
              <a:xfrm>
                <a:off x="9917740" y="5672099"/>
                <a:ext cx="20237" cy="4850"/>
              </a:xfrm>
              <a:custGeom>
                <a:avLst/>
                <a:gdLst>
                  <a:gd name="T0" fmla="*/ 0 w 13"/>
                  <a:gd name="T1" fmla="*/ 4 h 4"/>
                  <a:gd name="T2" fmla="*/ 5 w 13"/>
                  <a:gd name="T3" fmla="*/ 4 h 4"/>
                  <a:gd name="T4" fmla="*/ 9 w 13"/>
                  <a:gd name="T5" fmla="*/ 0 h 4"/>
                  <a:gd name="T6" fmla="*/ 9 w 13"/>
                  <a:gd name="T7" fmla="*/ 4 h 4"/>
                  <a:gd name="T8" fmla="*/ 9 w 13"/>
                  <a:gd name="T9" fmla="*/ 0 h 4"/>
                  <a:gd name="T10" fmla="*/ 9 w 13"/>
                  <a:gd name="T11" fmla="*/ 4 h 4"/>
                  <a:gd name="T12" fmla="*/ 13 w 13"/>
                  <a:gd name="T13" fmla="*/ 4 h 4"/>
                  <a:gd name="T14" fmla="*/ 13 w 13"/>
                  <a:gd name="T15" fmla="*/ 4 h 4"/>
                  <a:gd name="T16" fmla="*/ 0 w 13"/>
                  <a:gd name="T17" fmla="*/ 4 h 4"/>
                  <a:gd name="T18" fmla="*/ 0 w 13"/>
                  <a:gd name="T19" fmla="*/ 4 h 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13" h="4">
                    <a:moveTo>
                      <a:pt x="0" y="4"/>
                    </a:moveTo>
                    <a:lnTo>
                      <a:pt x="5" y="4"/>
                    </a:lnTo>
                    <a:lnTo>
                      <a:pt x="9" y="0"/>
                    </a:lnTo>
                    <a:lnTo>
                      <a:pt x="9" y="4"/>
                    </a:lnTo>
                    <a:lnTo>
                      <a:pt x="9" y="0"/>
                    </a:lnTo>
                    <a:lnTo>
                      <a:pt x="9" y="4"/>
                    </a:lnTo>
                    <a:lnTo>
                      <a:pt x="13" y="4"/>
                    </a:lnTo>
                    <a:lnTo>
                      <a:pt x="13" y="4"/>
                    </a:lnTo>
                    <a:lnTo>
                      <a:pt x="0" y="4"/>
                    </a:lnTo>
                    <a:lnTo>
                      <a:pt x="0" y="4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24" name="Freeform 220"/>
              <p:cNvSpPr>
                <a:spLocks/>
              </p:cNvSpPr>
              <p:nvPr/>
            </p:nvSpPr>
            <p:spPr bwMode="auto">
              <a:xfrm>
                <a:off x="9917740" y="5676949"/>
                <a:ext cx="20237" cy="0"/>
              </a:xfrm>
              <a:custGeom>
                <a:avLst/>
                <a:gdLst>
                  <a:gd name="T0" fmla="*/ 13 w 13"/>
                  <a:gd name="T1" fmla="*/ 13 w 13"/>
                  <a:gd name="T2" fmla="*/ 0 w 13"/>
                  <a:gd name="T3" fmla="*/ 0 w 13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13">
                    <a:moveTo>
                      <a:pt x="13" y="0"/>
                    </a:moveTo>
                    <a:lnTo>
                      <a:pt x="13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25" name="Freeform 221"/>
              <p:cNvSpPr>
                <a:spLocks/>
              </p:cNvSpPr>
              <p:nvPr/>
            </p:nvSpPr>
            <p:spPr bwMode="auto">
              <a:xfrm>
                <a:off x="9944204" y="5643000"/>
                <a:ext cx="12454" cy="33950"/>
              </a:xfrm>
              <a:custGeom>
                <a:avLst/>
                <a:gdLst>
                  <a:gd name="T0" fmla="*/ 0 w 8"/>
                  <a:gd name="T1" fmla="*/ 28 h 28"/>
                  <a:gd name="T2" fmla="*/ 0 w 8"/>
                  <a:gd name="T3" fmla="*/ 24 h 28"/>
                  <a:gd name="T4" fmla="*/ 4 w 8"/>
                  <a:gd name="T5" fmla="*/ 16 h 28"/>
                  <a:gd name="T6" fmla="*/ 4 w 8"/>
                  <a:gd name="T7" fmla="*/ 28 h 28"/>
                  <a:gd name="T8" fmla="*/ 4 w 8"/>
                  <a:gd name="T9" fmla="*/ 0 h 28"/>
                  <a:gd name="T10" fmla="*/ 8 w 8"/>
                  <a:gd name="T11" fmla="*/ 28 h 28"/>
                  <a:gd name="T12" fmla="*/ 8 w 8"/>
                  <a:gd name="T13" fmla="*/ 28 h 28"/>
                  <a:gd name="T14" fmla="*/ 0 w 8"/>
                  <a:gd name="T15" fmla="*/ 28 h 28"/>
                  <a:gd name="T16" fmla="*/ 0 w 8"/>
                  <a:gd name="T17" fmla="*/ 28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8" h="28">
                    <a:moveTo>
                      <a:pt x="0" y="28"/>
                    </a:moveTo>
                    <a:lnTo>
                      <a:pt x="0" y="24"/>
                    </a:lnTo>
                    <a:lnTo>
                      <a:pt x="4" y="16"/>
                    </a:lnTo>
                    <a:lnTo>
                      <a:pt x="4" y="28"/>
                    </a:lnTo>
                    <a:lnTo>
                      <a:pt x="4" y="0"/>
                    </a:lnTo>
                    <a:lnTo>
                      <a:pt x="8" y="28"/>
                    </a:lnTo>
                    <a:lnTo>
                      <a:pt x="8" y="28"/>
                    </a:lnTo>
                    <a:lnTo>
                      <a:pt x="0" y="28"/>
                    </a:lnTo>
                    <a:lnTo>
                      <a:pt x="0" y="28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26" name="Freeform 222"/>
              <p:cNvSpPr>
                <a:spLocks/>
              </p:cNvSpPr>
              <p:nvPr/>
            </p:nvSpPr>
            <p:spPr bwMode="auto">
              <a:xfrm>
                <a:off x="9944204" y="5676949"/>
                <a:ext cx="12454" cy="0"/>
              </a:xfrm>
              <a:custGeom>
                <a:avLst/>
                <a:gdLst>
                  <a:gd name="T0" fmla="*/ 8 w 8"/>
                  <a:gd name="T1" fmla="*/ 8 w 8"/>
                  <a:gd name="T2" fmla="*/ 0 w 8"/>
                  <a:gd name="T3" fmla="*/ 0 w 8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8">
                    <a:moveTo>
                      <a:pt x="8" y="0"/>
                    </a:moveTo>
                    <a:lnTo>
                      <a:pt x="8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27" name="Freeform 223"/>
              <p:cNvSpPr>
                <a:spLocks/>
              </p:cNvSpPr>
              <p:nvPr/>
            </p:nvSpPr>
            <p:spPr bwMode="auto">
              <a:xfrm>
                <a:off x="9956658" y="5676949"/>
                <a:ext cx="18681" cy="0"/>
              </a:xfrm>
              <a:custGeom>
                <a:avLst/>
                <a:gdLst>
                  <a:gd name="T0" fmla="*/ 12 w 12"/>
                  <a:gd name="T1" fmla="*/ 12 w 12"/>
                  <a:gd name="T2" fmla="*/ 0 w 12"/>
                  <a:gd name="T3" fmla="*/ 0 w 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12">
                    <a:moveTo>
                      <a:pt x="12" y="0"/>
                    </a:moveTo>
                    <a:lnTo>
                      <a:pt x="12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28" name="Freeform 224"/>
              <p:cNvSpPr>
                <a:spLocks/>
              </p:cNvSpPr>
              <p:nvPr/>
            </p:nvSpPr>
            <p:spPr bwMode="auto">
              <a:xfrm>
                <a:off x="9975338" y="5643000"/>
                <a:ext cx="18681" cy="33950"/>
              </a:xfrm>
              <a:custGeom>
                <a:avLst/>
                <a:gdLst>
                  <a:gd name="T0" fmla="*/ 0 w 12"/>
                  <a:gd name="T1" fmla="*/ 28 h 28"/>
                  <a:gd name="T2" fmla="*/ 4 w 12"/>
                  <a:gd name="T3" fmla="*/ 28 h 28"/>
                  <a:gd name="T4" fmla="*/ 4 w 12"/>
                  <a:gd name="T5" fmla="*/ 24 h 28"/>
                  <a:gd name="T6" fmla="*/ 8 w 12"/>
                  <a:gd name="T7" fmla="*/ 16 h 28"/>
                  <a:gd name="T8" fmla="*/ 8 w 12"/>
                  <a:gd name="T9" fmla="*/ 0 h 28"/>
                  <a:gd name="T10" fmla="*/ 8 w 12"/>
                  <a:gd name="T11" fmla="*/ 16 h 28"/>
                  <a:gd name="T12" fmla="*/ 12 w 12"/>
                  <a:gd name="T13" fmla="*/ 24 h 28"/>
                  <a:gd name="T14" fmla="*/ 12 w 12"/>
                  <a:gd name="T15" fmla="*/ 28 h 28"/>
                  <a:gd name="T16" fmla="*/ 12 w 12"/>
                  <a:gd name="T17" fmla="*/ 28 h 28"/>
                  <a:gd name="T18" fmla="*/ 0 w 12"/>
                  <a:gd name="T19" fmla="*/ 28 h 28"/>
                  <a:gd name="T20" fmla="*/ 0 w 12"/>
                  <a:gd name="T21" fmla="*/ 28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12" h="28">
                    <a:moveTo>
                      <a:pt x="0" y="28"/>
                    </a:moveTo>
                    <a:lnTo>
                      <a:pt x="4" y="28"/>
                    </a:lnTo>
                    <a:lnTo>
                      <a:pt x="4" y="24"/>
                    </a:lnTo>
                    <a:lnTo>
                      <a:pt x="8" y="16"/>
                    </a:lnTo>
                    <a:lnTo>
                      <a:pt x="8" y="0"/>
                    </a:lnTo>
                    <a:lnTo>
                      <a:pt x="8" y="16"/>
                    </a:lnTo>
                    <a:lnTo>
                      <a:pt x="12" y="24"/>
                    </a:lnTo>
                    <a:lnTo>
                      <a:pt x="12" y="28"/>
                    </a:lnTo>
                    <a:lnTo>
                      <a:pt x="12" y="28"/>
                    </a:lnTo>
                    <a:lnTo>
                      <a:pt x="0" y="28"/>
                    </a:lnTo>
                    <a:lnTo>
                      <a:pt x="0" y="28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29" name="Freeform 225"/>
              <p:cNvSpPr>
                <a:spLocks/>
              </p:cNvSpPr>
              <p:nvPr/>
            </p:nvSpPr>
            <p:spPr bwMode="auto">
              <a:xfrm>
                <a:off x="9975338" y="5676949"/>
                <a:ext cx="18681" cy="0"/>
              </a:xfrm>
              <a:custGeom>
                <a:avLst/>
                <a:gdLst>
                  <a:gd name="T0" fmla="*/ 12 w 12"/>
                  <a:gd name="T1" fmla="*/ 12 w 12"/>
                  <a:gd name="T2" fmla="*/ 0 w 12"/>
                  <a:gd name="T3" fmla="*/ 0 w 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12">
                    <a:moveTo>
                      <a:pt x="12" y="0"/>
                    </a:moveTo>
                    <a:lnTo>
                      <a:pt x="12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30" name="Freeform 226"/>
              <p:cNvSpPr>
                <a:spLocks/>
              </p:cNvSpPr>
              <p:nvPr/>
            </p:nvSpPr>
            <p:spPr bwMode="auto">
              <a:xfrm>
                <a:off x="10000246" y="5672099"/>
                <a:ext cx="12454" cy="4850"/>
              </a:xfrm>
              <a:custGeom>
                <a:avLst/>
                <a:gdLst>
                  <a:gd name="T0" fmla="*/ 0 w 8"/>
                  <a:gd name="T1" fmla="*/ 4 h 4"/>
                  <a:gd name="T2" fmla="*/ 4 w 8"/>
                  <a:gd name="T3" fmla="*/ 4 h 4"/>
                  <a:gd name="T4" fmla="*/ 4 w 8"/>
                  <a:gd name="T5" fmla="*/ 0 h 4"/>
                  <a:gd name="T6" fmla="*/ 8 w 8"/>
                  <a:gd name="T7" fmla="*/ 4 h 4"/>
                  <a:gd name="T8" fmla="*/ 8 w 8"/>
                  <a:gd name="T9" fmla="*/ 4 h 4"/>
                  <a:gd name="T10" fmla="*/ 0 w 8"/>
                  <a:gd name="T11" fmla="*/ 4 h 4"/>
                  <a:gd name="T12" fmla="*/ 0 w 8"/>
                  <a:gd name="T13" fmla="*/ 4 h 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8" h="4">
                    <a:moveTo>
                      <a:pt x="0" y="4"/>
                    </a:moveTo>
                    <a:lnTo>
                      <a:pt x="4" y="4"/>
                    </a:lnTo>
                    <a:lnTo>
                      <a:pt x="4" y="0"/>
                    </a:lnTo>
                    <a:lnTo>
                      <a:pt x="8" y="4"/>
                    </a:lnTo>
                    <a:lnTo>
                      <a:pt x="8" y="4"/>
                    </a:lnTo>
                    <a:lnTo>
                      <a:pt x="0" y="4"/>
                    </a:lnTo>
                    <a:lnTo>
                      <a:pt x="0" y="4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31" name="Freeform 227"/>
              <p:cNvSpPr>
                <a:spLocks/>
              </p:cNvSpPr>
              <p:nvPr/>
            </p:nvSpPr>
            <p:spPr bwMode="auto">
              <a:xfrm>
                <a:off x="10000246" y="5676949"/>
                <a:ext cx="12454" cy="0"/>
              </a:xfrm>
              <a:custGeom>
                <a:avLst/>
                <a:gdLst>
                  <a:gd name="T0" fmla="*/ 8 w 8"/>
                  <a:gd name="T1" fmla="*/ 8 w 8"/>
                  <a:gd name="T2" fmla="*/ 0 w 8"/>
                  <a:gd name="T3" fmla="*/ 0 w 8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8">
                    <a:moveTo>
                      <a:pt x="8" y="0"/>
                    </a:moveTo>
                    <a:lnTo>
                      <a:pt x="8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32" name="Freeform 228"/>
              <p:cNvSpPr>
                <a:spLocks/>
              </p:cNvSpPr>
              <p:nvPr/>
            </p:nvSpPr>
            <p:spPr bwMode="auto">
              <a:xfrm>
                <a:off x="10020483" y="5643000"/>
                <a:ext cx="18681" cy="33950"/>
              </a:xfrm>
              <a:custGeom>
                <a:avLst/>
                <a:gdLst>
                  <a:gd name="T0" fmla="*/ 0 w 12"/>
                  <a:gd name="T1" fmla="*/ 28 h 28"/>
                  <a:gd name="T2" fmla="*/ 4 w 12"/>
                  <a:gd name="T3" fmla="*/ 24 h 28"/>
                  <a:gd name="T4" fmla="*/ 4 w 12"/>
                  <a:gd name="T5" fmla="*/ 0 h 28"/>
                  <a:gd name="T6" fmla="*/ 8 w 12"/>
                  <a:gd name="T7" fmla="*/ 20 h 28"/>
                  <a:gd name="T8" fmla="*/ 8 w 12"/>
                  <a:gd name="T9" fmla="*/ 28 h 28"/>
                  <a:gd name="T10" fmla="*/ 8 w 12"/>
                  <a:gd name="T11" fmla="*/ 20 h 28"/>
                  <a:gd name="T12" fmla="*/ 12 w 12"/>
                  <a:gd name="T13" fmla="*/ 28 h 28"/>
                  <a:gd name="T14" fmla="*/ 12 w 12"/>
                  <a:gd name="T15" fmla="*/ 28 h 28"/>
                  <a:gd name="T16" fmla="*/ 0 w 12"/>
                  <a:gd name="T17" fmla="*/ 28 h 28"/>
                  <a:gd name="T18" fmla="*/ 0 w 12"/>
                  <a:gd name="T19" fmla="*/ 28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12" h="28">
                    <a:moveTo>
                      <a:pt x="0" y="28"/>
                    </a:moveTo>
                    <a:lnTo>
                      <a:pt x="4" y="24"/>
                    </a:lnTo>
                    <a:lnTo>
                      <a:pt x="4" y="0"/>
                    </a:lnTo>
                    <a:lnTo>
                      <a:pt x="8" y="20"/>
                    </a:lnTo>
                    <a:lnTo>
                      <a:pt x="8" y="28"/>
                    </a:lnTo>
                    <a:lnTo>
                      <a:pt x="8" y="20"/>
                    </a:lnTo>
                    <a:lnTo>
                      <a:pt x="12" y="28"/>
                    </a:lnTo>
                    <a:lnTo>
                      <a:pt x="12" y="28"/>
                    </a:lnTo>
                    <a:lnTo>
                      <a:pt x="0" y="28"/>
                    </a:lnTo>
                    <a:lnTo>
                      <a:pt x="0" y="28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33" name="Freeform 229"/>
              <p:cNvSpPr>
                <a:spLocks/>
              </p:cNvSpPr>
              <p:nvPr/>
            </p:nvSpPr>
            <p:spPr bwMode="auto">
              <a:xfrm>
                <a:off x="10020483" y="5676949"/>
                <a:ext cx="18681" cy="0"/>
              </a:xfrm>
              <a:custGeom>
                <a:avLst/>
                <a:gdLst>
                  <a:gd name="T0" fmla="*/ 12 w 12"/>
                  <a:gd name="T1" fmla="*/ 12 w 12"/>
                  <a:gd name="T2" fmla="*/ 0 w 12"/>
                  <a:gd name="T3" fmla="*/ 0 w 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12">
                    <a:moveTo>
                      <a:pt x="12" y="0"/>
                    </a:moveTo>
                    <a:lnTo>
                      <a:pt x="12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34" name="Freeform 230"/>
              <p:cNvSpPr>
                <a:spLocks/>
              </p:cNvSpPr>
              <p:nvPr/>
            </p:nvSpPr>
            <p:spPr bwMode="auto">
              <a:xfrm>
                <a:off x="10039164" y="5672099"/>
                <a:ext cx="12454" cy="4850"/>
              </a:xfrm>
              <a:custGeom>
                <a:avLst/>
                <a:gdLst>
                  <a:gd name="T0" fmla="*/ 0 w 8"/>
                  <a:gd name="T1" fmla="*/ 4 h 4"/>
                  <a:gd name="T2" fmla="*/ 4 w 8"/>
                  <a:gd name="T3" fmla="*/ 4 h 4"/>
                  <a:gd name="T4" fmla="*/ 4 w 8"/>
                  <a:gd name="T5" fmla="*/ 0 h 4"/>
                  <a:gd name="T6" fmla="*/ 8 w 8"/>
                  <a:gd name="T7" fmla="*/ 4 h 4"/>
                  <a:gd name="T8" fmla="*/ 8 w 8"/>
                  <a:gd name="T9" fmla="*/ 4 h 4"/>
                  <a:gd name="T10" fmla="*/ 0 w 8"/>
                  <a:gd name="T11" fmla="*/ 4 h 4"/>
                  <a:gd name="T12" fmla="*/ 0 w 8"/>
                  <a:gd name="T13" fmla="*/ 4 h 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8" h="4">
                    <a:moveTo>
                      <a:pt x="0" y="4"/>
                    </a:moveTo>
                    <a:lnTo>
                      <a:pt x="4" y="4"/>
                    </a:lnTo>
                    <a:lnTo>
                      <a:pt x="4" y="0"/>
                    </a:lnTo>
                    <a:lnTo>
                      <a:pt x="8" y="4"/>
                    </a:lnTo>
                    <a:lnTo>
                      <a:pt x="8" y="4"/>
                    </a:lnTo>
                    <a:lnTo>
                      <a:pt x="0" y="4"/>
                    </a:lnTo>
                    <a:lnTo>
                      <a:pt x="0" y="4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35" name="Freeform 231"/>
              <p:cNvSpPr>
                <a:spLocks/>
              </p:cNvSpPr>
              <p:nvPr/>
            </p:nvSpPr>
            <p:spPr bwMode="auto">
              <a:xfrm>
                <a:off x="10039164" y="5676949"/>
                <a:ext cx="12454" cy="0"/>
              </a:xfrm>
              <a:custGeom>
                <a:avLst/>
                <a:gdLst>
                  <a:gd name="T0" fmla="*/ 8 w 8"/>
                  <a:gd name="T1" fmla="*/ 8 w 8"/>
                  <a:gd name="T2" fmla="*/ 0 w 8"/>
                  <a:gd name="T3" fmla="*/ 0 w 8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8">
                    <a:moveTo>
                      <a:pt x="8" y="0"/>
                    </a:moveTo>
                    <a:lnTo>
                      <a:pt x="8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36" name="Freeform 232"/>
              <p:cNvSpPr>
                <a:spLocks/>
              </p:cNvSpPr>
              <p:nvPr/>
            </p:nvSpPr>
            <p:spPr bwMode="auto">
              <a:xfrm>
                <a:off x="10051618" y="5672099"/>
                <a:ext cx="18681" cy="4850"/>
              </a:xfrm>
              <a:custGeom>
                <a:avLst/>
                <a:gdLst>
                  <a:gd name="T0" fmla="*/ 0 w 12"/>
                  <a:gd name="T1" fmla="*/ 4 h 4"/>
                  <a:gd name="T2" fmla="*/ 4 w 12"/>
                  <a:gd name="T3" fmla="*/ 4 h 4"/>
                  <a:gd name="T4" fmla="*/ 8 w 12"/>
                  <a:gd name="T5" fmla="*/ 4 h 4"/>
                  <a:gd name="T6" fmla="*/ 8 w 12"/>
                  <a:gd name="T7" fmla="*/ 0 h 4"/>
                  <a:gd name="T8" fmla="*/ 12 w 12"/>
                  <a:gd name="T9" fmla="*/ 4 h 4"/>
                  <a:gd name="T10" fmla="*/ 12 w 12"/>
                  <a:gd name="T11" fmla="*/ 4 h 4"/>
                  <a:gd name="T12" fmla="*/ 0 w 12"/>
                  <a:gd name="T13" fmla="*/ 4 h 4"/>
                  <a:gd name="T14" fmla="*/ 0 w 12"/>
                  <a:gd name="T15" fmla="*/ 4 h 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2" h="4">
                    <a:moveTo>
                      <a:pt x="0" y="4"/>
                    </a:moveTo>
                    <a:lnTo>
                      <a:pt x="4" y="4"/>
                    </a:lnTo>
                    <a:lnTo>
                      <a:pt x="8" y="4"/>
                    </a:lnTo>
                    <a:lnTo>
                      <a:pt x="8" y="0"/>
                    </a:lnTo>
                    <a:lnTo>
                      <a:pt x="12" y="4"/>
                    </a:lnTo>
                    <a:lnTo>
                      <a:pt x="12" y="4"/>
                    </a:lnTo>
                    <a:lnTo>
                      <a:pt x="0" y="4"/>
                    </a:lnTo>
                    <a:lnTo>
                      <a:pt x="0" y="4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37" name="Freeform 233"/>
              <p:cNvSpPr>
                <a:spLocks/>
              </p:cNvSpPr>
              <p:nvPr/>
            </p:nvSpPr>
            <p:spPr bwMode="auto">
              <a:xfrm>
                <a:off x="10051618" y="5676949"/>
                <a:ext cx="18681" cy="0"/>
              </a:xfrm>
              <a:custGeom>
                <a:avLst/>
                <a:gdLst>
                  <a:gd name="T0" fmla="*/ 12 w 12"/>
                  <a:gd name="T1" fmla="*/ 12 w 12"/>
                  <a:gd name="T2" fmla="*/ 0 w 12"/>
                  <a:gd name="T3" fmla="*/ 0 w 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12">
                    <a:moveTo>
                      <a:pt x="12" y="0"/>
                    </a:moveTo>
                    <a:lnTo>
                      <a:pt x="12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38" name="Freeform 234"/>
              <p:cNvSpPr>
                <a:spLocks/>
              </p:cNvSpPr>
              <p:nvPr/>
            </p:nvSpPr>
            <p:spPr bwMode="auto">
              <a:xfrm>
                <a:off x="10076525" y="5672099"/>
                <a:ext cx="12454" cy="4850"/>
              </a:xfrm>
              <a:custGeom>
                <a:avLst/>
                <a:gdLst>
                  <a:gd name="T0" fmla="*/ 0 w 8"/>
                  <a:gd name="T1" fmla="*/ 4 h 4"/>
                  <a:gd name="T2" fmla="*/ 4 w 8"/>
                  <a:gd name="T3" fmla="*/ 4 h 4"/>
                  <a:gd name="T4" fmla="*/ 4 w 8"/>
                  <a:gd name="T5" fmla="*/ 0 h 4"/>
                  <a:gd name="T6" fmla="*/ 8 w 8"/>
                  <a:gd name="T7" fmla="*/ 4 h 4"/>
                  <a:gd name="T8" fmla="*/ 8 w 8"/>
                  <a:gd name="T9" fmla="*/ 4 h 4"/>
                  <a:gd name="T10" fmla="*/ 0 w 8"/>
                  <a:gd name="T11" fmla="*/ 4 h 4"/>
                  <a:gd name="T12" fmla="*/ 0 w 8"/>
                  <a:gd name="T13" fmla="*/ 4 h 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8" h="4">
                    <a:moveTo>
                      <a:pt x="0" y="4"/>
                    </a:moveTo>
                    <a:lnTo>
                      <a:pt x="4" y="4"/>
                    </a:lnTo>
                    <a:lnTo>
                      <a:pt x="4" y="0"/>
                    </a:lnTo>
                    <a:lnTo>
                      <a:pt x="8" y="4"/>
                    </a:lnTo>
                    <a:lnTo>
                      <a:pt x="8" y="4"/>
                    </a:lnTo>
                    <a:lnTo>
                      <a:pt x="0" y="4"/>
                    </a:lnTo>
                    <a:lnTo>
                      <a:pt x="0" y="4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39" name="Freeform 235"/>
              <p:cNvSpPr>
                <a:spLocks/>
              </p:cNvSpPr>
              <p:nvPr/>
            </p:nvSpPr>
            <p:spPr bwMode="auto">
              <a:xfrm>
                <a:off x="10076525" y="5676949"/>
                <a:ext cx="12454" cy="0"/>
              </a:xfrm>
              <a:custGeom>
                <a:avLst/>
                <a:gdLst>
                  <a:gd name="T0" fmla="*/ 8 w 8"/>
                  <a:gd name="T1" fmla="*/ 8 w 8"/>
                  <a:gd name="T2" fmla="*/ 0 w 8"/>
                  <a:gd name="T3" fmla="*/ 0 w 8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8">
                    <a:moveTo>
                      <a:pt x="8" y="0"/>
                    </a:moveTo>
                    <a:lnTo>
                      <a:pt x="8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40" name="Freeform 236"/>
              <p:cNvSpPr>
                <a:spLocks/>
              </p:cNvSpPr>
              <p:nvPr/>
            </p:nvSpPr>
            <p:spPr bwMode="auto">
              <a:xfrm>
                <a:off x="10095206" y="5662399"/>
                <a:ext cx="20237" cy="14550"/>
              </a:xfrm>
              <a:custGeom>
                <a:avLst/>
                <a:gdLst>
                  <a:gd name="T0" fmla="*/ 0 w 13"/>
                  <a:gd name="T1" fmla="*/ 12 h 12"/>
                  <a:gd name="T2" fmla="*/ 4 w 13"/>
                  <a:gd name="T3" fmla="*/ 12 h 12"/>
                  <a:gd name="T4" fmla="*/ 4 w 13"/>
                  <a:gd name="T5" fmla="*/ 0 h 12"/>
                  <a:gd name="T6" fmla="*/ 9 w 13"/>
                  <a:gd name="T7" fmla="*/ 0 h 12"/>
                  <a:gd name="T8" fmla="*/ 9 w 13"/>
                  <a:gd name="T9" fmla="*/ 12 h 12"/>
                  <a:gd name="T10" fmla="*/ 9 w 13"/>
                  <a:gd name="T11" fmla="*/ 0 h 12"/>
                  <a:gd name="T12" fmla="*/ 9 w 13"/>
                  <a:gd name="T13" fmla="*/ 12 h 12"/>
                  <a:gd name="T14" fmla="*/ 13 w 13"/>
                  <a:gd name="T15" fmla="*/ 12 h 12"/>
                  <a:gd name="T16" fmla="*/ 13 w 13"/>
                  <a:gd name="T17" fmla="*/ 12 h 12"/>
                  <a:gd name="T18" fmla="*/ 0 w 13"/>
                  <a:gd name="T19" fmla="*/ 12 h 12"/>
                  <a:gd name="T20" fmla="*/ 0 w 13"/>
                  <a:gd name="T21" fmla="*/ 12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13" h="12">
                    <a:moveTo>
                      <a:pt x="0" y="12"/>
                    </a:moveTo>
                    <a:lnTo>
                      <a:pt x="4" y="12"/>
                    </a:lnTo>
                    <a:lnTo>
                      <a:pt x="4" y="0"/>
                    </a:lnTo>
                    <a:lnTo>
                      <a:pt x="9" y="0"/>
                    </a:lnTo>
                    <a:lnTo>
                      <a:pt x="9" y="12"/>
                    </a:lnTo>
                    <a:lnTo>
                      <a:pt x="9" y="0"/>
                    </a:lnTo>
                    <a:lnTo>
                      <a:pt x="9" y="12"/>
                    </a:lnTo>
                    <a:lnTo>
                      <a:pt x="13" y="12"/>
                    </a:lnTo>
                    <a:lnTo>
                      <a:pt x="13" y="12"/>
                    </a:lnTo>
                    <a:lnTo>
                      <a:pt x="0" y="12"/>
                    </a:lnTo>
                    <a:lnTo>
                      <a:pt x="0" y="12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41" name="Freeform 237"/>
              <p:cNvSpPr>
                <a:spLocks/>
              </p:cNvSpPr>
              <p:nvPr/>
            </p:nvSpPr>
            <p:spPr bwMode="auto">
              <a:xfrm>
                <a:off x="10095206" y="5676949"/>
                <a:ext cx="20237" cy="0"/>
              </a:xfrm>
              <a:custGeom>
                <a:avLst/>
                <a:gdLst>
                  <a:gd name="T0" fmla="*/ 13 w 13"/>
                  <a:gd name="T1" fmla="*/ 13 w 13"/>
                  <a:gd name="T2" fmla="*/ 0 w 13"/>
                  <a:gd name="T3" fmla="*/ 0 w 13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13">
                    <a:moveTo>
                      <a:pt x="13" y="0"/>
                    </a:moveTo>
                    <a:lnTo>
                      <a:pt x="13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42" name="Freeform 238"/>
              <p:cNvSpPr>
                <a:spLocks/>
              </p:cNvSpPr>
              <p:nvPr/>
            </p:nvSpPr>
            <p:spPr bwMode="auto">
              <a:xfrm>
                <a:off x="10115443" y="5638150"/>
                <a:ext cx="18681" cy="38800"/>
              </a:xfrm>
              <a:custGeom>
                <a:avLst/>
                <a:gdLst>
                  <a:gd name="T0" fmla="*/ 0 w 12"/>
                  <a:gd name="T1" fmla="*/ 32 h 32"/>
                  <a:gd name="T2" fmla="*/ 4 w 12"/>
                  <a:gd name="T3" fmla="*/ 32 h 32"/>
                  <a:gd name="T4" fmla="*/ 4 w 12"/>
                  <a:gd name="T5" fmla="*/ 0 h 32"/>
                  <a:gd name="T6" fmla="*/ 8 w 12"/>
                  <a:gd name="T7" fmla="*/ 20 h 32"/>
                  <a:gd name="T8" fmla="*/ 8 w 12"/>
                  <a:gd name="T9" fmla="*/ 32 h 32"/>
                  <a:gd name="T10" fmla="*/ 8 w 12"/>
                  <a:gd name="T11" fmla="*/ 20 h 32"/>
                  <a:gd name="T12" fmla="*/ 8 w 12"/>
                  <a:gd name="T13" fmla="*/ 32 h 32"/>
                  <a:gd name="T14" fmla="*/ 12 w 12"/>
                  <a:gd name="T15" fmla="*/ 32 h 32"/>
                  <a:gd name="T16" fmla="*/ 12 w 12"/>
                  <a:gd name="T17" fmla="*/ 32 h 32"/>
                  <a:gd name="T18" fmla="*/ 0 w 12"/>
                  <a:gd name="T19" fmla="*/ 32 h 32"/>
                  <a:gd name="T20" fmla="*/ 0 w 12"/>
                  <a:gd name="T21" fmla="*/ 32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12" h="32">
                    <a:moveTo>
                      <a:pt x="0" y="32"/>
                    </a:moveTo>
                    <a:lnTo>
                      <a:pt x="4" y="32"/>
                    </a:lnTo>
                    <a:lnTo>
                      <a:pt x="4" y="0"/>
                    </a:lnTo>
                    <a:lnTo>
                      <a:pt x="8" y="20"/>
                    </a:lnTo>
                    <a:lnTo>
                      <a:pt x="8" y="32"/>
                    </a:lnTo>
                    <a:lnTo>
                      <a:pt x="8" y="20"/>
                    </a:lnTo>
                    <a:lnTo>
                      <a:pt x="8" y="32"/>
                    </a:lnTo>
                    <a:lnTo>
                      <a:pt x="12" y="32"/>
                    </a:lnTo>
                    <a:lnTo>
                      <a:pt x="12" y="32"/>
                    </a:lnTo>
                    <a:lnTo>
                      <a:pt x="0" y="32"/>
                    </a:lnTo>
                    <a:lnTo>
                      <a:pt x="0" y="32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43" name="Freeform 239"/>
              <p:cNvSpPr>
                <a:spLocks/>
              </p:cNvSpPr>
              <p:nvPr/>
            </p:nvSpPr>
            <p:spPr bwMode="auto">
              <a:xfrm>
                <a:off x="10115443" y="5676949"/>
                <a:ext cx="18681" cy="0"/>
              </a:xfrm>
              <a:custGeom>
                <a:avLst/>
                <a:gdLst>
                  <a:gd name="T0" fmla="*/ 12 w 12"/>
                  <a:gd name="T1" fmla="*/ 12 w 12"/>
                  <a:gd name="T2" fmla="*/ 0 w 12"/>
                  <a:gd name="T3" fmla="*/ 0 w 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12">
                    <a:moveTo>
                      <a:pt x="12" y="0"/>
                    </a:moveTo>
                    <a:lnTo>
                      <a:pt x="12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44" name="Freeform 240"/>
              <p:cNvSpPr>
                <a:spLocks/>
              </p:cNvSpPr>
              <p:nvPr/>
            </p:nvSpPr>
            <p:spPr bwMode="auto">
              <a:xfrm>
                <a:off x="10134124" y="5657549"/>
                <a:ext cx="18681" cy="19400"/>
              </a:xfrm>
              <a:custGeom>
                <a:avLst/>
                <a:gdLst>
                  <a:gd name="T0" fmla="*/ 0 w 12"/>
                  <a:gd name="T1" fmla="*/ 16 h 16"/>
                  <a:gd name="T2" fmla="*/ 4 w 12"/>
                  <a:gd name="T3" fmla="*/ 16 h 16"/>
                  <a:gd name="T4" fmla="*/ 4 w 12"/>
                  <a:gd name="T5" fmla="*/ 0 h 16"/>
                  <a:gd name="T6" fmla="*/ 8 w 12"/>
                  <a:gd name="T7" fmla="*/ 0 h 16"/>
                  <a:gd name="T8" fmla="*/ 8 w 12"/>
                  <a:gd name="T9" fmla="*/ 16 h 16"/>
                  <a:gd name="T10" fmla="*/ 8 w 12"/>
                  <a:gd name="T11" fmla="*/ 0 h 16"/>
                  <a:gd name="T12" fmla="*/ 8 w 12"/>
                  <a:gd name="T13" fmla="*/ 16 h 16"/>
                  <a:gd name="T14" fmla="*/ 12 w 12"/>
                  <a:gd name="T15" fmla="*/ 16 h 16"/>
                  <a:gd name="T16" fmla="*/ 12 w 12"/>
                  <a:gd name="T17" fmla="*/ 16 h 16"/>
                  <a:gd name="T18" fmla="*/ 0 w 12"/>
                  <a:gd name="T19" fmla="*/ 16 h 16"/>
                  <a:gd name="T20" fmla="*/ 0 w 12"/>
                  <a:gd name="T21" fmla="*/ 16 h 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12" h="16">
                    <a:moveTo>
                      <a:pt x="0" y="16"/>
                    </a:moveTo>
                    <a:lnTo>
                      <a:pt x="4" y="16"/>
                    </a:lnTo>
                    <a:lnTo>
                      <a:pt x="4" y="0"/>
                    </a:lnTo>
                    <a:lnTo>
                      <a:pt x="8" y="0"/>
                    </a:lnTo>
                    <a:lnTo>
                      <a:pt x="8" y="16"/>
                    </a:lnTo>
                    <a:lnTo>
                      <a:pt x="8" y="0"/>
                    </a:lnTo>
                    <a:lnTo>
                      <a:pt x="8" y="16"/>
                    </a:lnTo>
                    <a:lnTo>
                      <a:pt x="12" y="16"/>
                    </a:lnTo>
                    <a:lnTo>
                      <a:pt x="12" y="16"/>
                    </a:lnTo>
                    <a:lnTo>
                      <a:pt x="0" y="16"/>
                    </a:lnTo>
                    <a:lnTo>
                      <a:pt x="0" y="16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45" name="Freeform 241"/>
              <p:cNvSpPr>
                <a:spLocks/>
              </p:cNvSpPr>
              <p:nvPr/>
            </p:nvSpPr>
            <p:spPr bwMode="auto">
              <a:xfrm>
                <a:off x="10134124" y="5676949"/>
                <a:ext cx="18681" cy="0"/>
              </a:xfrm>
              <a:custGeom>
                <a:avLst/>
                <a:gdLst>
                  <a:gd name="T0" fmla="*/ 12 w 12"/>
                  <a:gd name="T1" fmla="*/ 12 w 12"/>
                  <a:gd name="T2" fmla="*/ 0 w 12"/>
                  <a:gd name="T3" fmla="*/ 0 w 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12">
                    <a:moveTo>
                      <a:pt x="12" y="0"/>
                    </a:moveTo>
                    <a:lnTo>
                      <a:pt x="12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46" name="Freeform 242"/>
              <p:cNvSpPr>
                <a:spLocks/>
              </p:cNvSpPr>
              <p:nvPr/>
            </p:nvSpPr>
            <p:spPr bwMode="auto">
              <a:xfrm>
                <a:off x="10152804" y="5593288"/>
                <a:ext cx="18681" cy="83661"/>
              </a:xfrm>
              <a:custGeom>
                <a:avLst/>
                <a:gdLst>
                  <a:gd name="T0" fmla="*/ 0 w 12"/>
                  <a:gd name="T1" fmla="*/ 69 h 69"/>
                  <a:gd name="T2" fmla="*/ 4 w 12"/>
                  <a:gd name="T3" fmla="*/ 65 h 69"/>
                  <a:gd name="T4" fmla="*/ 4 w 12"/>
                  <a:gd name="T5" fmla="*/ 12 h 69"/>
                  <a:gd name="T6" fmla="*/ 8 w 12"/>
                  <a:gd name="T7" fmla="*/ 0 h 69"/>
                  <a:gd name="T8" fmla="*/ 8 w 12"/>
                  <a:gd name="T9" fmla="*/ 69 h 69"/>
                  <a:gd name="T10" fmla="*/ 8 w 12"/>
                  <a:gd name="T11" fmla="*/ 0 h 69"/>
                  <a:gd name="T12" fmla="*/ 12 w 12"/>
                  <a:gd name="T13" fmla="*/ 69 h 69"/>
                  <a:gd name="T14" fmla="*/ 12 w 12"/>
                  <a:gd name="T15" fmla="*/ 69 h 69"/>
                  <a:gd name="T16" fmla="*/ 0 w 12"/>
                  <a:gd name="T17" fmla="*/ 69 h 69"/>
                  <a:gd name="T18" fmla="*/ 0 w 12"/>
                  <a:gd name="T19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12" h="69">
                    <a:moveTo>
                      <a:pt x="0" y="69"/>
                    </a:moveTo>
                    <a:lnTo>
                      <a:pt x="4" y="65"/>
                    </a:lnTo>
                    <a:lnTo>
                      <a:pt x="4" y="12"/>
                    </a:lnTo>
                    <a:lnTo>
                      <a:pt x="8" y="0"/>
                    </a:lnTo>
                    <a:lnTo>
                      <a:pt x="8" y="69"/>
                    </a:lnTo>
                    <a:lnTo>
                      <a:pt x="8" y="0"/>
                    </a:lnTo>
                    <a:lnTo>
                      <a:pt x="12" y="69"/>
                    </a:lnTo>
                    <a:lnTo>
                      <a:pt x="12" y="69"/>
                    </a:lnTo>
                    <a:lnTo>
                      <a:pt x="0" y="69"/>
                    </a:lnTo>
                    <a:lnTo>
                      <a:pt x="0" y="69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47" name="Freeform 243"/>
              <p:cNvSpPr>
                <a:spLocks/>
              </p:cNvSpPr>
              <p:nvPr/>
            </p:nvSpPr>
            <p:spPr bwMode="auto">
              <a:xfrm>
                <a:off x="10152804" y="5676949"/>
                <a:ext cx="18681" cy="0"/>
              </a:xfrm>
              <a:custGeom>
                <a:avLst/>
                <a:gdLst>
                  <a:gd name="T0" fmla="*/ 12 w 12"/>
                  <a:gd name="T1" fmla="*/ 12 w 12"/>
                  <a:gd name="T2" fmla="*/ 0 w 12"/>
                  <a:gd name="T3" fmla="*/ 0 w 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12">
                    <a:moveTo>
                      <a:pt x="12" y="0"/>
                    </a:moveTo>
                    <a:lnTo>
                      <a:pt x="12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48" name="Freeform 244"/>
              <p:cNvSpPr>
                <a:spLocks/>
              </p:cNvSpPr>
              <p:nvPr/>
            </p:nvSpPr>
            <p:spPr bwMode="auto">
              <a:xfrm>
                <a:off x="10171485" y="5652699"/>
                <a:ext cx="18681" cy="24250"/>
              </a:xfrm>
              <a:custGeom>
                <a:avLst/>
                <a:gdLst>
                  <a:gd name="T0" fmla="*/ 0 w 12"/>
                  <a:gd name="T1" fmla="*/ 20 h 20"/>
                  <a:gd name="T2" fmla="*/ 4 w 12"/>
                  <a:gd name="T3" fmla="*/ 20 h 20"/>
                  <a:gd name="T4" fmla="*/ 4 w 12"/>
                  <a:gd name="T5" fmla="*/ 4 h 20"/>
                  <a:gd name="T6" fmla="*/ 8 w 12"/>
                  <a:gd name="T7" fmla="*/ 0 h 20"/>
                  <a:gd name="T8" fmla="*/ 8 w 12"/>
                  <a:gd name="T9" fmla="*/ 20 h 20"/>
                  <a:gd name="T10" fmla="*/ 8 w 12"/>
                  <a:gd name="T11" fmla="*/ 0 h 20"/>
                  <a:gd name="T12" fmla="*/ 12 w 12"/>
                  <a:gd name="T13" fmla="*/ 20 h 20"/>
                  <a:gd name="T14" fmla="*/ 12 w 12"/>
                  <a:gd name="T15" fmla="*/ 20 h 20"/>
                  <a:gd name="T16" fmla="*/ 0 w 12"/>
                  <a:gd name="T17" fmla="*/ 20 h 20"/>
                  <a:gd name="T18" fmla="*/ 0 w 12"/>
                  <a:gd name="T19" fmla="*/ 20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12" h="20">
                    <a:moveTo>
                      <a:pt x="0" y="20"/>
                    </a:moveTo>
                    <a:lnTo>
                      <a:pt x="4" y="20"/>
                    </a:lnTo>
                    <a:lnTo>
                      <a:pt x="4" y="4"/>
                    </a:lnTo>
                    <a:lnTo>
                      <a:pt x="8" y="0"/>
                    </a:lnTo>
                    <a:lnTo>
                      <a:pt x="8" y="20"/>
                    </a:lnTo>
                    <a:lnTo>
                      <a:pt x="8" y="0"/>
                    </a:lnTo>
                    <a:lnTo>
                      <a:pt x="12" y="20"/>
                    </a:lnTo>
                    <a:lnTo>
                      <a:pt x="12" y="20"/>
                    </a:lnTo>
                    <a:lnTo>
                      <a:pt x="0" y="20"/>
                    </a:lnTo>
                    <a:lnTo>
                      <a:pt x="0" y="20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49" name="Freeform 245"/>
              <p:cNvSpPr>
                <a:spLocks/>
              </p:cNvSpPr>
              <p:nvPr/>
            </p:nvSpPr>
            <p:spPr bwMode="auto">
              <a:xfrm>
                <a:off x="10171485" y="5676949"/>
                <a:ext cx="18681" cy="0"/>
              </a:xfrm>
              <a:custGeom>
                <a:avLst/>
                <a:gdLst>
                  <a:gd name="T0" fmla="*/ 12 w 12"/>
                  <a:gd name="T1" fmla="*/ 12 w 12"/>
                  <a:gd name="T2" fmla="*/ 0 w 12"/>
                  <a:gd name="T3" fmla="*/ 0 w 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12">
                    <a:moveTo>
                      <a:pt x="12" y="0"/>
                    </a:moveTo>
                    <a:lnTo>
                      <a:pt x="12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50" name="Freeform 246"/>
              <p:cNvSpPr>
                <a:spLocks/>
              </p:cNvSpPr>
              <p:nvPr/>
            </p:nvSpPr>
            <p:spPr bwMode="auto">
              <a:xfrm>
                <a:off x="10190166" y="5672099"/>
                <a:ext cx="20237" cy="4850"/>
              </a:xfrm>
              <a:custGeom>
                <a:avLst/>
                <a:gdLst>
                  <a:gd name="T0" fmla="*/ 0 w 13"/>
                  <a:gd name="T1" fmla="*/ 4 h 4"/>
                  <a:gd name="T2" fmla="*/ 4 w 13"/>
                  <a:gd name="T3" fmla="*/ 4 h 4"/>
                  <a:gd name="T4" fmla="*/ 9 w 13"/>
                  <a:gd name="T5" fmla="*/ 0 h 4"/>
                  <a:gd name="T6" fmla="*/ 9 w 13"/>
                  <a:gd name="T7" fmla="*/ 4 h 4"/>
                  <a:gd name="T8" fmla="*/ 9 w 13"/>
                  <a:gd name="T9" fmla="*/ 0 h 4"/>
                  <a:gd name="T10" fmla="*/ 13 w 13"/>
                  <a:gd name="T11" fmla="*/ 4 h 4"/>
                  <a:gd name="T12" fmla="*/ 13 w 13"/>
                  <a:gd name="T13" fmla="*/ 4 h 4"/>
                  <a:gd name="T14" fmla="*/ 0 w 13"/>
                  <a:gd name="T15" fmla="*/ 4 h 4"/>
                  <a:gd name="T16" fmla="*/ 0 w 13"/>
                  <a:gd name="T17" fmla="*/ 4 h 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13" h="4">
                    <a:moveTo>
                      <a:pt x="0" y="4"/>
                    </a:moveTo>
                    <a:lnTo>
                      <a:pt x="4" y="4"/>
                    </a:lnTo>
                    <a:lnTo>
                      <a:pt x="9" y="0"/>
                    </a:lnTo>
                    <a:lnTo>
                      <a:pt x="9" y="4"/>
                    </a:lnTo>
                    <a:lnTo>
                      <a:pt x="9" y="0"/>
                    </a:lnTo>
                    <a:lnTo>
                      <a:pt x="13" y="4"/>
                    </a:lnTo>
                    <a:lnTo>
                      <a:pt x="13" y="4"/>
                    </a:lnTo>
                    <a:lnTo>
                      <a:pt x="0" y="4"/>
                    </a:lnTo>
                    <a:lnTo>
                      <a:pt x="0" y="4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51" name="Freeform 247"/>
              <p:cNvSpPr>
                <a:spLocks/>
              </p:cNvSpPr>
              <p:nvPr/>
            </p:nvSpPr>
            <p:spPr bwMode="auto">
              <a:xfrm>
                <a:off x="10190166" y="5676949"/>
                <a:ext cx="20237" cy="0"/>
              </a:xfrm>
              <a:custGeom>
                <a:avLst/>
                <a:gdLst>
                  <a:gd name="T0" fmla="*/ 13 w 13"/>
                  <a:gd name="T1" fmla="*/ 13 w 13"/>
                  <a:gd name="T2" fmla="*/ 0 w 13"/>
                  <a:gd name="T3" fmla="*/ 0 w 13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13">
                    <a:moveTo>
                      <a:pt x="13" y="0"/>
                    </a:moveTo>
                    <a:lnTo>
                      <a:pt x="13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52" name="Freeform 248"/>
              <p:cNvSpPr>
                <a:spLocks/>
              </p:cNvSpPr>
              <p:nvPr/>
            </p:nvSpPr>
            <p:spPr bwMode="auto">
              <a:xfrm>
                <a:off x="10210403" y="5662399"/>
                <a:ext cx="18681" cy="14550"/>
              </a:xfrm>
              <a:custGeom>
                <a:avLst/>
                <a:gdLst>
                  <a:gd name="T0" fmla="*/ 0 w 12"/>
                  <a:gd name="T1" fmla="*/ 12 h 12"/>
                  <a:gd name="T2" fmla="*/ 4 w 12"/>
                  <a:gd name="T3" fmla="*/ 12 h 12"/>
                  <a:gd name="T4" fmla="*/ 4 w 12"/>
                  <a:gd name="T5" fmla="*/ 8 h 12"/>
                  <a:gd name="T6" fmla="*/ 8 w 12"/>
                  <a:gd name="T7" fmla="*/ 4 h 12"/>
                  <a:gd name="T8" fmla="*/ 8 w 12"/>
                  <a:gd name="T9" fmla="*/ 12 h 12"/>
                  <a:gd name="T10" fmla="*/ 8 w 12"/>
                  <a:gd name="T11" fmla="*/ 0 h 12"/>
                  <a:gd name="T12" fmla="*/ 12 w 12"/>
                  <a:gd name="T13" fmla="*/ 12 h 12"/>
                  <a:gd name="T14" fmla="*/ 12 w 12"/>
                  <a:gd name="T15" fmla="*/ 12 h 12"/>
                  <a:gd name="T16" fmla="*/ 0 w 12"/>
                  <a:gd name="T17" fmla="*/ 12 h 12"/>
                  <a:gd name="T18" fmla="*/ 0 w 12"/>
                  <a:gd name="T19" fmla="*/ 12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12" h="12">
                    <a:moveTo>
                      <a:pt x="0" y="12"/>
                    </a:moveTo>
                    <a:lnTo>
                      <a:pt x="4" y="12"/>
                    </a:lnTo>
                    <a:lnTo>
                      <a:pt x="4" y="8"/>
                    </a:lnTo>
                    <a:lnTo>
                      <a:pt x="8" y="4"/>
                    </a:lnTo>
                    <a:lnTo>
                      <a:pt x="8" y="12"/>
                    </a:lnTo>
                    <a:lnTo>
                      <a:pt x="8" y="0"/>
                    </a:lnTo>
                    <a:lnTo>
                      <a:pt x="12" y="12"/>
                    </a:lnTo>
                    <a:lnTo>
                      <a:pt x="12" y="12"/>
                    </a:lnTo>
                    <a:lnTo>
                      <a:pt x="0" y="12"/>
                    </a:lnTo>
                    <a:lnTo>
                      <a:pt x="0" y="12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53" name="Freeform 249"/>
              <p:cNvSpPr>
                <a:spLocks/>
              </p:cNvSpPr>
              <p:nvPr/>
            </p:nvSpPr>
            <p:spPr bwMode="auto">
              <a:xfrm>
                <a:off x="10210403" y="5676949"/>
                <a:ext cx="18681" cy="0"/>
              </a:xfrm>
              <a:custGeom>
                <a:avLst/>
                <a:gdLst>
                  <a:gd name="T0" fmla="*/ 12 w 12"/>
                  <a:gd name="T1" fmla="*/ 12 w 12"/>
                  <a:gd name="T2" fmla="*/ 0 w 12"/>
                  <a:gd name="T3" fmla="*/ 0 w 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12">
                    <a:moveTo>
                      <a:pt x="12" y="0"/>
                    </a:moveTo>
                    <a:lnTo>
                      <a:pt x="12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54" name="Freeform 250"/>
              <p:cNvSpPr>
                <a:spLocks/>
              </p:cNvSpPr>
              <p:nvPr/>
            </p:nvSpPr>
            <p:spPr bwMode="auto">
              <a:xfrm>
                <a:off x="10229084" y="5672099"/>
                <a:ext cx="18681" cy="4850"/>
              </a:xfrm>
              <a:custGeom>
                <a:avLst/>
                <a:gdLst>
                  <a:gd name="T0" fmla="*/ 0 w 12"/>
                  <a:gd name="T1" fmla="*/ 4 h 4"/>
                  <a:gd name="T2" fmla="*/ 4 w 12"/>
                  <a:gd name="T3" fmla="*/ 4 h 4"/>
                  <a:gd name="T4" fmla="*/ 8 w 12"/>
                  <a:gd name="T5" fmla="*/ 4 h 4"/>
                  <a:gd name="T6" fmla="*/ 8 w 12"/>
                  <a:gd name="T7" fmla="*/ 0 h 4"/>
                  <a:gd name="T8" fmla="*/ 12 w 12"/>
                  <a:gd name="T9" fmla="*/ 4 h 4"/>
                  <a:gd name="T10" fmla="*/ 12 w 12"/>
                  <a:gd name="T11" fmla="*/ 4 h 4"/>
                  <a:gd name="T12" fmla="*/ 0 w 12"/>
                  <a:gd name="T13" fmla="*/ 4 h 4"/>
                  <a:gd name="T14" fmla="*/ 0 w 12"/>
                  <a:gd name="T15" fmla="*/ 4 h 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2" h="4">
                    <a:moveTo>
                      <a:pt x="0" y="4"/>
                    </a:moveTo>
                    <a:lnTo>
                      <a:pt x="4" y="4"/>
                    </a:lnTo>
                    <a:lnTo>
                      <a:pt x="8" y="4"/>
                    </a:lnTo>
                    <a:lnTo>
                      <a:pt x="8" y="0"/>
                    </a:lnTo>
                    <a:lnTo>
                      <a:pt x="12" y="4"/>
                    </a:lnTo>
                    <a:lnTo>
                      <a:pt x="12" y="4"/>
                    </a:lnTo>
                    <a:lnTo>
                      <a:pt x="0" y="4"/>
                    </a:lnTo>
                    <a:lnTo>
                      <a:pt x="0" y="4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55" name="Freeform 251"/>
              <p:cNvSpPr>
                <a:spLocks/>
              </p:cNvSpPr>
              <p:nvPr/>
            </p:nvSpPr>
            <p:spPr bwMode="auto">
              <a:xfrm>
                <a:off x="10229084" y="5676949"/>
                <a:ext cx="18681" cy="0"/>
              </a:xfrm>
              <a:custGeom>
                <a:avLst/>
                <a:gdLst>
                  <a:gd name="T0" fmla="*/ 12 w 12"/>
                  <a:gd name="T1" fmla="*/ 12 w 12"/>
                  <a:gd name="T2" fmla="*/ 0 w 12"/>
                  <a:gd name="T3" fmla="*/ 0 w 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12">
                    <a:moveTo>
                      <a:pt x="12" y="0"/>
                    </a:moveTo>
                    <a:lnTo>
                      <a:pt x="12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56" name="Freeform 252"/>
              <p:cNvSpPr>
                <a:spLocks/>
              </p:cNvSpPr>
              <p:nvPr/>
            </p:nvSpPr>
            <p:spPr bwMode="auto">
              <a:xfrm>
                <a:off x="10253991" y="5657549"/>
                <a:ext cx="12454" cy="19400"/>
              </a:xfrm>
              <a:custGeom>
                <a:avLst/>
                <a:gdLst>
                  <a:gd name="T0" fmla="*/ 0 w 8"/>
                  <a:gd name="T1" fmla="*/ 16 h 16"/>
                  <a:gd name="T2" fmla="*/ 4 w 8"/>
                  <a:gd name="T3" fmla="*/ 12 h 16"/>
                  <a:gd name="T4" fmla="*/ 4 w 8"/>
                  <a:gd name="T5" fmla="*/ 16 h 16"/>
                  <a:gd name="T6" fmla="*/ 4 w 8"/>
                  <a:gd name="T7" fmla="*/ 0 h 16"/>
                  <a:gd name="T8" fmla="*/ 8 w 8"/>
                  <a:gd name="T9" fmla="*/ 16 h 16"/>
                  <a:gd name="T10" fmla="*/ 8 w 8"/>
                  <a:gd name="T11" fmla="*/ 16 h 16"/>
                  <a:gd name="T12" fmla="*/ 0 w 8"/>
                  <a:gd name="T13" fmla="*/ 16 h 16"/>
                  <a:gd name="T14" fmla="*/ 0 w 8"/>
                  <a:gd name="T15" fmla="*/ 16 h 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8" h="16">
                    <a:moveTo>
                      <a:pt x="0" y="16"/>
                    </a:moveTo>
                    <a:lnTo>
                      <a:pt x="4" y="12"/>
                    </a:lnTo>
                    <a:lnTo>
                      <a:pt x="4" y="16"/>
                    </a:lnTo>
                    <a:lnTo>
                      <a:pt x="4" y="0"/>
                    </a:lnTo>
                    <a:lnTo>
                      <a:pt x="8" y="16"/>
                    </a:lnTo>
                    <a:lnTo>
                      <a:pt x="8" y="16"/>
                    </a:lnTo>
                    <a:lnTo>
                      <a:pt x="0" y="16"/>
                    </a:lnTo>
                    <a:lnTo>
                      <a:pt x="0" y="16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57" name="Freeform 253"/>
              <p:cNvSpPr>
                <a:spLocks/>
              </p:cNvSpPr>
              <p:nvPr/>
            </p:nvSpPr>
            <p:spPr bwMode="auto">
              <a:xfrm>
                <a:off x="10253991" y="5676949"/>
                <a:ext cx="12454" cy="0"/>
              </a:xfrm>
              <a:custGeom>
                <a:avLst/>
                <a:gdLst>
                  <a:gd name="T0" fmla="*/ 8 w 8"/>
                  <a:gd name="T1" fmla="*/ 8 w 8"/>
                  <a:gd name="T2" fmla="*/ 0 w 8"/>
                  <a:gd name="T3" fmla="*/ 0 w 8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8">
                    <a:moveTo>
                      <a:pt x="8" y="0"/>
                    </a:moveTo>
                    <a:lnTo>
                      <a:pt x="8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58" name="Freeform 254"/>
              <p:cNvSpPr>
                <a:spLocks/>
              </p:cNvSpPr>
              <p:nvPr/>
            </p:nvSpPr>
            <p:spPr bwMode="auto">
              <a:xfrm>
                <a:off x="10272672" y="5676949"/>
                <a:ext cx="12454" cy="0"/>
              </a:xfrm>
              <a:custGeom>
                <a:avLst/>
                <a:gdLst>
                  <a:gd name="T0" fmla="*/ 8 w 8"/>
                  <a:gd name="T1" fmla="*/ 8 w 8"/>
                  <a:gd name="T2" fmla="*/ 0 w 8"/>
                  <a:gd name="T3" fmla="*/ 0 w 8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8">
                    <a:moveTo>
                      <a:pt x="8" y="0"/>
                    </a:moveTo>
                    <a:lnTo>
                      <a:pt x="8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59" name="Freeform 255"/>
              <p:cNvSpPr>
                <a:spLocks/>
              </p:cNvSpPr>
              <p:nvPr/>
            </p:nvSpPr>
            <p:spPr bwMode="auto">
              <a:xfrm>
                <a:off x="10285125" y="5667249"/>
                <a:ext cx="20237" cy="9700"/>
              </a:xfrm>
              <a:custGeom>
                <a:avLst/>
                <a:gdLst>
                  <a:gd name="T0" fmla="*/ 0 w 13"/>
                  <a:gd name="T1" fmla="*/ 8 h 8"/>
                  <a:gd name="T2" fmla="*/ 4 w 13"/>
                  <a:gd name="T3" fmla="*/ 8 h 8"/>
                  <a:gd name="T4" fmla="*/ 9 w 13"/>
                  <a:gd name="T5" fmla="*/ 4 h 8"/>
                  <a:gd name="T6" fmla="*/ 9 w 13"/>
                  <a:gd name="T7" fmla="*/ 0 h 8"/>
                  <a:gd name="T8" fmla="*/ 9 w 13"/>
                  <a:gd name="T9" fmla="*/ 4 h 8"/>
                  <a:gd name="T10" fmla="*/ 13 w 13"/>
                  <a:gd name="T11" fmla="*/ 8 h 8"/>
                  <a:gd name="T12" fmla="*/ 13 w 13"/>
                  <a:gd name="T13" fmla="*/ 8 h 8"/>
                  <a:gd name="T14" fmla="*/ 0 w 13"/>
                  <a:gd name="T15" fmla="*/ 8 h 8"/>
                  <a:gd name="T16" fmla="*/ 0 w 13"/>
                  <a:gd name="T17" fmla="*/ 8 h 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13" h="8">
                    <a:moveTo>
                      <a:pt x="0" y="8"/>
                    </a:moveTo>
                    <a:lnTo>
                      <a:pt x="4" y="8"/>
                    </a:lnTo>
                    <a:lnTo>
                      <a:pt x="9" y="4"/>
                    </a:lnTo>
                    <a:lnTo>
                      <a:pt x="9" y="0"/>
                    </a:lnTo>
                    <a:lnTo>
                      <a:pt x="9" y="4"/>
                    </a:lnTo>
                    <a:lnTo>
                      <a:pt x="13" y="8"/>
                    </a:lnTo>
                    <a:lnTo>
                      <a:pt x="13" y="8"/>
                    </a:lnTo>
                    <a:lnTo>
                      <a:pt x="0" y="8"/>
                    </a:lnTo>
                    <a:lnTo>
                      <a:pt x="0" y="8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60" name="Freeform 256"/>
              <p:cNvSpPr>
                <a:spLocks/>
              </p:cNvSpPr>
              <p:nvPr/>
            </p:nvSpPr>
            <p:spPr bwMode="auto">
              <a:xfrm>
                <a:off x="10285125" y="5676949"/>
                <a:ext cx="20237" cy="0"/>
              </a:xfrm>
              <a:custGeom>
                <a:avLst/>
                <a:gdLst>
                  <a:gd name="T0" fmla="*/ 13 w 13"/>
                  <a:gd name="T1" fmla="*/ 13 w 13"/>
                  <a:gd name="T2" fmla="*/ 0 w 13"/>
                  <a:gd name="T3" fmla="*/ 0 w 13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13">
                    <a:moveTo>
                      <a:pt x="13" y="0"/>
                    </a:moveTo>
                    <a:lnTo>
                      <a:pt x="13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61" name="Freeform 257"/>
              <p:cNvSpPr>
                <a:spLocks/>
              </p:cNvSpPr>
              <p:nvPr/>
            </p:nvSpPr>
            <p:spPr bwMode="auto">
              <a:xfrm>
                <a:off x="10305363" y="5676949"/>
                <a:ext cx="18681" cy="0"/>
              </a:xfrm>
              <a:custGeom>
                <a:avLst/>
                <a:gdLst>
                  <a:gd name="T0" fmla="*/ 12 w 12"/>
                  <a:gd name="T1" fmla="*/ 12 w 12"/>
                  <a:gd name="T2" fmla="*/ 0 w 12"/>
                  <a:gd name="T3" fmla="*/ 0 w 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12">
                    <a:moveTo>
                      <a:pt x="12" y="0"/>
                    </a:moveTo>
                    <a:lnTo>
                      <a:pt x="12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62" name="Freeform 258"/>
              <p:cNvSpPr>
                <a:spLocks/>
              </p:cNvSpPr>
              <p:nvPr/>
            </p:nvSpPr>
            <p:spPr bwMode="auto">
              <a:xfrm>
                <a:off x="10324043" y="5667249"/>
                <a:ext cx="18681" cy="9700"/>
              </a:xfrm>
              <a:custGeom>
                <a:avLst/>
                <a:gdLst>
                  <a:gd name="T0" fmla="*/ 0 w 12"/>
                  <a:gd name="T1" fmla="*/ 8 h 8"/>
                  <a:gd name="T2" fmla="*/ 4 w 12"/>
                  <a:gd name="T3" fmla="*/ 8 h 8"/>
                  <a:gd name="T4" fmla="*/ 8 w 12"/>
                  <a:gd name="T5" fmla="*/ 8 h 8"/>
                  <a:gd name="T6" fmla="*/ 8 w 12"/>
                  <a:gd name="T7" fmla="*/ 0 h 8"/>
                  <a:gd name="T8" fmla="*/ 12 w 12"/>
                  <a:gd name="T9" fmla="*/ 8 h 8"/>
                  <a:gd name="T10" fmla="*/ 12 w 12"/>
                  <a:gd name="T11" fmla="*/ 8 h 8"/>
                  <a:gd name="T12" fmla="*/ 0 w 12"/>
                  <a:gd name="T13" fmla="*/ 8 h 8"/>
                  <a:gd name="T14" fmla="*/ 0 w 12"/>
                  <a:gd name="T15" fmla="*/ 8 h 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2" h="8">
                    <a:moveTo>
                      <a:pt x="0" y="8"/>
                    </a:moveTo>
                    <a:lnTo>
                      <a:pt x="4" y="8"/>
                    </a:lnTo>
                    <a:lnTo>
                      <a:pt x="8" y="8"/>
                    </a:lnTo>
                    <a:lnTo>
                      <a:pt x="8" y="0"/>
                    </a:lnTo>
                    <a:lnTo>
                      <a:pt x="12" y="8"/>
                    </a:lnTo>
                    <a:lnTo>
                      <a:pt x="12" y="8"/>
                    </a:lnTo>
                    <a:lnTo>
                      <a:pt x="0" y="8"/>
                    </a:lnTo>
                    <a:lnTo>
                      <a:pt x="0" y="8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63" name="Freeform 259"/>
              <p:cNvSpPr>
                <a:spLocks/>
              </p:cNvSpPr>
              <p:nvPr/>
            </p:nvSpPr>
            <p:spPr bwMode="auto">
              <a:xfrm>
                <a:off x="10324043" y="5676949"/>
                <a:ext cx="18681" cy="0"/>
              </a:xfrm>
              <a:custGeom>
                <a:avLst/>
                <a:gdLst>
                  <a:gd name="T0" fmla="*/ 12 w 12"/>
                  <a:gd name="T1" fmla="*/ 12 w 12"/>
                  <a:gd name="T2" fmla="*/ 0 w 12"/>
                  <a:gd name="T3" fmla="*/ 0 w 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12">
                    <a:moveTo>
                      <a:pt x="12" y="0"/>
                    </a:moveTo>
                    <a:lnTo>
                      <a:pt x="12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64" name="Freeform 260"/>
              <p:cNvSpPr>
                <a:spLocks/>
              </p:cNvSpPr>
              <p:nvPr/>
            </p:nvSpPr>
            <p:spPr bwMode="auto">
              <a:xfrm>
                <a:off x="10342724" y="5676949"/>
                <a:ext cx="18681" cy="0"/>
              </a:xfrm>
              <a:custGeom>
                <a:avLst/>
                <a:gdLst>
                  <a:gd name="T0" fmla="*/ 12 w 12"/>
                  <a:gd name="T1" fmla="*/ 12 w 12"/>
                  <a:gd name="T2" fmla="*/ 0 w 12"/>
                  <a:gd name="T3" fmla="*/ 0 w 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12">
                    <a:moveTo>
                      <a:pt x="12" y="0"/>
                    </a:moveTo>
                    <a:lnTo>
                      <a:pt x="12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65" name="Freeform 261"/>
              <p:cNvSpPr>
                <a:spLocks/>
              </p:cNvSpPr>
              <p:nvPr/>
            </p:nvSpPr>
            <p:spPr bwMode="auto">
              <a:xfrm>
                <a:off x="10367631" y="5657549"/>
                <a:ext cx="18681" cy="19400"/>
              </a:xfrm>
              <a:custGeom>
                <a:avLst/>
                <a:gdLst>
                  <a:gd name="T0" fmla="*/ 0 w 12"/>
                  <a:gd name="T1" fmla="*/ 16 h 16"/>
                  <a:gd name="T2" fmla="*/ 4 w 12"/>
                  <a:gd name="T3" fmla="*/ 16 h 16"/>
                  <a:gd name="T4" fmla="*/ 4 w 12"/>
                  <a:gd name="T5" fmla="*/ 0 h 16"/>
                  <a:gd name="T6" fmla="*/ 8 w 12"/>
                  <a:gd name="T7" fmla="*/ 8 h 16"/>
                  <a:gd name="T8" fmla="*/ 8 w 12"/>
                  <a:gd name="T9" fmla="*/ 16 h 16"/>
                  <a:gd name="T10" fmla="*/ 8 w 12"/>
                  <a:gd name="T11" fmla="*/ 8 h 16"/>
                  <a:gd name="T12" fmla="*/ 12 w 12"/>
                  <a:gd name="T13" fmla="*/ 16 h 16"/>
                  <a:gd name="T14" fmla="*/ 12 w 12"/>
                  <a:gd name="T15" fmla="*/ 16 h 16"/>
                  <a:gd name="T16" fmla="*/ 0 w 12"/>
                  <a:gd name="T17" fmla="*/ 16 h 16"/>
                  <a:gd name="T18" fmla="*/ 0 w 12"/>
                  <a:gd name="T19" fmla="*/ 16 h 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12" h="16">
                    <a:moveTo>
                      <a:pt x="0" y="16"/>
                    </a:moveTo>
                    <a:lnTo>
                      <a:pt x="4" y="16"/>
                    </a:lnTo>
                    <a:lnTo>
                      <a:pt x="4" y="0"/>
                    </a:lnTo>
                    <a:lnTo>
                      <a:pt x="8" y="8"/>
                    </a:lnTo>
                    <a:lnTo>
                      <a:pt x="8" y="16"/>
                    </a:lnTo>
                    <a:lnTo>
                      <a:pt x="8" y="8"/>
                    </a:lnTo>
                    <a:lnTo>
                      <a:pt x="12" y="16"/>
                    </a:lnTo>
                    <a:lnTo>
                      <a:pt x="12" y="16"/>
                    </a:lnTo>
                    <a:lnTo>
                      <a:pt x="0" y="16"/>
                    </a:lnTo>
                    <a:lnTo>
                      <a:pt x="0" y="16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66" name="Freeform 262"/>
              <p:cNvSpPr>
                <a:spLocks/>
              </p:cNvSpPr>
              <p:nvPr/>
            </p:nvSpPr>
            <p:spPr bwMode="auto">
              <a:xfrm>
                <a:off x="10367631" y="5676949"/>
                <a:ext cx="18681" cy="0"/>
              </a:xfrm>
              <a:custGeom>
                <a:avLst/>
                <a:gdLst>
                  <a:gd name="T0" fmla="*/ 12 w 12"/>
                  <a:gd name="T1" fmla="*/ 12 w 12"/>
                  <a:gd name="T2" fmla="*/ 0 w 12"/>
                  <a:gd name="T3" fmla="*/ 0 w 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12">
                    <a:moveTo>
                      <a:pt x="12" y="0"/>
                    </a:moveTo>
                    <a:lnTo>
                      <a:pt x="12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67" name="Freeform 263"/>
              <p:cNvSpPr>
                <a:spLocks/>
              </p:cNvSpPr>
              <p:nvPr/>
            </p:nvSpPr>
            <p:spPr bwMode="auto">
              <a:xfrm>
                <a:off x="10386312" y="5662399"/>
                <a:ext cx="14010" cy="14550"/>
              </a:xfrm>
              <a:custGeom>
                <a:avLst/>
                <a:gdLst>
                  <a:gd name="T0" fmla="*/ 0 w 9"/>
                  <a:gd name="T1" fmla="*/ 12 h 12"/>
                  <a:gd name="T2" fmla="*/ 5 w 9"/>
                  <a:gd name="T3" fmla="*/ 12 h 12"/>
                  <a:gd name="T4" fmla="*/ 5 w 9"/>
                  <a:gd name="T5" fmla="*/ 0 h 12"/>
                  <a:gd name="T6" fmla="*/ 9 w 9"/>
                  <a:gd name="T7" fmla="*/ 4 h 12"/>
                  <a:gd name="T8" fmla="*/ 9 w 9"/>
                  <a:gd name="T9" fmla="*/ 12 h 12"/>
                  <a:gd name="T10" fmla="*/ 9 w 9"/>
                  <a:gd name="T11" fmla="*/ 4 h 12"/>
                  <a:gd name="T12" fmla="*/ 9 w 9"/>
                  <a:gd name="T13" fmla="*/ 12 h 12"/>
                  <a:gd name="T14" fmla="*/ 9 w 9"/>
                  <a:gd name="T15" fmla="*/ 12 h 12"/>
                  <a:gd name="T16" fmla="*/ 0 w 9"/>
                  <a:gd name="T17" fmla="*/ 12 h 12"/>
                  <a:gd name="T18" fmla="*/ 0 w 9"/>
                  <a:gd name="T19" fmla="*/ 12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9" h="12">
                    <a:moveTo>
                      <a:pt x="0" y="12"/>
                    </a:moveTo>
                    <a:lnTo>
                      <a:pt x="5" y="12"/>
                    </a:lnTo>
                    <a:lnTo>
                      <a:pt x="5" y="0"/>
                    </a:lnTo>
                    <a:lnTo>
                      <a:pt x="9" y="4"/>
                    </a:lnTo>
                    <a:lnTo>
                      <a:pt x="9" y="12"/>
                    </a:lnTo>
                    <a:lnTo>
                      <a:pt x="9" y="4"/>
                    </a:lnTo>
                    <a:lnTo>
                      <a:pt x="9" y="12"/>
                    </a:lnTo>
                    <a:lnTo>
                      <a:pt x="9" y="12"/>
                    </a:lnTo>
                    <a:lnTo>
                      <a:pt x="0" y="12"/>
                    </a:lnTo>
                    <a:lnTo>
                      <a:pt x="0" y="12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68" name="Freeform 264"/>
              <p:cNvSpPr>
                <a:spLocks/>
              </p:cNvSpPr>
              <p:nvPr/>
            </p:nvSpPr>
            <p:spPr bwMode="auto">
              <a:xfrm>
                <a:off x="10386312" y="5676949"/>
                <a:ext cx="14010" cy="0"/>
              </a:xfrm>
              <a:custGeom>
                <a:avLst/>
                <a:gdLst>
                  <a:gd name="T0" fmla="*/ 9 w 9"/>
                  <a:gd name="T1" fmla="*/ 9 w 9"/>
                  <a:gd name="T2" fmla="*/ 0 w 9"/>
                  <a:gd name="T3" fmla="*/ 0 w 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9">
                    <a:moveTo>
                      <a:pt x="9" y="0"/>
                    </a:moveTo>
                    <a:lnTo>
                      <a:pt x="9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69" name="Freeform 265"/>
              <p:cNvSpPr>
                <a:spLocks/>
              </p:cNvSpPr>
              <p:nvPr/>
            </p:nvSpPr>
            <p:spPr bwMode="auto">
              <a:xfrm>
                <a:off x="10406549" y="5662399"/>
                <a:ext cx="12454" cy="14550"/>
              </a:xfrm>
              <a:custGeom>
                <a:avLst/>
                <a:gdLst>
                  <a:gd name="T0" fmla="*/ 0 w 8"/>
                  <a:gd name="T1" fmla="*/ 12 h 12"/>
                  <a:gd name="T2" fmla="*/ 4 w 8"/>
                  <a:gd name="T3" fmla="*/ 12 h 12"/>
                  <a:gd name="T4" fmla="*/ 4 w 8"/>
                  <a:gd name="T5" fmla="*/ 0 h 12"/>
                  <a:gd name="T6" fmla="*/ 8 w 8"/>
                  <a:gd name="T7" fmla="*/ 4 h 12"/>
                  <a:gd name="T8" fmla="*/ 8 w 8"/>
                  <a:gd name="T9" fmla="*/ 12 h 12"/>
                  <a:gd name="T10" fmla="*/ 8 w 8"/>
                  <a:gd name="T11" fmla="*/ 4 h 12"/>
                  <a:gd name="T12" fmla="*/ 8 w 8"/>
                  <a:gd name="T13" fmla="*/ 12 h 12"/>
                  <a:gd name="T14" fmla="*/ 8 w 8"/>
                  <a:gd name="T15" fmla="*/ 12 h 12"/>
                  <a:gd name="T16" fmla="*/ 0 w 8"/>
                  <a:gd name="T17" fmla="*/ 12 h 12"/>
                  <a:gd name="T18" fmla="*/ 0 w 8"/>
                  <a:gd name="T19" fmla="*/ 12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8" h="12">
                    <a:moveTo>
                      <a:pt x="0" y="12"/>
                    </a:moveTo>
                    <a:lnTo>
                      <a:pt x="4" y="12"/>
                    </a:lnTo>
                    <a:lnTo>
                      <a:pt x="4" y="0"/>
                    </a:lnTo>
                    <a:lnTo>
                      <a:pt x="8" y="4"/>
                    </a:lnTo>
                    <a:lnTo>
                      <a:pt x="8" y="12"/>
                    </a:lnTo>
                    <a:lnTo>
                      <a:pt x="8" y="4"/>
                    </a:lnTo>
                    <a:lnTo>
                      <a:pt x="8" y="12"/>
                    </a:lnTo>
                    <a:lnTo>
                      <a:pt x="8" y="12"/>
                    </a:lnTo>
                    <a:lnTo>
                      <a:pt x="0" y="12"/>
                    </a:lnTo>
                    <a:lnTo>
                      <a:pt x="0" y="12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70" name="Freeform 266"/>
              <p:cNvSpPr>
                <a:spLocks/>
              </p:cNvSpPr>
              <p:nvPr/>
            </p:nvSpPr>
            <p:spPr bwMode="auto">
              <a:xfrm>
                <a:off x="10406549" y="5676949"/>
                <a:ext cx="12454" cy="0"/>
              </a:xfrm>
              <a:custGeom>
                <a:avLst/>
                <a:gdLst>
                  <a:gd name="T0" fmla="*/ 8 w 8"/>
                  <a:gd name="T1" fmla="*/ 8 w 8"/>
                  <a:gd name="T2" fmla="*/ 0 w 8"/>
                  <a:gd name="T3" fmla="*/ 0 w 8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8">
                    <a:moveTo>
                      <a:pt x="8" y="0"/>
                    </a:moveTo>
                    <a:lnTo>
                      <a:pt x="8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71" name="Freeform 267"/>
              <p:cNvSpPr>
                <a:spLocks/>
              </p:cNvSpPr>
              <p:nvPr/>
            </p:nvSpPr>
            <p:spPr bwMode="auto">
              <a:xfrm>
                <a:off x="10425230" y="5652699"/>
                <a:ext cx="18681" cy="24250"/>
              </a:xfrm>
              <a:custGeom>
                <a:avLst/>
                <a:gdLst>
                  <a:gd name="T0" fmla="*/ 0 w 12"/>
                  <a:gd name="T1" fmla="*/ 20 h 20"/>
                  <a:gd name="T2" fmla="*/ 4 w 12"/>
                  <a:gd name="T3" fmla="*/ 20 h 20"/>
                  <a:gd name="T4" fmla="*/ 4 w 12"/>
                  <a:gd name="T5" fmla="*/ 0 h 20"/>
                  <a:gd name="T6" fmla="*/ 8 w 12"/>
                  <a:gd name="T7" fmla="*/ 4 h 20"/>
                  <a:gd name="T8" fmla="*/ 8 w 12"/>
                  <a:gd name="T9" fmla="*/ 20 h 20"/>
                  <a:gd name="T10" fmla="*/ 8 w 12"/>
                  <a:gd name="T11" fmla="*/ 4 h 20"/>
                  <a:gd name="T12" fmla="*/ 8 w 12"/>
                  <a:gd name="T13" fmla="*/ 20 h 20"/>
                  <a:gd name="T14" fmla="*/ 12 w 12"/>
                  <a:gd name="T15" fmla="*/ 20 h 20"/>
                  <a:gd name="T16" fmla="*/ 12 w 12"/>
                  <a:gd name="T17" fmla="*/ 20 h 20"/>
                  <a:gd name="T18" fmla="*/ 0 w 12"/>
                  <a:gd name="T19" fmla="*/ 20 h 20"/>
                  <a:gd name="T20" fmla="*/ 0 w 12"/>
                  <a:gd name="T21" fmla="*/ 20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12" h="20">
                    <a:moveTo>
                      <a:pt x="0" y="20"/>
                    </a:moveTo>
                    <a:lnTo>
                      <a:pt x="4" y="20"/>
                    </a:lnTo>
                    <a:lnTo>
                      <a:pt x="4" y="0"/>
                    </a:lnTo>
                    <a:lnTo>
                      <a:pt x="8" y="4"/>
                    </a:lnTo>
                    <a:lnTo>
                      <a:pt x="8" y="20"/>
                    </a:lnTo>
                    <a:lnTo>
                      <a:pt x="8" y="4"/>
                    </a:lnTo>
                    <a:lnTo>
                      <a:pt x="8" y="20"/>
                    </a:lnTo>
                    <a:lnTo>
                      <a:pt x="12" y="20"/>
                    </a:lnTo>
                    <a:lnTo>
                      <a:pt x="12" y="20"/>
                    </a:lnTo>
                    <a:lnTo>
                      <a:pt x="0" y="20"/>
                    </a:lnTo>
                    <a:lnTo>
                      <a:pt x="0" y="20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72" name="Freeform 268"/>
              <p:cNvSpPr>
                <a:spLocks/>
              </p:cNvSpPr>
              <p:nvPr/>
            </p:nvSpPr>
            <p:spPr bwMode="auto">
              <a:xfrm>
                <a:off x="10425230" y="5676949"/>
                <a:ext cx="18681" cy="0"/>
              </a:xfrm>
              <a:custGeom>
                <a:avLst/>
                <a:gdLst>
                  <a:gd name="T0" fmla="*/ 12 w 12"/>
                  <a:gd name="T1" fmla="*/ 12 w 12"/>
                  <a:gd name="T2" fmla="*/ 0 w 12"/>
                  <a:gd name="T3" fmla="*/ 0 w 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12">
                    <a:moveTo>
                      <a:pt x="12" y="0"/>
                    </a:moveTo>
                    <a:lnTo>
                      <a:pt x="12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73" name="Freeform 269"/>
              <p:cNvSpPr>
                <a:spLocks/>
              </p:cNvSpPr>
              <p:nvPr/>
            </p:nvSpPr>
            <p:spPr bwMode="auto">
              <a:xfrm>
                <a:off x="10443911" y="5647850"/>
                <a:ext cx="18681" cy="29100"/>
              </a:xfrm>
              <a:custGeom>
                <a:avLst/>
                <a:gdLst>
                  <a:gd name="T0" fmla="*/ 0 w 12"/>
                  <a:gd name="T1" fmla="*/ 24 h 24"/>
                  <a:gd name="T2" fmla="*/ 4 w 12"/>
                  <a:gd name="T3" fmla="*/ 24 h 24"/>
                  <a:gd name="T4" fmla="*/ 4 w 12"/>
                  <a:gd name="T5" fmla="*/ 4 h 24"/>
                  <a:gd name="T6" fmla="*/ 8 w 12"/>
                  <a:gd name="T7" fmla="*/ 0 h 24"/>
                  <a:gd name="T8" fmla="*/ 8 w 12"/>
                  <a:gd name="T9" fmla="*/ 24 h 24"/>
                  <a:gd name="T10" fmla="*/ 8 w 12"/>
                  <a:gd name="T11" fmla="*/ 0 h 24"/>
                  <a:gd name="T12" fmla="*/ 8 w 12"/>
                  <a:gd name="T13" fmla="*/ 24 h 24"/>
                  <a:gd name="T14" fmla="*/ 12 w 12"/>
                  <a:gd name="T15" fmla="*/ 24 h 24"/>
                  <a:gd name="T16" fmla="*/ 12 w 12"/>
                  <a:gd name="T17" fmla="*/ 24 h 24"/>
                  <a:gd name="T18" fmla="*/ 0 w 12"/>
                  <a:gd name="T19" fmla="*/ 24 h 24"/>
                  <a:gd name="T20" fmla="*/ 0 w 12"/>
                  <a:gd name="T21" fmla="*/ 24 h 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12" h="24">
                    <a:moveTo>
                      <a:pt x="0" y="24"/>
                    </a:moveTo>
                    <a:lnTo>
                      <a:pt x="4" y="24"/>
                    </a:lnTo>
                    <a:lnTo>
                      <a:pt x="4" y="4"/>
                    </a:lnTo>
                    <a:lnTo>
                      <a:pt x="8" y="0"/>
                    </a:lnTo>
                    <a:lnTo>
                      <a:pt x="8" y="24"/>
                    </a:lnTo>
                    <a:lnTo>
                      <a:pt x="8" y="0"/>
                    </a:lnTo>
                    <a:lnTo>
                      <a:pt x="8" y="24"/>
                    </a:lnTo>
                    <a:lnTo>
                      <a:pt x="12" y="24"/>
                    </a:lnTo>
                    <a:lnTo>
                      <a:pt x="12" y="24"/>
                    </a:lnTo>
                    <a:lnTo>
                      <a:pt x="0" y="24"/>
                    </a:lnTo>
                    <a:lnTo>
                      <a:pt x="0" y="24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74" name="Freeform 270"/>
              <p:cNvSpPr>
                <a:spLocks/>
              </p:cNvSpPr>
              <p:nvPr/>
            </p:nvSpPr>
            <p:spPr bwMode="auto">
              <a:xfrm>
                <a:off x="10443911" y="5676949"/>
                <a:ext cx="18681" cy="0"/>
              </a:xfrm>
              <a:custGeom>
                <a:avLst/>
                <a:gdLst>
                  <a:gd name="T0" fmla="*/ 12 w 12"/>
                  <a:gd name="T1" fmla="*/ 12 w 12"/>
                  <a:gd name="T2" fmla="*/ 0 w 12"/>
                  <a:gd name="T3" fmla="*/ 0 w 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12">
                    <a:moveTo>
                      <a:pt x="12" y="0"/>
                    </a:moveTo>
                    <a:lnTo>
                      <a:pt x="12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75" name="Freeform 271"/>
              <p:cNvSpPr>
                <a:spLocks/>
              </p:cNvSpPr>
              <p:nvPr/>
            </p:nvSpPr>
            <p:spPr bwMode="auto">
              <a:xfrm>
                <a:off x="10462591" y="5672099"/>
                <a:ext cx="18681" cy="4850"/>
              </a:xfrm>
              <a:custGeom>
                <a:avLst/>
                <a:gdLst>
                  <a:gd name="T0" fmla="*/ 0 w 12"/>
                  <a:gd name="T1" fmla="*/ 4 h 4"/>
                  <a:gd name="T2" fmla="*/ 4 w 12"/>
                  <a:gd name="T3" fmla="*/ 4 h 4"/>
                  <a:gd name="T4" fmla="*/ 8 w 12"/>
                  <a:gd name="T5" fmla="*/ 0 h 4"/>
                  <a:gd name="T6" fmla="*/ 8 w 12"/>
                  <a:gd name="T7" fmla="*/ 4 h 4"/>
                  <a:gd name="T8" fmla="*/ 8 w 12"/>
                  <a:gd name="T9" fmla="*/ 0 h 4"/>
                  <a:gd name="T10" fmla="*/ 12 w 12"/>
                  <a:gd name="T11" fmla="*/ 4 h 4"/>
                  <a:gd name="T12" fmla="*/ 12 w 12"/>
                  <a:gd name="T13" fmla="*/ 4 h 4"/>
                  <a:gd name="T14" fmla="*/ 0 w 12"/>
                  <a:gd name="T15" fmla="*/ 4 h 4"/>
                  <a:gd name="T16" fmla="*/ 0 w 12"/>
                  <a:gd name="T17" fmla="*/ 4 h 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12" h="4">
                    <a:moveTo>
                      <a:pt x="0" y="4"/>
                    </a:moveTo>
                    <a:lnTo>
                      <a:pt x="4" y="4"/>
                    </a:lnTo>
                    <a:lnTo>
                      <a:pt x="8" y="0"/>
                    </a:lnTo>
                    <a:lnTo>
                      <a:pt x="8" y="4"/>
                    </a:lnTo>
                    <a:lnTo>
                      <a:pt x="8" y="0"/>
                    </a:lnTo>
                    <a:lnTo>
                      <a:pt x="12" y="4"/>
                    </a:lnTo>
                    <a:lnTo>
                      <a:pt x="12" y="4"/>
                    </a:lnTo>
                    <a:lnTo>
                      <a:pt x="0" y="4"/>
                    </a:lnTo>
                    <a:lnTo>
                      <a:pt x="0" y="4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76" name="Freeform 272"/>
              <p:cNvSpPr>
                <a:spLocks/>
              </p:cNvSpPr>
              <p:nvPr/>
            </p:nvSpPr>
            <p:spPr bwMode="auto">
              <a:xfrm>
                <a:off x="10462591" y="5676949"/>
                <a:ext cx="18681" cy="0"/>
              </a:xfrm>
              <a:custGeom>
                <a:avLst/>
                <a:gdLst>
                  <a:gd name="T0" fmla="*/ 12 w 12"/>
                  <a:gd name="T1" fmla="*/ 12 w 12"/>
                  <a:gd name="T2" fmla="*/ 0 w 12"/>
                  <a:gd name="T3" fmla="*/ 0 w 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12">
                    <a:moveTo>
                      <a:pt x="12" y="0"/>
                    </a:moveTo>
                    <a:lnTo>
                      <a:pt x="12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77" name="Freeform 273"/>
              <p:cNvSpPr>
                <a:spLocks/>
              </p:cNvSpPr>
              <p:nvPr/>
            </p:nvSpPr>
            <p:spPr bwMode="auto">
              <a:xfrm>
                <a:off x="10481272" y="5652699"/>
                <a:ext cx="20237" cy="24250"/>
              </a:xfrm>
              <a:custGeom>
                <a:avLst/>
                <a:gdLst>
                  <a:gd name="T0" fmla="*/ 0 w 13"/>
                  <a:gd name="T1" fmla="*/ 20 h 20"/>
                  <a:gd name="T2" fmla="*/ 5 w 13"/>
                  <a:gd name="T3" fmla="*/ 20 h 20"/>
                  <a:gd name="T4" fmla="*/ 5 w 13"/>
                  <a:gd name="T5" fmla="*/ 4 h 20"/>
                  <a:gd name="T6" fmla="*/ 9 w 13"/>
                  <a:gd name="T7" fmla="*/ 0 h 20"/>
                  <a:gd name="T8" fmla="*/ 9 w 13"/>
                  <a:gd name="T9" fmla="*/ 20 h 20"/>
                  <a:gd name="T10" fmla="*/ 9 w 13"/>
                  <a:gd name="T11" fmla="*/ 0 h 20"/>
                  <a:gd name="T12" fmla="*/ 9 w 13"/>
                  <a:gd name="T13" fmla="*/ 20 h 20"/>
                  <a:gd name="T14" fmla="*/ 13 w 13"/>
                  <a:gd name="T15" fmla="*/ 20 h 20"/>
                  <a:gd name="T16" fmla="*/ 13 w 13"/>
                  <a:gd name="T17" fmla="*/ 20 h 20"/>
                  <a:gd name="T18" fmla="*/ 0 w 13"/>
                  <a:gd name="T19" fmla="*/ 20 h 20"/>
                  <a:gd name="T20" fmla="*/ 0 w 13"/>
                  <a:gd name="T21" fmla="*/ 20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13" h="20">
                    <a:moveTo>
                      <a:pt x="0" y="20"/>
                    </a:moveTo>
                    <a:lnTo>
                      <a:pt x="5" y="20"/>
                    </a:lnTo>
                    <a:lnTo>
                      <a:pt x="5" y="4"/>
                    </a:lnTo>
                    <a:lnTo>
                      <a:pt x="9" y="0"/>
                    </a:lnTo>
                    <a:lnTo>
                      <a:pt x="9" y="20"/>
                    </a:lnTo>
                    <a:lnTo>
                      <a:pt x="9" y="0"/>
                    </a:lnTo>
                    <a:lnTo>
                      <a:pt x="9" y="20"/>
                    </a:lnTo>
                    <a:lnTo>
                      <a:pt x="13" y="20"/>
                    </a:lnTo>
                    <a:lnTo>
                      <a:pt x="13" y="20"/>
                    </a:lnTo>
                    <a:lnTo>
                      <a:pt x="0" y="20"/>
                    </a:lnTo>
                    <a:lnTo>
                      <a:pt x="0" y="20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78" name="Freeform 274"/>
              <p:cNvSpPr>
                <a:spLocks/>
              </p:cNvSpPr>
              <p:nvPr/>
            </p:nvSpPr>
            <p:spPr bwMode="auto">
              <a:xfrm>
                <a:off x="10481272" y="5676949"/>
                <a:ext cx="20237" cy="0"/>
              </a:xfrm>
              <a:custGeom>
                <a:avLst/>
                <a:gdLst>
                  <a:gd name="T0" fmla="*/ 13 w 13"/>
                  <a:gd name="T1" fmla="*/ 13 w 13"/>
                  <a:gd name="T2" fmla="*/ 0 w 13"/>
                  <a:gd name="T3" fmla="*/ 0 w 13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13">
                    <a:moveTo>
                      <a:pt x="13" y="0"/>
                    </a:moveTo>
                    <a:lnTo>
                      <a:pt x="13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79" name="Freeform 275"/>
              <p:cNvSpPr>
                <a:spLocks/>
              </p:cNvSpPr>
              <p:nvPr/>
            </p:nvSpPr>
            <p:spPr bwMode="auto">
              <a:xfrm>
                <a:off x="10507736" y="5667249"/>
                <a:ext cx="12454" cy="9700"/>
              </a:xfrm>
              <a:custGeom>
                <a:avLst/>
                <a:gdLst>
                  <a:gd name="T0" fmla="*/ 0 w 8"/>
                  <a:gd name="T1" fmla="*/ 8 h 8"/>
                  <a:gd name="T2" fmla="*/ 4 w 8"/>
                  <a:gd name="T3" fmla="*/ 8 h 8"/>
                  <a:gd name="T4" fmla="*/ 4 w 8"/>
                  <a:gd name="T5" fmla="*/ 0 h 8"/>
                  <a:gd name="T6" fmla="*/ 8 w 8"/>
                  <a:gd name="T7" fmla="*/ 8 h 8"/>
                  <a:gd name="T8" fmla="*/ 8 w 8"/>
                  <a:gd name="T9" fmla="*/ 8 h 8"/>
                  <a:gd name="T10" fmla="*/ 0 w 8"/>
                  <a:gd name="T11" fmla="*/ 8 h 8"/>
                  <a:gd name="T12" fmla="*/ 0 w 8"/>
                  <a:gd name="T13" fmla="*/ 8 h 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8" h="8">
                    <a:moveTo>
                      <a:pt x="0" y="8"/>
                    </a:moveTo>
                    <a:lnTo>
                      <a:pt x="4" y="8"/>
                    </a:lnTo>
                    <a:lnTo>
                      <a:pt x="4" y="0"/>
                    </a:lnTo>
                    <a:lnTo>
                      <a:pt x="8" y="8"/>
                    </a:lnTo>
                    <a:lnTo>
                      <a:pt x="8" y="8"/>
                    </a:lnTo>
                    <a:lnTo>
                      <a:pt x="0" y="8"/>
                    </a:lnTo>
                    <a:lnTo>
                      <a:pt x="0" y="8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80" name="Freeform 276"/>
              <p:cNvSpPr>
                <a:spLocks/>
              </p:cNvSpPr>
              <p:nvPr/>
            </p:nvSpPr>
            <p:spPr bwMode="auto">
              <a:xfrm>
                <a:off x="10507736" y="5676949"/>
                <a:ext cx="12454" cy="0"/>
              </a:xfrm>
              <a:custGeom>
                <a:avLst/>
                <a:gdLst>
                  <a:gd name="T0" fmla="*/ 8 w 8"/>
                  <a:gd name="T1" fmla="*/ 8 w 8"/>
                  <a:gd name="T2" fmla="*/ 0 w 8"/>
                  <a:gd name="T3" fmla="*/ 0 w 8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8">
                    <a:moveTo>
                      <a:pt x="8" y="0"/>
                    </a:moveTo>
                    <a:lnTo>
                      <a:pt x="8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81" name="Freeform 277"/>
              <p:cNvSpPr>
                <a:spLocks/>
              </p:cNvSpPr>
              <p:nvPr/>
            </p:nvSpPr>
            <p:spPr bwMode="auto">
              <a:xfrm>
                <a:off x="10520190" y="5657549"/>
                <a:ext cx="18681" cy="19400"/>
              </a:xfrm>
              <a:custGeom>
                <a:avLst/>
                <a:gdLst>
                  <a:gd name="T0" fmla="*/ 0 w 12"/>
                  <a:gd name="T1" fmla="*/ 16 h 16"/>
                  <a:gd name="T2" fmla="*/ 4 w 12"/>
                  <a:gd name="T3" fmla="*/ 16 h 16"/>
                  <a:gd name="T4" fmla="*/ 4 w 12"/>
                  <a:gd name="T5" fmla="*/ 12 h 16"/>
                  <a:gd name="T6" fmla="*/ 8 w 12"/>
                  <a:gd name="T7" fmla="*/ 4 h 16"/>
                  <a:gd name="T8" fmla="*/ 8 w 12"/>
                  <a:gd name="T9" fmla="*/ 12 h 16"/>
                  <a:gd name="T10" fmla="*/ 8 w 12"/>
                  <a:gd name="T11" fmla="*/ 0 h 16"/>
                  <a:gd name="T12" fmla="*/ 8 w 12"/>
                  <a:gd name="T13" fmla="*/ 12 h 16"/>
                  <a:gd name="T14" fmla="*/ 12 w 12"/>
                  <a:gd name="T15" fmla="*/ 16 h 16"/>
                  <a:gd name="T16" fmla="*/ 12 w 12"/>
                  <a:gd name="T17" fmla="*/ 16 h 16"/>
                  <a:gd name="T18" fmla="*/ 0 w 12"/>
                  <a:gd name="T19" fmla="*/ 16 h 16"/>
                  <a:gd name="T20" fmla="*/ 0 w 12"/>
                  <a:gd name="T21" fmla="*/ 16 h 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12" h="16">
                    <a:moveTo>
                      <a:pt x="0" y="16"/>
                    </a:moveTo>
                    <a:lnTo>
                      <a:pt x="4" y="16"/>
                    </a:lnTo>
                    <a:lnTo>
                      <a:pt x="4" y="12"/>
                    </a:lnTo>
                    <a:lnTo>
                      <a:pt x="8" y="4"/>
                    </a:lnTo>
                    <a:lnTo>
                      <a:pt x="8" y="12"/>
                    </a:lnTo>
                    <a:lnTo>
                      <a:pt x="8" y="0"/>
                    </a:lnTo>
                    <a:lnTo>
                      <a:pt x="8" y="12"/>
                    </a:lnTo>
                    <a:lnTo>
                      <a:pt x="12" y="16"/>
                    </a:lnTo>
                    <a:lnTo>
                      <a:pt x="12" y="16"/>
                    </a:lnTo>
                    <a:lnTo>
                      <a:pt x="0" y="16"/>
                    </a:lnTo>
                    <a:lnTo>
                      <a:pt x="0" y="16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82" name="Freeform 278"/>
              <p:cNvSpPr>
                <a:spLocks/>
              </p:cNvSpPr>
              <p:nvPr/>
            </p:nvSpPr>
            <p:spPr bwMode="auto">
              <a:xfrm>
                <a:off x="10520190" y="5676949"/>
                <a:ext cx="18681" cy="0"/>
              </a:xfrm>
              <a:custGeom>
                <a:avLst/>
                <a:gdLst>
                  <a:gd name="T0" fmla="*/ 12 w 12"/>
                  <a:gd name="T1" fmla="*/ 12 w 12"/>
                  <a:gd name="T2" fmla="*/ 0 w 12"/>
                  <a:gd name="T3" fmla="*/ 0 w 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12">
                    <a:moveTo>
                      <a:pt x="12" y="0"/>
                    </a:moveTo>
                    <a:lnTo>
                      <a:pt x="12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83" name="Freeform 279"/>
              <p:cNvSpPr>
                <a:spLocks/>
              </p:cNvSpPr>
              <p:nvPr/>
            </p:nvSpPr>
            <p:spPr bwMode="auto">
              <a:xfrm>
                <a:off x="10538870" y="5672099"/>
                <a:ext cx="18681" cy="4850"/>
              </a:xfrm>
              <a:custGeom>
                <a:avLst/>
                <a:gdLst>
                  <a:gd name="T0" fmla="*/ 0 w 12"/>
                  <a:gd name="T1" fmla="*/ 4 h 4"/>
                  <a:gd name="T2" fmla="*/ 4 w 12"/>
                  <a:gd name="T3" fmla="*/ 4 h 4"/>
                  <a:gd name="T4" fmla="*/ 8 w 12"/>
                  <a:gd name="T5" fmla="*/ 0 h 4"/>
                  <a:gd name="T6" fmla="*/ 8 w 12"/>
                  <a:gd name="T7" fmla="*/ 4 h 4"/>
                  <a:gd name="T8" fmla="*/ 8 w 12"/>
                  <a:gd name="T9" fmla="*/ 0 h 4"/>
                  <a:gd name="T10" fmla="*/ 12 w 12"/>
                  <a:gd name="T11" fmla="*/ 4 h 4"/>
                  <a:gd name="T12" fmla="*/ 12 w 12"/>
                  <a:gd name="T13" fmla="*/ 4 h 4"/>
                  <a:gd name="T14" fmla="*/ 0 w 12"/>
                  <a:gd name="T15" fmla="*/ 4 h 4"/>
                  <a:gd name="T16" fmla="*/ 0 w 12"/>
                  <a:gd name="T17" fmla="*/ 4 h 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12" h="4">
                    <a:moveTo>
                      <a:pt x="0" y="4"/>
                    </a:moveTo>
                    <a:lnTo>
                      <a:pt x="4" y="4"/>
                    </a:lnTo>
                    <a:lnTo>
                      <a:pt x="8" y="0"/>
                    </a:lnTo>
                    <a:lnTo>
                      <a:pt x="8" y="4"/>
                    </a:lnTo>
                    <a:lnTo>
                      <a:pt x="8" y="0"/>
                    </a:lnTo>
                    <a:lnTo>
                      <a:pt x="12" y="4"/>
                    </a:lnTo>
                    <a:lnTo>
                      <a:pt x="12" y="4"/>
                    </a:lnTo>
                    <a:lnTo>
                      <a:pt x="0" y="4"/>
                    </a:lnTo>
                    <a:lnTo>
                      <a:pt x="0" y="4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84" name="Freeform 280"/>
              <p:cNvSpPr>
                <a:spLocks/>
              </p:cNvSpPr>
              <p:nvPr/>
            </p:nvSpPr>
            <p:spPr bwMode="auto">
              <a:xfrm>
                <a:off x="10538870" y="5676949"/>
                <a:ext cx="18681" cy="0"/>
              </a:xfrm>
              <a:custGeom>
                <a:avLst/>
                <a:gdLst>
                  <a:gd name="T0" fmla="*/ 12 w 12"/>
                  <a:gd name="T1" fmla="*/ 12 w 12"/>
                  <a:gd name="T2" fmla="*/ 0 w 12"/>
                  <a:gd name="T3" fmla="*/ 0 w 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12">
                    <a:moveTo>
                      <a:pt x="12" y="0"/>
                    </a:moveTo>
                    <a:lnTo>
                      <a:pt x="12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85" name="Freeform 281"/>
              <p:cNvSpPr>
                <a:spLocks/>
              </p:cNvSpPr>
              <p:nvPr/>
            </p:nvSpPr>
            <p:spPr bwMode="auto">
              <a:xfrm>
                <a:off x="10557551" y="5657549"/>
                <a:ext cx="18681" cy="19400"/>
              </a:xfrm>
              <a:custGeom>
                <a:avLst/>
                <a:gdLst>
                  <a:gd name="T0" fmla="*/ 0 w 12"/>
                  <a:gd name="T1" fmla="*/ 16 h 16"/>
                  <a:gd name="T2" fmla="*/ 4 w 12"/>
                  <a:gd name="T3" fmla="*/ 16 h 16"/>
                  <a:gd name="T4" fmla="*/ 4 w 12"/>
                  <a:gd name="T5" fmla="*/ 12 h 16"/>
                  <a:gd name="T6" fmla="*/ 8 w 12"/>
                  <a:gd name="T7" fmla="*/ 8 h 16"/>
                  <a:gd name="T8" fmla="*/ 8 w 12"/>
                  <a:gd name="T9" fmla="*/ 16 h 16"/>
                  <a:gd name="T10" fmla="*/ 8 w 12"/>
                  <a:gd name="T11" fmla="*/ 0 h 16"/>
                  <a:gd name="T12" fmla="*/ 12 w 12"/>
                  <a:gd name="T13" fmla="*/ 16 h 16"/>
                  <a:gd name="T14" fmla="*/ 12 w 12"/>
                  <a:gd name="T15" fmla="*/ 16 h 16"/>
                  <a:gd name="T16" fmla="*/ 0 w 12"/>
                  <a:gd name="T17" fmla="*/ 16 h 16"/>
                  <a:gd name="T18" fmla="*/ 0 w 12"/>
                  <a:gd name="T19" fmla="*/ 16 h 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12" h="16">
                    <a:moveTo>
                      <a:pt x="0" y="16"/>
                    </a:moveTo>
                    <a:lnTo>
                      <a:pt x="4" y="16"/>
                    </a:lnTo>
                    <a:lnTo>
                      <a:pt x="4" y="12"/>
                    </a:lnTo>
                    <a:lnTo>
                      <a:pt x="8" y="8"/>
                    </a:lnTo>
                    <a:lnTo>
                      <a:pt x="8" y="16"/>
                    </a:lnTo>
                    <a:lnTo>
                      <a:pt x="8" y="0"/>
                    </a:lnTo>
                    <a:lnTo>
                      <a:pt x="12" y="16"/>
                    </a:lnTo>
                    <a:lnTo>
                      <a:pt x="12" y="16"/>
                    </a:lnTo>
                    <a:lnTo>
                      <a:pt x="0" y="16"/>
                    </a:lnTo>
                    <a:lnTo>
                      <a:pt x="0" y="16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86" name="Freeform 282"/>
              <p:cNvSpPr>
                <a:spLocks/>
              </p:cNvSpPr>
              <p:nvPr/>
            </p:nvSpPr>
            <p:spPr bwMode="auto">
              <a:xfrm>
                <a:off x="10557551" y="5676949"/>
                <a:ext cx="18681" cy="0"/>
              </a:xfrm>
              <a:custGeom>
                <a:avLst/>
                <a:gdLst>
                  <a:gd name="T0" fmla="*/ 12 w 12"/>
                  <a:gd name="T1" fmla="*/ 12 w 12"/>
                  <a:gd name="T2" fmla="*/ 0 w 12"/>
                  <a:gd name="T3" fmla="*/ 0 w 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12">
                    <a:moveTo>
                      <a:pt x="12" y="0"/>
                    </a:moveTo>
                    <a:lnTo>
                      <a:pt x="12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87" name="Freeform 283"/>
              <p:cNvSpPr>
                <a:spLocks/>
              </p:cNvSpPr>
              <p:nvPr/>
            </p:nvSpPr>
            <p:spPr bwMode="auto">
              <a:xfrm>
                <a:off x="10584015" y="5672099"/>
                <a:ext cx="12454" cy="4850"/>
              </a:xfrm>
              <a:custGeom>
                <a:avLst/>
                <a:gdLst>
                  <a:gd name="T0" fmla="*/ 0 w 8"/>
                  <a:gd name="T1" fmla="*/ 4 h 4"/>
                  <a:gd name="T2" fmla="*/ 4 w 8"/>
                  <a:gd name="T3" fmla="*/ 4 h 4"/>
                  <a:gd name="T4" fmla="*/ 4 w 8"/>
                  <a:gd name="T5" fmla="*/ 0 h 4"/>
                  <a:gd name="T6" fmla="*/ 8 w 8"/>
                  <a:gd name="T7" fmla="*/ 4 h 4"/>
                  <a:gd name="T8" fmla="*/ 8 w 8"/>
                  <a:gd name="T9" fmla="*/ 4 h 4"/>
                  <a:gd name="T10" fmla="*/ 0 w 8"/>
                  <a:gd name="T11" fmla="*/ 4 h 4"/>
                  <a:gd name="T12" fmla="*/ 0 w 8"/>
                  <a:gd name="T13" fmla="*/ 4 h 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8" h="4">
                    <a:moveTo>
                      <a:pt x="0" y="4"/>
                    </a:moveTo>
                    <a:lnTo>
                      <a:pt x="4" y="4"/>
                    </a:lnTo>
                    <a:lnTo>
                      <a:pt x="4" y="0"/>
                    </a:lnTo>
                    <a:lnTo>
                      <a:pt x="8" y="4"/>
                    </a:lnTo>
                    <a:lnTo>
                      <a:pt x="8" y="4"/>
                    </a:lnTo>
                    <a:lnTo>
                      <a:pt x="0" y="4"/>
                    </a:lnTo>
                    <a:lnTo>
                      <a:pt x="0" y="4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88" name="Freeform 284"/>
              <p:cNvSpPr>
                <a:spLocks/>
              </p:cNvSpPr>
              <p:nvPr/>
            </p:nvSpPr>
            <p:spPr bwMode="auto">
              <a:xfrm>
                <a:off x="10584015" y="5676949"/>
                <a:ext cx="12454" cy="0"/>
              </a:xfrm>
              <a:custGeom>
                <a:avLst/>
                <a:gdLst>
                  <a:gd name="T0" fmla="*/ 8 w 8"/>
                  <a:gd name="T1" fmla="*/ 8 w 8"/>
                  <a:gd name="T2" fmla="*/ 0 w 8"/>
                  <a:gd name="T3" fmla="*/ 0 w 8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8">
                    <a:moveTo>
                      <a:pt x="8" y="0"/>
                    </a:moveTo>
                    <a:lnTo>
                      <a:pt x="8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89" name="Freeform 285"/>
              <p:cNvSpPr>
                <a:spLocks/>
              </p:cNvSpPr>
              <p:nvPr/>
            </p:nvSpPr>
            <p:spPr bwMode="auto">
              <a:xfrm>
                <a:off x="10602696" y="5672099"/>
                <a:ext cx="12454" cy="4850"/>
              </a:xfrm>
              <a:custGeom>
                <a:avLst/>
                <a:gdLst>
                  <a:gd name="T0" fmla="*/ 0 w 8"/>
                  <a:gd name="T1" fmla="*/ 4 h 4"/>
                  <a:gd name="T2" fmla="*/ 4 w 8"/>
                  <a:gd name="T3" fmla="*/ 4 h 4"/>
                  <a:gd name="T4" fmla="*/ 4 w 8"/>
                  <a:gd name="T5" fmla="*/ 0 h 4"/>
                  <a:gd name="T6" fmla="*/ 8 w 8"/>
                  <a:gd name="T7" fmla="*/ 4 h 4"/>
                  <a:gd name="T8" fmla="*/ 8 w 8"/>
                  <a:gd name="T9" fmla="*/ 4 h 4"/>
                  <a:gd name="T10" fmla="*/ 0 w 8"/>
                  <a:gd name="T11" fmla="*/ 4 h 4"/>
                  <a:gd name="T12" fmla="*/ 0 w 8"/>
                  <a:gd name="T13" fmla="*/ 4 h 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8" h="4">
                    <a:moveTo>
                      <a:pt x="0" y="4"/>
                    </a:moveTo>
                    <a:lnTo>
                      <a:pt x="4" y="4"/>
                    </a:lnTo>
                    <a:lnTo>
                      <a:pt x="4" y="0"/>
                    </a:lnTo>
                    <a:lnTo>
                      <a:pt x="8" y="4"/>
                    </a:lnTo>
                    <a:lnTo>
                      <a:pt x="8" y="4"/>
                    </a:lnTo>
                    <a:lnTo>
                      <a:pt x="0" y="4"/>
                    </a:lnTo>
                    <a:lnTo>
                      <a:pt x="0" y="4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90" name="Freeform 286"/>
              <p:cNvSpPr>
                <a:spLocks/>
              </p:cNvSpPr>
              <p:nvPr/>
            </p:nvSpPr>
            <p:spPr bwMode="auto">
              <a:xfrm>
                <a:off x="10602696" y="5676949"/>
                <a:ext cx="12454" cy="0"/>
              </a:xfrm>
              <a:custGeom>
                <a:avLst/>
                <a:gdLst>
                  <a:gd name="T0" fmla="*/ 8 w 8"/>
                  <a:gd name="T1" fmla="*/ 8 w 8"/>
                  <a:gd name="T2" fmla="*/ 0 w 8"/>
                  <a:gd name="T3" fmla="*/ 0 w 8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8">
                    <a:moveTo>
                      <a:pt x="8" y="0"/>
                    </a:moveTo>
                    <a:lnTo>
                      <a:pt x="8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91" name="Freeform 287"/>
              <p:cNvSpPr>
                <a:spLocks/>
              </p:cNvSpPr>
              <p:nvPr/>
            </p:nvSpPr>
            <p:spPr bwMode="auto">
              <a:xfrm>
                <a:off x="10633830" y="5647850"/>
                <a:ext cx="24907" cy="29100"/>
              </a:xfrm>
              <a:custGeom>
                <a:avLst/>
                <a:gdLst>
                  <a:gd name="T0" fmla="*/ 0 w 16"/>
                  <a:gd name="T1" fmla="*/ 24 h 24"/>
                  <a:gd name="T2" fmla="*/ 4 w 16"/>
                  <a:gd name="T3" fmla="*/ 24 h 24"/>
                  <a:gd name="T4" fmla="*/ 8 w 16"/>
                  <a:gd name="T5" fmla="*/ 24 h 24"/>
                  <a:gd name="T6" fmla="*/ 8 w 16"/>
                  <a:gd name="T7" fmla="*/ 0 h 24"/>
                  <a:gd name="T8" fmla="*/ 12 w 16"/>
                  <a:gd name="T9" fmla="*/ 4 h 24"/>
                  <a:gd name="T10" fmla="*/ 12 w 16"/>
                  <a:gd name="T11" fmla="*/ 24 h 24"/>
                  <a:gd name="T12" fmla="*/ 12 w 16"/>
                  <a:gd name="T13" fmla="*/ 4 h 24"/>
                  <a:gd name="T14" fmla="*/ 12 w 16"/>
                  <a:gd name="T15" fmla="*/ 24 h 24"/>
                  <a:gd name="T16" fmla="*/ 16 w 16"/>
                  <a:gd name="T17" fmla="*/ 24 h 24"/>
                  <a:gd name="T18" fmla="*/ 16 w 16"/>
                  <a:gd name="T19" fmla="*/ 24 h 24"/>
                  <a:gd name="T20" fmla="*/ 0 w 16"/>
                  <a:gd name="T21" fmla="*/ 24 h 24"/>
                  <a:gd name="T22" fmla="*/ 0 w 16"/>
                  <a:gd name="T23" fmla="*/ 24 h 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16" h="24">
                    <a:moveTo>
                      <a:pt x="0" y="24"/>
                    </a:moveTo>
                    <a:lnTo>
                      <a:pt x="4" y="24"/>
                    </a:lnTo>
                    <a:lnTo>
                      <a:pt x="8" y="24"/>
                    </a:lnTo>
                    <a:lnTo>
                      <a:pt x="8" y="0"/>
                    </a:lnTo>
                    <a:lnTo>
                      <a:pt x="12" y="4"/>
                    </a:lnTo>
                    <a:lnTo>
                      <a:pt x="12" y="24"/>
                    </a:lnTo>
                    <a:lnTo>
                      <a:pt x="12" y="4"/>
                    </a:lnTo>
                    <a:lnTo>
                      <a:pt x="12" y="24"/>
                    </a:lnTo>
                    <a:lnTo>
                      <a:pt x="16" y="24"/>
                    </a:lnTo>
                    <a:lnTo>
                      <a:pt x="16" y="24"/>
                    </a:lnTo>
                    <a:lnTo>
                      <a:pt x="0" y="24"/>
                    </a:lnTo>
                    <a:lnTo>
                      <a:pt x="0" y="24"/>
                    </a:lnTo>
                    <a:close/>
                  </a:path>
                </a:pathLst>
              </a:custGeom>
              <a:solidFill>
                <a:srgbClr val="E5F5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92" name="Freeform 288"/>
              <p:cNvSpPr>
                <a:spLocks/>
              </p:cNvSpPr>
              <p:nvPr/>
            </p:nvSpPr>
            <p:spPr bwMode="auto">
              <a:xfrm>
                <a:off x="10633830" y="5676949"/>
                <a:ext cx="24907" cy="0"/>
              </a:xfrm>
              <a:custGeom>
                <a:avLst/>
                <a:gdLst>
                  <a:gd name="T0" fmla="*/ 16 w 16"/>
                  <a:gd name="T1" fmla="*/ 16 w 16"/>
                  <a:gd name="T2" fmla="*/ 0 w 16"/>
                  <a:gd name="T3" fmla="*/ 0 w 16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16">
                    <a:moveTo>
                      <a:pt x="16" y="0"/>
                    </a:moveTo>
                    <a:lnTo>
                      <a:pt x="16" y="0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flat">
                <a:solidFill>
                  <a:srgbClr val="E5F5E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93" name="Freeform 289"/>
              <p:cNvSpPr>
                <a:spLocks/>
              </p:cNvSpPr>
              <p:nvPr/>
            </p:nvSpPr>
            <p:spPr bwMode="auto">
              <a:xfrm>
                <a:off x="6790293" y="3751523"/>
                <a:ext cx="3874671" cy="1925426"/>
              </a:xfrm>
              <a:custGeom>
                <a:avLst/>
                <a:gdLst>
                  <a:gd name="T0" fmla="*/ 379 w 2489"/>
                  <a:gd name="T1" fmla="*/ 1588 h 1588"/>
                  <a:gd name="T2" fmla="*/ 411 w 2489"/>
                  <a:gd name="T3" fmla="*/ 1429 h 1588"/>
                  <a:gd name="T4" fmla="*/ 525 w 2489"/>
                  <a:gd name="T5" fmla="*/ 1584 h 1588"/>
                  <a:gd name="T6" fmla="*/ 574 w 2489"/>
                  <a:gd name="T7" fmla="*/ 1588 h 1588"/>
                  <a:gd name="T8" fmla="*/ 708 w 2489"/>
                  <a:gd name="T9" fmla="*/ 1584 h 1588"/>
                  <a:gd name="T10" fmla="*/ 757 w 2489"/>
                  <a:gd name="T11" fmla="*/ 1584 h 1588"/>
                  <a:gd name="T12" fmla="*/ 798 w 2489"/>
                  <a:gd name="T13" fmla="*/ 1584 h 1588"/>
                  <a:gd name="T14" fmla="*/ 822 w 2489"/>
                  <a:gd name="T15" fmla="*/ 1584 h 1588"/>
                  <a:gd name="T16" fmla="*/ 863 w 2489"/>
                  <a:gd name="T17" fmla="*/ 1588 h 1588"/>
                  <a:gd name="T18" fmla="*/ 895 w 2489"/>
                  <a:gd name="T19" fmla="*/ 1588 h 1588"/>
                  <a:gd name="T20" fmla="*/ 924 w 2489"/>
                  <a:gd name="T21" fmla="*/ 1245 h 1588"/>
                  <a:gd name="T22" fmla="*/ 960 w 2489"/>
                  <a:gd name="T23" fmla="*/ 1552 h 1588"/>
                  <a:gd name="T24" fmla="*/ 985 w 2489"/>
                  <a:gd name="T25" fmla="*/ 1588 h 1588"/>
                  <a:gd name="T26" fmla="*/ 1054 w 2489"/>
                  <a:gd name="T27" fmla="*/ 1580 h 1588"/>
                  <a:gd name="T28" fmla="*/ 1086 w 2489"/>
                  <a:gd name="T29" fmla="*/ 1584 h 1588"/>
                  <a:gd name="T30" fmla="*/ 1107 w 2489"/>
                  <a:gd name="T31" fmla="*/ 1580 h 1588"/>
                  <a:gd name="T32" fmla="*/ 1147 w 2489"/>
                  <a:gd name="T33" fmla="*/ 1547 h 1588"/>
                  <a:gd name="T34" fmla="*/ 1184 w 2489"/>
                  <a:gd name="T35" fmla="*/ 1576 h 1588"/>
                  <a:gd name="T36" fmla="*/ 1220 w 2489"/>
                  <a:gd name="T37" fmla="*/ 1588 h 1588"/>
                  <a:gd name="T38" fmla="*/ 1245 w 2489"/>
                  <a:gd name="T39" fmla="*/ 1584 h 1588"/>
                  <a:gd name="T40" fmla="*/ 1286 w 2489"/>
                  <a:gd name="T41" fmla="*/ 1588 h 1588"/>
                  <a:gd name="T42" fmla="*/ 1338 w 2489"/>
                  <a:gd name="T43" fmla="*/ 1588 h 1588"/>
                  <a:gd name="T44" fmla="*/ 1363 w 2489"/>
                  <a:gd name="T45" fmla="*/ 1588 h 1588"/>
                  <a:gd name="T46" fmla="*/ 1412 w 2489"/>
                  <a:gd name="T47" fmla="*/ 1588 h 1588"/>
                  <a:gd name="T48" fmla="*/ 1440 w 2489"/>
                  <a:gd name="T49" fmla="*/ 1588 h 1588"/>
                  <a:gd name="T50" fmla="*/ 1460 w 2489"/>
                  <a:gd name="T51" fmla="*/ 1588 h 1588"/>
                  <a:gd name="T52" fmla="*/ 1489 w 2489"/>
                  <a:gd name="T53" fmla="*/ 1588 h 1588"/>
                  <a:gd name="T54" fmla="*/ 1521 w 2489"/>
                  <a:gd name="T55" fmla="*/ 1584 h 1588"/>
                  <a:gd name="T56" fmla="*/ 1546 w 2489"/>
                  <a:gd name="T57" fmla="*/ 1588 h 1588"/>
                  <a:gd name="T58" fmla="*/ 1587 w 2489"/>
                  <a:gd name="T59" fmla="*/ 1588 h 1588"/>
                  <a:gd name="T60" fmla="*/ 1615 w 2489"/>
                  <a:gd name="T61" fmla="*/ 1588 h 1588"/>
                  <a:gd name="T62" fmla="*/ 1643 w 2489"/>
                  <a:gd name="T63" fmla="*/ 1584 h 1588"/>
                  <a:gd name="T64" fmla="*/ 1668 w 2489"/>
                  <a:gd name="T65" fmla="*/ 1588 h 1588"/>
                  <a:gd name="T66" fmla="*/ 1696 w 2489"/>
                  <a:gd name="T67" fmla="*/ 1584 h 1588"/>
                  <a:gd name="T68" fmla="*/ 1757 w 2489"/>
                  <a:gd name="T69" fmla="*/ 1556 h 1588"/>
                  <a:gd name="T70" fmla="*/ 1782 w 2489"/>
                  <a:gd name="T71" fmla="*/ 1572 h 1588"/>
                  <a:gd name="T72" fmla="*/ 1806 w 2489"/>
                  <a:gd name="T73" fmla="*/ 1547 h 1588"/>
                  <a:gd name="T74" fmla="*/ 1831 w 2489"/>
                  <a:gd name="T75" fmla="*/ 1466 h 1588"/>
                  <a:gd name="T76" fmla="*/ 1855 w 2489"/>
                  <a:gd name="T77" fmla="*/ 1584 h 1588"/>
                  <a:gd name="T78" fmla="*/ 1879 w 2489"/>
                  <a:gd name="T79" fmla="*/ 1584 h 1588"/>
                  <a:gd name="T80" fmla="*/ 1908 w 2489"/>
                  <a:gd name="T81" fmla="*/ 1588 h 1588"/>
                  <a:gd name="T82" fmla="*/ 1932 w 2489"/>
                  <a:gd name="T83" fmla="*/ 1588 h 1588"/>
                  <a:gd name="T84" fmla="*/ 1969 w 2489"/>
                  <a:gd name="T85" fmla="*/ 1576 h 1588"/>
                  <a:gd name="T86" fmla="*/ 1993 w 2489"/>
                  <a:gd name="T87" fmla="*/ 1572 h 1588"/>
                  <a:gd name="T88" fmla="*/ 2018 w 2489"/>
                  <a:gd name="T89" fmla="*/ 1588 h 1588"/>
                  <a:gd name="T90" fmla="*/ 2054 w 2489"/>
                  <a:gd name="T91" fmla="*/ 1560 h 1588"/>
                  <a:gd name="T92" fmla="*/ 2083 w 2489"/>
                  <a:gd name="T93" fmla="*/ 1580 h 1588"/>
                  <a:gd name="T94" fmla="*/ 2119 w 2489"/>
                  <a:gd name="T95" fmla="*/ 1588 h 1588"/>
                  <a:gd name="T96" fmla="*/ 2148 w 2489"/>
                  <a:gd name="T97" fmla="*/ 1588 h 1588"/>
                  <a:gd name="T98" fmla="*/ 2172 w 2489"/>
                  <a:gd name="T99" fmla="*/ 1588 h 1588"/>
                  <a:gd name="T100" fmla="*/ 2201 w 2489"/>
                  <a:gd name="T101" fmla="*/ 1588 h 1588"/>
                  <a:gd name="T102" fmla="*/ 2229 w 2489"/>
                  <a:gd name="T103" fmla="*/ 1572 h 1588"/>
                  <a:gd name="T104" fmla="*/ 2306 w 2489"/>
                  <a:gd name="T105" fmla="*/ 1580 h 1588"/>
                  <a:gd name="T106" fmla="*/ 2331 w 2489"/>
                  <a:gd name="T107" fmla="*/ 1580 h 1588"/>
                  <a:gd name="T108" fmla="*/ 2355 w 2489"/>
                  <a:gd name="T109" fmla="*/ 1564 h 1588"/>
                  <a:gd name="T110" fmla="*/ 2380 w 2489"/>
                  <a:gd name="T111" fmla="*/ 1588 h 1588"/>
                  <a:gd name="T112" fmla="*/ 2408 w 2489"/>
                  <a:gd name="T113" fmla="*/ 1588 h 1588"/>
                  <a:gd name="T114" fmla="*/ 2441 w 2489"/>
                  <a:gd name="T115" fmla="*/ 1588 h 1588"/>
                  <a:gd name="T116" fmla="*/ 2489 w 2489"/>
                  <a:gd name="T117" fmla="*/ 1588 h 15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</a:cxnLst>
                <a:rect l="0" t="0" r="r" b="b"/>
                <a:pathLst>
                  <a:path w="2489" h="1588">
                    <a:moveTo>
                      <a:pt x="0" y="1588"/>
                    </a:moveTo>
                    <a:lnTo>
                      <a:pt x="4" y="1588"/>
                    </a:lnTo>
                    <a:lnTo>
                      <a:pt x="175" y="1588"/>
                    </a:lnTo>
                    <a:lnTo>
                      <a:pt x="175" y="1576"/>
                    </a:lnTo>
                    <a:lnTo>
                      <a:pt x="179" y="1588"/>
                    </a:lnTo>
                    <a:lnTo>
                      <a:pt x="261" y="1588"/>
                    </a:lnTo>
                    <a:lnTo>
                      <a:pt x="261" y="1584"/>
                    </a:lnTo>
                    <a:lnTo>
                      <a:pt x="265" y="1584"/>
                    </a:lnTo>
                    <a:lnTo>
                      <a:pt x="265" y="1588"/>
                    </a:lnTo>
                    <a:lnTo>
                      <a:pt x="265" y="1584"/>
                    </a:lnTo>
                    <a:lnTo>
                      <a:pt x="269" y="1588"/>
                    </a:lnTo>
                    <a:lnTo>
                      <a:pt x="379" y="1588"/>
                    </a:lnTo>
                    <a:lnTo>
                      <a:pt x="383" y="1584"/>
                    </a:lnTo>
                    <a:lnTo>
                      <a:pt x="383" y="1196"/>
                    </a:lnTo>
                    <a:lnTo>
                      <a:pt x="387" y="1082"/>
                    </a:lnTo>
                    <a:lnTo>
                      <a:pt x="387" y="1584"/>
                    </a:lnTo>
                    <a:lnTo>
                      <a:pt x="387" y="1082"/>
                    </a:lnTo>
                    <a:lnTo>
                      <a:pt x="387" y="1584"/>
                    </a:lnTo>
                    <a:lnTo>
                      <a:pt x="391" y="1588"/>
                    </a:lnTo>
                    <a:lnTo>
                      <a:pt x="407" y="1588"/>
                    </a:lnTo>
                    <a:lnTo>
                      <a:pt x="407" y="1523"/>
                    </a:lnTo>
                    <a:lnTo>
                      <a:pt x="411" y="1449"/>
                    </a:lnTo>
                    <a:lnTo>
                      <a:pt x="411" y="1580"/>
                    </a:lnTo>
                    <a:lnTo>
                      <a:pt x="411" y="1429"/>
                    </a:lnTo>
                    <a:lnTo>
                      <a:pt x="411" y="1580"/>
                    </a:lnTo>
                    <a:lnTo>
                      <a:pt x="415" y="1588"/>
                    </a:lnTo>
                    <a:lnTo>
                      <a:pt x="436" y="1588"/>
                    </a:lnTo>
                    <a:lnTo>
                      <a:pt x="436" y="1584"/>
                    </a:lnTo>
                    <a:lnTo>
                      <a:pt x="440" y="1588"/>
                    </a:lnTo>
                    <a:lnTo>
                      <a:pt x="484" y="1588"/>
                    </a:lnTo>
                    <a:lnTo>
                      <a:pt x="488" y="1584"/>
                    </a:lnTo>
                    <a:lnTo>
                      <a:pt x="488" y="1588"/>
                    </a:lnTo>
                    <a:lnTo>
                      <a:pt x="488" y="1584"/>
                    </a:lnTo>
                    <a:lnTo>
                      <a:pt x="492" y="1588"/>
                    </a:lnTo>
                    <a:lnTo>
                      <a:pt x="521" y="1588"/>
                    </a:lnTo>
                    <a:lnTo>
                      <a:pt x="525" y="1584"/>
                    </a:lnTo>
                    <a:lnTo>
                      <a:pt x="525" y="1588"/>
                    </a:lnTo>
                    <a:lnTo>
                      <a:pt x="525" y="1584"/>
                    </a:lnTo>
                    <a:lnTo>
                      <a:pt x="529" y="1588"/>
                    </a:lnTo>
                    <a:lnTo>
                      <a:pt x="558" y="1588"/>
                    </a:lnTo>
                    <a:lnTo>
                      <a:pt x="558" y="1556"/>
                    </a:lnTo>
                    <a:lnTo>
                      <a:pt x="562" y="1519"/>
                    </a:lnTo>
                    <a:lnTo>
                      <a:pt x="562" y="1588"/>
                    </a:lnTo>
                    <a:lnTo>
                      <a:pt x="562" y="1507"/>
                    </a:lnTo>
                    <a:lnTo>
                      <a:pt x="566" y="1588"/>
                    </a:lnTo>
                    <a:lnTo>
                      <a:pt x="570" y="1588"/>
                    </a:lnTo>
                    <a:lnTo>
                      <a:pt x="574" y="1584"/>
                    </a:lnTo>
                    <a:lnTo>
                      <a:pt x="574" y="1588"/>
                    </a:lnTo>
                    <a:lnTo>
                      <a:pt x="574" y="1584"/>
                    </a:lnTo>
                    <a:lnTo>
                      <a:pt x="578" y="1588"/>
                    </a:lnTo>
                    <a:lnTo>
                      <a:pt x="586" y="1588"/>
                    </a:lnTo>
                    <a:lnTo>
                      <a:pt x="586" y="1584"/>
                    </a:lnTo>
                    <a:lnTo>
                      <a:pt x="590" y="1588"/>
                    </a:lnTo>
                    <a:lnTo>
                      <a:pt x="667" y="1588"/>
                    </a:lnTo>
                    <a:lnTo>
                      <a:pt x="671" y="1584"/>
                    </a:lnTo>
                    <a:lnTo>
                      <a:pt x="671" y="1588"/>
                    </a:lnTo>
                    <a:lnTo>
                      <a:pt x="671" y="1584"/>
                    </a:lnTo>
                    <a:lnTo>
                      <a:pt x="675" y="1588"/>
                    </a:lnTo>
                    <a:lnTo>
                      <a:pt x="708" y="1588"/>
                    </a:lnTo>
                    <a:lnTo>
                      <a:pt x="708" y="1584"/>
                    </a:lnTo>
                    <a:lnTo>
                      <a:pt x="712" y="1588"/>
                    </a:lnTo>
                    <a:lnTo>
                      <a:pt x="720" y="1588"/>
                    </a:lnTo>
                    <a:lnTo>
                      <a:pt x="720" y="1580"/>
                    </a:lnTo>
                    <a:lnTo>
                      <a:pt x="724" y="1588"/>
                    </a:lnTo>
                    <a:lnTo>
                      <a:pt x="732" y="1588"/>
                    </a:lnTo>
                    <a:lnTo>
                      <a:pt x="732" y="1584"/>
                    </a:lnTo>
                    <a:lnTo>
                      <a:pt x="736" y="1584"/>
                    </a:lnTo>
                    <a:lnTo>
                      <a:pt x="736" y="1588"/>
                    </a:lnTo>
                    <a:lnTo>
                      <a:pt x="736" y="1584"/>
                    </a:lnTo>
                    <a:lnTo>
                      <a:pt x="741" y="1588"/>
                    </a:lnTo>
                    <a:lnTo>
                      <a:pt x="757" y="1588"/>
                    </a:lnTo>
                    <a:lnTo>
                      <a:pt x="757" y="1584"/>
                    </a:lnTo>
                    <a:lnTo>
                      <a:pt x="761" y="1584"/>
                    </a:lnTo>
                    <a:lnTo>
                      <a:pt x="761" y="1588"/>
                    </a:lnTo>
                    <a:lnTo>
                      <a:pt x="761" y="1584"/>
                    </a:lnTo>
                    <a:lnTo>
                      <a:pt x="765" y="1588"/>
                    </a:lnTo>
                    <a:lnTo>
                      <a:pt x="781" y="1588"/>
                    </a:lnTo>
                    <a:lnTo>
                      <a:pt x="781" y="1584"/>
                    </a:lnTo>
                    <a:lnTo>
                      <a:pt x="785" y="1584"/>
                    </a:lnTo>
                    <a:lnTo>
                      <a:pt x="785" y="1588"/>
                    </a:lnTo>
                    <a:lnTo>
                      <a:pt x="785" y="1584"/>
                    </a:lnTo>
                    <a:lnTo>
                      <a:pt x="789" y="1588"/>
                    </a:lnTo>
                    <a:lnTo>
                      <a:pt x="798" y="1588"/>
                    </a:lnTo>
                    <a:lnTo>
                      <a:pt x="798" y="1584"/>
                    </a:lnTo>
                    <a:lnTo>
                      <a:pt x="802" y="1588"/>
                    </a:lnTo>
                    <a:lnTo>
                      <a:pt x="806" y="1588"/>
                    </a:lnTo>
                    <a:lnTo>
                      <a:pt x="806" y="1576"/>
                    </a:lnTo>
                    <a:lnTo>
                      <a:pt x="810" y="1560"/>
                    </a:lnTo>
                    <a:lnTo>
                      <a:pt x="810" y="1588"/>
                    </a:lnTo>
                    <a:lnTo>
                      <a:pt x="810" y="1556"/>
                    </a:lnTo>
                    <a:lnTo>
                      <a:pt x="814" y="1588"/>
                    </a:lnTo>
                    <a:lnTo>
                      <a:pt x="818" y="1588"/>
                    </a:lnTo>
                    <a:lnTo>
                      <a:pt x="818" y="1584"/>
                    </a:lnTo>
                    <a:lnTo>
                      <a:pt x="822" y="1584"/>
                    </a:lnTo>
                    <a:lnTo>
                      <a:pt x="822" y="1588"/>
                    </a:lnTo>
                    <a:lnTo>
                      <a:pt x="822" y="1584"/>
                    </a:lnTo>
                    <a:lnTo>
                      <a:pt x="826" y="1588"/>
                    </a:lnTo>
                    <a:lnTo>
                      <a:pt x="846" y="1588"/>
                    </a:lnTo>
                    <a:lnTo>
                      <a:pt x="846" y="1584"/>
                    </a:lnTo>
                    <a:lnTo>
                      <a:pt x="850" y="1588"/>
                    </a:lnTo>
                    <a:lnTo>
                      <a:pt x="854" y="1588"/>
                    </a:lnTo>
                    <a:lnTo>
                      <a:pt x="854" y="1425"/>
                    </a:lnTo>
                    <a:lnTo>
                      <a:pt x="859" y="1008"/>
                    </a:lnTo>
                    <a:lnTo>
                      <a:pt x="859" y="1041"/>
                    </a:lnTo>
                    <a:lnTo>
                      <a:pt x="859" y="0"/>
                    </a:lnTo>
                    <a:lnTo>
                      <a:pt x="859" y="1041"/>
                    </a:lnTo>
                    <a:lnTo>
                      <a:pt x="863" y="1433"/>
                    </a:lnTo>
                    <a:lnTo>
                      <a:pt x="863" y="1588"/>
                    </a:lnTo>
                    <a:lnTo>
                      <a:pt x="863" y="1433"/>
                    </a:lnTo>
                    <a:lnTo>
                      <a:pt x="867" y="1588"/>
                    </a:lnTo>
                    <a:lnTo>
                      <a:pt x="871" y="1580"/>
                    </a:lnTo>
                    <a:lnTo>
                      <a:pt x="871" y="1462"/>
                    </a:lnTo>
                    <a:lnTo>
                      <a:pt x="875" y="1580"/>
                    </a:lnTo>
                    <a:lnTo>
                      <a:pt x="875" y="1588"/>
                    </a:lnTo>
                    <a:lnTo>
                      <a:pt x="875" y="1580"/>
                    </a:lnTo>
                    <a:lnTo>
                      <a:pt x="879" y="1588"/>
                    </a:lnTo>
                    <a:lnTo>
                      <a:pt x="883" y="1588"/>
                    </a:lnTo>
                    <a:lnTo>
                      <a:pt x="883" y="1580"/>
                    </a:lnTo>
                    <a:lnTo>
                      <a:pt x="887" y="1588"/>
                    </a:lnTo>
                    <a:lnTo>
                      <a:pt x="895" y="1588"/>
                    </a:lnTo>
                    <a:lnTo>
                      <a:pt x="895" y="1580"/>
                    </a:lnTo>
                    <a:lnTo>
                      <a:pt x="899" y="1584"/>
                    </a:lnTo>
                    <a:lnTo>
                      <a:pt x="899" y="1588"/>
                    </a:lnTo>
                    <a:lnTo>
                      <a:pt x="899" y="1584"/>
                    </a:lnTo>
                    <a:lnTo>
                      <a:pt x="903" y="1588"/>
                    </a:lnTo>
                    <a:lnTo>
                      <a:pt x="907" y="1588"/>
                    </a:lnTo>
                    <a:lnTo>
                      <a:pt x="907" y="1584"/>
                    </a:lnTo>
                    <a:lnTo>
                      <a:pt x="911" y="1588"/>
                    </a:lnTo>
                    <a:lnTo>
                      <a:pt x="915" y="1588"/>
                    </a:lnTo>
                    <a:lnTo>
                      <a:pt x="920" y="1584"/>
                    </a:lnTo>
                    <a:lnTo>
                      <a:pt x="920" y="1184"/>
                    </a:lnTo>
                    <a:lnTo>
                      <a:pt x="924" y="1245"/>
                    </a:lnTo>
                    <a:lnTo>
                      <a:pt x="924" y="1588"/>
                    </a:lnTo>
                    <a:lnTo>
                      <a:pt x="924" y="1245"/>
                    </a:lnTo>
                    <a:lnTo>
                      <a:pt x="928" y="1588"/>
                    </a:lnTo>
                    <a:lnTo>
                      <a:pt x="932" y="1588"/>
                    </a:lnTo>
                    <a:lnTo>
                      <a:pt x="932" y="1560"/>
                    </a:lnTo>
                    <a:lnTo>
                      <a:pt x="936" y="1564"/>
                    </a:lnTo>
                    <a:lnTo>
                      <a:pt x="936" y="1588"/>
                    </a:lnTo>
                    <a:lnTo>
                      <a:pt x="936" y="1564"/>
                    </a:lnTo>
                    <a:lnTo>
                      <a:pt x="940" y="1588"/>
                    </a:lnTo>
                    <a:lnTo>
                      <a:pt x="956" y="1588"/>
                    </a:lnTo>
                    <a:lnTo>
                      <a:pt x="956" y="1568"/>
                    </a:lnTo>
                    <a:lnTo>
                      <a:pt x="960" y="1552"/>
                    </a:lnTo>
                    <a:lnTo>
                      <a:pt x="960" y="1588"/>
                    </a:lnTo>
                    <a:lnTo>
                      <a:pt x="960" y="1547"/>
                    </a:lnTo>
                    <a:lnTo>
                      <a:pt x="964" y="1588"/>
                    </a:lnTo>
                    <a:lnTo>
                      <a:pt x="968" y="1588"/>
                    </a:lnTo>
                    <a:lnTo>
                      <a:pt x="972" y="1584"/>
                    </a:lnTo>
                    <a:lnTo>
                      <a:pt x="972" y="1588"/>
                    </a:lnTo>
                    <a:lnTo>
                      <a:pt x="972" y="1584"/>
                    </a:lnTo>
                    <a:lnTo>
                      <a:pt x="976" y="1588"/>
                    </a:lnTo>
                    <a:lnTo>
                      <a:pt x="981" y="1588"/>
                    </a:lnTo>
                    <a:lnTo>
                      <a:pt x="981" y="1576"/>
                    </a:lnTo>
                    <a:lnTo>
                      <a:pt x="985" y="1572"/>
                    </a:lnTo>
                    <a:lnTo>
                      <a:pt x="985" y="1588"/>
                    </a:lnTo>
                    <a:lnTo>
                      <a:pt x="985" y="1572"/>
                    </a:lnTo>
                    <a:lnTo>
                      <a:pt x="989" y="1588"/>
                    </a:lnTo>
                    <a:lnTo>
                      <a:pt x="993" y="1588"/>
                    </a:lnTo>
                    <a:lnTo>
                      <a:pt x="997" y="1584"/>
                    </a:lnTo>
                    <a:lnTo>
                      <a:pt x="997" y="1588"/>
                    </a:lnTo>
                    <a:lnTo>
                      <a:pt x="997" y="1576"/>
                    </a:lnTo>
                    <a:lnTo>
                      <a:pt x="1001" y="1588"/>
                    </a:lnTo>
                    <a:lnTo>
                      <a:pt x="1046" y="1588"/>
                    </a:lnTo>
                    <a:lnTo>
                      <a:pt x="1046" y="1584"/>
                    </a:lnTo>
                    <a:lnTo>
                      <a:pt x="1050" y="1588"/>
                    </a:lnTo>
                    <a:lnTo>
                      <a:pt x="1054" y="1588"/>
                    </a:lnTo>
                    <a:lnTo>
                      <a:pt x="1054" y="1580"/>
                    </a:lnTo>
                    <a:lnTo>
                      <a:pt x="1058" y="1568"/>
                    </a:lnTo>
                    <a:lnTo>
                      <a:pt x="1058" y="1588"/>
                    </a:lnTo>
                    <a:lnTo>
                      <a:pt x="1058" y="1568"/>
                    </a:lnTo>
                    <a:lnTo>
                      <a:pt x="1062" y="1588"/>
                    </a:lnTo>
                    <a:lnTo>
                      <a:pt x="1070" y="1588"/>
                    </a:lnTo>
                    <a:lnTo>
                      <a:pt x="1070" y="1564"/>
                    </a:lnTo>
                    <a:lnTo>
                      <a:pt x="1074" y="1588"/>
                    </a:lnTo>
                    <a:lnTo>
                      <a:pt x="1082" y="1588"/>
                    </a:lnTo>
                    <a:lnTo>
                      <a:pt x="1082" y="1572"/>
                    </a:lnTo>
                    <a:lnTo>
                      <a:pt x="1086" y="1584"/>
                    </a:lnTo>
                    <a:lnTo>
                      <a:pt x="1086" y="1588"/>
                    </a:lnTo>
                    <a:lnTo>
                      <a:pt x="1086" y="1584"/>
                    </a:lnTo>
                    <a:lnTo>
                      <a:pt x="1090" y="1588"/>
                    </a:lnTo>
                    <a:lnTo>
                      <a:pt x="1094" y="1588"/>
                    </a:lnTo>
                    <a:lnTo>
                      <a:pt x="1094" y="1580"/>
                    </a:lnTo>
                    <a:lnTo>
                      <a:pt x="1098" y="1584"/>
                    </a:lnTo>
                    <a:lnTo>
                      <a:pt x="1098" y="1588"/>
                    </a:lnTo>
                    <a:lnTo>
                      <a:pt x="1098" y="1584"/>
                    </a:lnTo>
                    <a:lnTo>
                      <a:pt x="1103" y="1588"/>
                    </a:lnTo>
                    <a:lnTo>
                      <a:pt x="1103" y="1466"/>
                    </a:lnTo>
                    <a:lnTo>
                      <a:pt x="1107" y="1429"/>
                    </a:lnTo>
                    <a:lnTo>
                      <a:pt x="1107" y="1580"/>
                    </a:lnTo>
                    <a:lnTo>
                      <a:pt x="1107" y="1429"/>
                    </a:lnTo>
                    <a:lnTo>
                      <a:pt x="1107" y="1580"/>
                    </a:lnTo>
                    <a:lnTo>
                      <a:pt x="1111" y="1588"/>
                    </a:lnTo>
                    <a:lnTo>
                      <a:pt x="1127" y="1588"/>
                    </a:lnTo>
                    <a:lnTo>
                      <a:pt x="1127" y="1519"/>
                    </a:lnTo>
                    <a:lnTo>
                      <a:pt x="1131" y="1372"/>
                    </a:lnTo>
                    <a:lnTo>
                      <a:pt x="1131" y="278"/>
                    </a:lnTo>
                    <a:lnTo>
                      <a:pt x="1135" y="1098"/>
                    </a:lnTo>
                    <a:lnTo>
                      <a:pt x="1135" y="1588"/>
                    </a:lnTo>
                    <a:lnTo>
                      <a:pt x="1135" y="1098"/>
                    </a:lnTo>
                    <a:lnTo>
                      <a:pt x="1139" y="1588"/>
                    </a:lnTo>
                    <a:lnTo>
                      <a:pt x="1143" y="1580"/>
                    </a:lnTo>
                    <a:lnTo>
                      <a:pt x="1143" y="1482"/>
                    </a:lnTo>
                    <a:lnTo>
                      <a:pt x="1147" y="1547"/>
                    </a:lnTo>
                    <a:lnTo>
                      <a:pt x="1147" y="1588"/>
                    </a:lnTo>
                    <a:lnTo>
                      <a:pt x="1147" y="1547"/>
                    </a:lnTo>
                    <a:lnTo>
                      <a:pt x="1151" y="1588"/>
                    </a:lnTo>
                    <a:lnTo>
                      <a:pt x="1155" y="1584"/>
                    </a:lnTo>
                    <a:lnTo>
                      <a:pt x="1155" y="1568"/>
                    </a:lnTo>
                    <a:lnTo>
                      <a:pt x="1159" y="1580"/>
                    </a:lnTo>
                    <a:lnTo>
                      <a:pt x="1159" y="1588"/>
                    </a:lnTo>
                    <a:lnTo>
                      <a:pt x="1159" y="1580"/>
                    </a:lnTo>
                    <a:lnTo>
                      <a:pt x="1164" y="1588"/>
                    </a:lnTo>
                    <a:lnTo>
                      <a:pt x="1180" y="1588"/>
                    </a:lnTo>
                    <a:lnTo>
                      <a:pt x="1180" y="1556"/>
                    </a:lnTo>
                    <a:lnTo>
                      <a:pt x="1184" y="1576"/>
                    </a:lnTo>
                    <a:lnTo>
                      <a:pt x="1184" y="1588"/>
                    </a:lnTo>
                    <a:lnTo>
                      <a:pt x="1184" y="1576"/>
                    </a:lnTo>
                    <a:lnTo>
                      <a:pt x="1188" y="1588"/>
                    </a:lnTo>
                    <a:lnTo>
                      <a:pt x="1204" y="1588"/>
                    </a:lnTo>
                    <a:lnTo>
                      <a:pt x="1204" y="1576"/>
                    </a:lnTo>
                    <a:lnTo>
                      <a:pt x="1208" y="1576"/>
                    </a:lnTo>
                    <a:lnTo>
                      <a:pt x="1208" y="1588"/>
                    </a:lnTo>
                    <a:lnTo>
                      <a:pt x="1208" y="1576"/>
                    </a:lnTo>
                    <a:lnTo>
                      <a:pt x="1212" y="1588"/>
                    </a:lnTo>
                    <a:lnTo>
                      <a:pt x="1216" y="1588"/>
                    </a:lnTo>
                    <a:lnTo>
                      <a:pt x="1220" y="1584"/>
                    </a:lnTo>
                    <a:lnTo>
                      <a:pt x="1220" y="1588"/>
                    </a:lnTo>
                    <a:lnTo>
                      <a:pt x="1220" y="1584"/>
                    </a:lnTo>
                    <a:lnTo>
                      <a:pt x="1225" y="1588"/>
                    </a:lnTo>
                    <a:lnTo>
                      <a:pt x="1229" y="1588"/>
                    </a:lnTo>
                    <a:lnTo>
                      <a:pt x="1229" y="1584"/>
                    </a:lnTo>
                    <a:lnTo>
                      <a:pt x="1233" y="1580"/>
                    </a:lnTo>
                    <a:lnTo>
                      <a:pt x="1233" y="1588"/>
                    </a:lnTo>
                    <a:lnTo>
                      <a:pt x="1233" y="1580"/>
                    </a:lnTo>
                    <a:lnTo>
                      <a:pt x="1237" y="1588"/>
                    </a:lnTo>
                    <a:lnTo>
                      <a:pt x="1241" y="1588"/>
                    </a:lnTo>
                    <a:lnTo>
                      <a:pt x="1245" y="1584"/>
                    </a:lnTo>
                    <a:lnTo>
                      <a:pt x="1245" y="1576"/>
                    </a:lnTo>
                    <a:lnTo>
                      <a:pt x="1245" y="1584"/>
                    </a:lnTo>
                    <a:lnTo>
                      <a:pt x="1249" y="1588"/>
                    </a:lnTo>
                    <a:lnTo>
                      <a:pt x="1253" y="1588"/>
                    </a:lnTo>
                    <a:lnTo>
                      <a:pt x="1257" y="1584"/>
                    </a:lnTo>
                    <a:lnTo>
                      <a:pt x="1257" y="1588"/>
                    </a:lnTo>
                    <a:lnTo>
                      <a:pt x="1257" y="1580"/>
                    </a:lnTo>
                    <a:lnTo>
                      <a:pt x="1261" y="1588"/>
                    </a:lnTo>
                    <a:lnTo>
                      <a:pt x="1269" y="1588"/>
                    </a:lnTo>
                    <a:lnTo>
                      <a:pt x="1269" y="1584"/>
                    </a:lnTo>
                    <a:lnTo>
                      <a:pt x="1273" y="1588"/>
                    </a:lnTo>
                    <a:lnTo>
                      <a:pt x="1281" y="1588"/>
                    </a:lnTo>
                    <a:lnTo>
                      <a:pt x="1281" y="1580"/>
                    </a:lnTo>
                    <a:lnTo>
                      <a:pt x="1286" y="1588"/>
                    </a:lnTo>
                    <a:lnTo>
                      <a:pt x="1306" y="1588"/>
                    </a:lnTo>
                    <a:lnTo>
                      <a:pt x="1306" y="1580"/>
                    </a:lnTo>
                    <a:lnTo>
                      <a:pt x="1310" y="1588"/>
                    </a:lnTo>
                    <a:lnTo>
                      <a:pt x="1318" y="1588"/>
                    </a:lnTo>
                    <a:lnTo>
                      <a:pt x="1318" y="1584"/>
                    </a:lnTo>
                    <a:lnTo>
                      <a:pt x="1322" y="1588"/>
                    </a:lnTo>
                    <a:lnTo>
                      <a:pt x="1330" y="1588"/>
                    </a:lnTo>
                    <a:lnTo>
                      <a:pt x="1330" y="1543"/>
                    </a:lnTo>
                    <a:lnTo>
                      <a:pt x="1334" y="1564"/>
                    </a:lnTo>
                    <a:lnTo>
                      <a:pt x="1334" y="1588"/>
                    </a:lnTo>
                    <a:lnTo>
                      <a:pt x="1334" y="1564"/>
                    </a:lnTo>
                    <a:lnTo>
                      <a:pt x="1338" y="1588"/>
                    </a:lnTo>
                    <a:lnTo>
                      <a:pt x="1342" y="1588"/>
                    </a:lnTo>
                    <a:lnTo>
                      <a:pt x="1342" y="1584"/>
                    </a:lnTo>
                    <a:lnTo>
                      <a:pt x="1347" y="1584"/>
                    </a:lnTo>
                    <a:lnTo>
                      <a:pt x="1347" y="1588"/>
                    </a:lnTo>
                    <a:lnTo>
                      <a:pt x="1347" y="1584"/>
                    </a:lnTo>
                    <a:lnTo>
                      <a:pt x="1351" y="1588"/>
                    </a:lnTo>
                    <a:lnTo>
                      <a:pt x="1355" y="1588"/>
                    </a:lnTo>
                    <a:lnTo>
                      <a:pt x="1355" y="1580"/>
                    </a:lnTo>
                    <a:lnTo>
                      <a:pt x="1359" y="1580"/>
                    </a:lnTo>
                    <a:lnTo>
                      <a:pt x="1359" y="1588"/>
                    </a:lnTo>
                    <a:lnTo>
                      <a:pt x="1359" y="1580"/>
                    </a:lnTo>
                    <a:lnTo>
                      <a:pt x="1363" y="1588"/>
                    </a:lnTo>
                    <a:lnTo>
                      <a:pt x="1379" y="1588"/>
                    </a:lnTo>
                    <a:lnTo>
                      <a:pt x="1379" y="1580"/>
                    </a:lnTo>
                    <a:lnTo>
                      <a:pt x="1383" y="1584"/>
                    </a:lnTo>
                    <a:lnTo>
                      <a:pt x="1383" y="1588"/>
                    </a:lnTo>
                    <a:lnTo>
                      <a:pt x="1383" y="1584"/>
                    </a:lnTo>
                    <a:lnTo>
                      <a:pt x="1387" y="1588"/>
                    </a:lnTo>
                    <a:lnTo>
                      <a:pt x="1403" y="1588"/>
                    </a:lnTo>
                    <a:lnTo>
                      <a:pt x="1403" y="1584"/>
                    </a:lnTo>
                    <a:lnTo>
                      <a:pt x="1408" y="1580"/>
                    </a:lnTo>
                    <a:lnTo>
                      <a:pt x="1408" y="1588"/>
                    </a:lnTo>
                    <a:lnTo>
                      <a:pt x="1408" y="1580"/>
                    </a:lnTo>
                    <a:lnTo>
                      <a:pt x="1412" y="1588"/>
                    </a:lnTo>
                    <a:lnTo>
                      <a:pt x="1416" y="1588"/>
                    </a:lnTo>
                    <a:lnTo>
                      <a:pt x="1420" y="1584"/>
                    </a:lnTo>
                    <a:lnTo>
                      <a:pt x="1420" y="1588"/>
                    </a:lnTo>
                    <a:lnTo>
                      <a:pt x="1420" y="1584"/>
                    </a:lnTo>
                    <a:lnTo>
                      <a:pt x="1424" y="1588"/>
                    </a:lnTo>
                    <a:lnTo>
                      <a:pt x="1428" y="1588"/>
                    </a:lnTo>
                    <a:lnTo>
                      <a:pt x="1428" y="1580"/>
                    </a:lnTo>
                    <a:lnTo>
                      <a:pt x="1432" y="1576"/>
                    </a:lnTo>
                    <a:lnTo>
                      <a:pt x="1432" y="1588"/>
                    </a:lnTo>
                    <a:lnTo>
                      <a:pt x="1432" y="1572"/>
                    </a:lnTo>
                    <a:lnTo>
                      <a:pt x="1436" y="1588"/>
                    </a:lnTo>
                    <a:lnTo>
                      <a:pt x="1440" y="1588"/>
                    </a:lnTo>
                    <a:lnTo>
                      <a:pt x="1444" y="1584"/>
                    </a:lnTo>
                    <a:lnTo>
                      <a:pt x="1444" y="1588"/>
                    </a:lnTo>
                    <a:lnTo>
                      <a:pt x="1444" y="1580"/>
                    </a:lnTo>
                    <a:lnTo>
                      <a:pt x="1448" y="1588"/>
                    </a:lnTo>
                    <a:lnTo>
                      <a:pt x="1452" y="1588"/>
                    </a:lnTo>
                    <a:lnTo>
                      <a:pt x="1452" y="1568"/>
                    </a:lnTo>
                    <a:lnTo>
                      <a:pt x="1456" y="1527"/>
                    </a:lnTo>
                    <a:lnTo>
                      <a:pt x="1456" y="1552"/>
                    </a:lnTo>
                    <a:lnTo>
                      <a:pt x="1456" y="1458"/>
                    </a:lnTo>
                    <a:lnTo>
                      <a:pt x="1456" y="1552"/>
                    </a:lnTo>
                    <a:lnTo>
                      <a:pt x="1460" y="1580"/>
                    </a:lnTo>
                    <a:lnTo>
                      <a:pt x="1460" y="1588"/>
                    </a:lnTo>
                    <a:lnTo>
                      <a:pt x="1460" y="1580"/>
                    </a:lnTo>
                    <a:lnTo>
                      <a:pt x="1465" y="1588"/>
                    </a:lnTo>
                    <a:lnTo>
                      <a:pt x="1469" y="1588"/>
                    </a:lnTo>
                    <a:lnTo>
                      <a:pt x="1469" y="1576"/>
                    </a:lnTo>
                    <a:lnTo>
                      <a:pt x="1473" y="1588"/>
                    </a:lnTo>
                    <a:lnTo>
                      <a:pt x="1477" y="1588"/>
                    </a:lnTo>
                    <a:lnTo>
                      <a:pt x="1481" y="1580"/>
                    </a:lnTo>
                    <a:lnTo>
                      <a:pt x="1481" y="1556"/>
                    </a:lnTo>
                    <a:lnTo>
                      <a:pt x="1485" y="1580"/>
                    </a:lnTo>
                    <a:lnTo>
                      <a:pt x="1485" y="1588"/>
                    </a:lnTo>
                    <a:lnTo>
                      <a:pt x="1485" y="1580"/>
                    </a:lnTo>
                    <a:lnTo>
                      <a:pt x="1489" y="1588"/>
                    </a:lnTo>
                    <a:lnTo>
                      <a:pt x="1493" y="1588"/>
                    </a:lnTo>
                    <a:lnTo>
                      <a:pt x="1493" y="1584"/>
                    </a:lnTo>
                    <a:lnTo>
                      <a:pt x="1497" y="1588"/>
                    </a:lnTo>
                    <a:lnTo>
                      <a:pt x="1505" y="1588"/>
                    </a:lnTo>
                    <a:lnTo>
                      <a:pt x="1505" y="1552"/>
                    </a:lnTo>
                    <a:lnTo>
                      <a:pt x="1509" y="1580"/>
                    </a:lnTo>
                    <a:lnTo>
                      <a:pt x="1509" y="1588"/>
                    </a:lnTo>
                    <a:lnTo>
                      <a:pt x="1509" y="1580"/>
                    </a:lnTo>
                    <a:lnTo>
                      <a:pt x="1513" y="1588"/>
                    </a:lnTo>
                    <a:lnTo>
                      <a:pt x="1517" y="1588"/>
                    </a:lnTo>
                    <a:lnTo>
                      <a:pt x="1517" y="1580"/>
                    </a:lnTo>
                    <a:lnTo>
                      <a:pt x="1521" y="1584"/>
                    </a:lnTo>
                    <a:lnTo>
                      <a:pt x="1521" y="1588"/>
                    </a:lnTo>
                    <a:lnTo>
                      <a:pt x="1521" y="1584"/>
                    </a:lnTo>
                    <a:lnTo>
                      <a:pt x="1526" y="1588"/>
                    </a:lnTo>
                    <a:lnTo>
                      <a:pt x="1530" y="1588"/>
                    </a:lnTo>
                    <a:lnTo>
                      <a:pt x="1530" y="1560"/>
                    </a:lnTo>
                    <a:lnTo>
                      <a:pt x="1534" y="1576"/>
                    </a:lnTo>
                    <a:lnTo>
                      <a:pt x="1534" y="1588"/>
                    </a:lnTo>
                    <a:lnTo>
                      <a:pt x="1534" y="1576"/>
                    </a:lnTo>
                    <a:lnTo>
                      <a:pt x="1538" y="1588"/>
                    </a:lnTo>
                    <a:lnTo>
                      <a:pt x="1542" y="1588"/>
                    </a:lnTo>
                    <a:lnTo>
                      <a:pt x="1542" y="1584"/>
                    </a:lnTo>
                    <a:lnTo>
                      <a:pt x="1546" y="1588"/>
                    </a:lnTo>
                    <a:lnTo>
                      <a:pt x="1554" y="1588"/>
                    </a:lnTo>
                    <a:lnTo>
                      <a:pt x="1554" y="1580"/>
                    </a:lnTo>
                    <a:lnTo>
                      <a:pt x="1558" y="1584"/>
                    </a:lnTo>
                    <a:lnTo>
                      <a:pt x="1558" y="1588"/>
                    </a:lnTo>
                    <a:lnTo>
                      <a:pt x="1558" y="1584"/>
                    </a:lnTo>
                    <a:lnTo>
                      <a:pt x="1562" y="1588"/>
                    </a:lnTo>
                    <a:lnTo>
                      <a:pt x="1578" y="1588"/>
                    </a:lnTo>
                    <a:lnTo>
                      <a:pt x="1578" y="1576"/>
                    </a:lnTo>
                    <a:lnTo>
                      <a:pt x="1582" y="1580"/>
                    </a:lnTo>
                    <a:lnTo>
                      <a:pt x="1582" y="1588"/>
                    </a:lnTo>
                    <a:lnTo>
                      <a:pt x="1582" y="1580"/>
                    </a:lnTo>
                    <a:lnTo>
                      <a:pt x="1587" y="1588"/>
                    </a:lnTo>
                    <a:lnTo>
                      <a:pt x="1591" y="1588"/>
                    </a:lnTo>
                    <a:lnTo>
                      <a:pt x="1595" y="1584"/>
                    </a:lnTo>
                    <a:lnTo>
                      <a:pt x="1595" y="1588"/>
                    </a:lnTo>
                    <a:lnTo>
                      <a:pt x="1595" y="1584"/>
                    </a:lnTo>
                    <a:lnTo>
                      <a:pt x="1599" y="1588"/>
                    </a:lnTo>
                    <a:lnTo>
                      <a:pt x="1603" y="1588"/>
                    </a:lnTo>
                    <a:lnTo>
                      <a:pt x="1603" y="1576"/>
                    </a:lnTo>
                    <a:lnTo>
                      <a:pt x="1607" y="1564"/>
                    </a:lnTo>
                    <a:lnTo>
                      <a:pt x="1607" y="1588"/>
                    </a:lnTo>
                    <a:lnTo>
                      <a:pt x="1607" y="1564"/>
                    </a:lnTo>
                    <a:lnTo>
                      <a:pt x="1611" y="1588"/>
                    </a:lnTo>
                    <a:lnTo>
                      <a:pt x="1615" y="1588"/>
                    </a:lnTo>
                    <a:lnTo>
                      <a:pt x="1619" y="1584"/>
                    </a:lnTo>
                    <a:lnTo>
                      <a:pt x="1619" y="1588"/>
                    </a:lnTo>
                    <a:lnTo>
                      <a:pt x="1619" y="1584"/>
                    </a:lnTo>
                    <a:lnTo>
                      <a:pt x="1623" y="1588"/>
                    </a:lnTo>
                    <a:lnTo>
                      <a:pt x="1627" y="1588"/>
                    </a:lnTo>
                    <a:lnTo>
                      <a:pt x="1627" y="1584"/>
                    </a:lnTo>
                    <a:lnTo>
                      <a:pt x="1631" y="1576"/>
                    </a:lnTo>
                    <a:lnTo>
                      <a:pt x="1631" y="1588"/>
                    </a:lnTo>
                    <a:lnTo>
                      <a:pt x="1631" y="1564"/>
                    </a:lnTo>
                    <a:lnTo>
                      <a:pt x="1635" y="1588"/>
                    </a:lnTo>
                    <a:lnTo>
                      <a:pt x="1643" y="1588"/>
                    </a:lnTo>
                    <a:lnTo>
                      <a:pt x="1643" y="1584"/>
                    </a:lnTo>
                    <a:lnTo>
                      <a:pt x="1648" y="1588"/>
                    </a:lnTo>
                    <a:lnTo>
                      <a:pt x="1652" y="1588"/>
                    </a:lnTo>
                    <a:lnTo>
                      <a:pt x="1652" y="1580"/>
                    </a:lnTo>
                    <a:lnTo>
                      <a:pt x="1656" y="1568"/>
                    </a:lnTo>
                    <a:lnTo>
                      <a:pt x="1656" y="1572"/>
                    </a:lnTo>
                    <a:lnTo>
                      <a:pt x="1656" y="1535"/>
                    </a:lnTo>
                    <a:lnTo>
                      <a:pt x="1656" y="1572"/>
                    </a:lnTo>
                    <a:lnTo>
                      <a:pt x="1660" y="1584"/>
                    </a:lnTo>
                    <a:lnTo>
                      <a:pt x="1660" y="1588"/>
                    </a:lnTo>
                    <a:lnTo>
                      <a:pt x="1660" y="1584"/>
                    </a:lnTo>
                    <a:lnTo>
                      <a:pt x="1664" y="1588"/>
                    </a:lnTo>
                    <a:lnTo>
                      <a:pt x="1668" y="1588"/>
                    </a:lnTo>
                    <a:lnTo>
                      <a:pt x="1668" y="1584"/>
                    </a:lnTo>
                    <a:lnTo>
                      <a:pt x="1672" y="1588"/>
                    </a:lnTo>
                    <a:lnTo>
                      <a:pt x="1676" y="1588"/>
                    </a:lnTo>
                    <a:lnTo>
                      <a:pt x="1680" y="1576"/>
                    </a:lnTo>
                    <a:lnTo>
                      <a:pt x="1680" y="1511"/>
                    </a:lnTo>
                    <a:lnTo>
                      <a:pt x="1684" y="1568"/>
                    </a:lnTo>
                    <a:lnTo>
                      <a:pt x="1684" y="1588"/>
                    </a:lnTo>
                    <a:lnTo>
                      <a:pt x="1684" y="1568"/>
                    </a:lnTo>
                    <a:lnTo>
                      <a:pt x="1688" y="1588"/>
                    </a:lnTo>
                    <a:lnTo>
                      <a:pt x="1692" y="1588"/>
                    </a:lnTo>
                    <a:lnTo>
                      <a:pt x="1692" y="1580"/>
                    </a:lnTo>
                    <a:lnTo>
                      <a:pt x="1696" y="1584"/>
                    </a:lnTo>
                    <a:lnTo>
                      <a:pt x="1696" y="1588"/>
                    </a:lnTo>
                    <a:lnTo>
                      <a:pt x="1696" y="1584"/>
                    </a:lnTo>
                    <a:lnTo>
                      <a:pt x="1700" y="1588"/>
                    </a:lnTo>
                    <a:lnTo>
                      <a:pt x="1704" y="1588"/>
                    </a:lnTo>
                    <a:lnTo>
                      <a:pt x="1704" y="1568"/>
                    </a:lnTo>
                    <a:lnTo>
                      <a:pt x="1709" y="1588"/>
                    </a:lnTo>
                    <a:lnTo>
                      <a:pt x="1729" y="1588"/>
                    </a:lnTo>
                    <a:lnTo>
                      <a:pt x="1729" y="1584"/>
                    </a:lnTo>
                    <a:lnTo>
                      <a:pt x="1733" y="1588"/>
                    </a:lnTo>
                    <a:lnTo>
                      <a:pt x="1753" y="1588"/>
                    </a:lnTo>
                    <a:lnTo>
                      <a:pt x="1753" y="1560"/>
                    </a:lnTo>
                    <a:lnTo>
                      <a:pt x="1757" y="1556"/>
                    </a:lnTo>
                    <a:lnTo>
                      <a:pt x="1757" y="1588"/>
                    </a:lnTo>
                    <a:lnTo>
                      <a:pt x="1757" y="1556"/>
                    </a:lnTo>
                    <a:lnTo>
                      <a:pt x="1761" y="1588"/>
                    </a:lnTo>
                    <a:lnTo>
                      <a:pt x="1765" y="1588"/>
                    </a:lnTo>
                    <a:lnTo>
                      <a:pt x="1765" y="1584"/>
                    </a:lnTo>
                    <a:lnTo>
                      <a:pt x="1770" y="1580"/>
                    </a:lnTo>
                    <a:lnTo>
                      <a:pt x="1770" y="1588"/>
                    </a:lnTo>
                    <a:lnTo>
                      <a:pt x="1770" y="1580"/>
                    </a:lnTo>
                    <a:lnTo>
                      <a:pt x="1774" y="1588"/>
                    </a:lnTo>
                    <a:lnTo>
                      <a:pt x="1778" y="1588"/>
                    </a:lnTo>
                    <a:lnTo>
                      <a:pt x="1778" y="1572"/>
                    </a:lnTo>
                    <a:lnTo>
                      <a:pt x="1782" y="1572"/>
                    </a:lnTo>
                    <a:lnTo>
                      <a:pt x="1782" y="1588"/>
                    </a:lnTo>
                    <a:lnTo>
                      <a:pt x="1782" y="1572"/>
                    </a:lnTo>
                    <a:lnTo>
                      <a:pt x="1786" y="1588"/>
                    </a:lnTo>
                    <a:lnTo>
                      <a:pt x="1790" y="1588"/>
                    </a:lnTo>
                    <a:lnTo>
                      <a:pt x="1790" y="1523"/>
                    </a:lnTo>
                    <a:lnTo>
                      <a:pt x="1794" y="1454"/>
                    </a:lnTo>
                    <a:lnTo>
                      <a:pt x="1794" y="1588"/>
                    </a:lnTo>
                    <a:lnTo>
                      <a:pt x="1794" y="1417"/>
                    </a:lnTo>
                    <a:lnTo>
                      <a:pt x="1798" y="1588"/>
                    </a:lnTo>
                    <a:lnTo>
                      <a:pt x="1802" y="1588"/>
                    </a:lnTo>
                    <a:lnTo>
                      <a:pt x="1802" y="1564"/>
                    </a:lnTo>
                    <a:lnTo>
                      <a:pt x="1806" y="1547"/>
                    </a:lnTo>
                    <a:lnTo>
                      <a:pt x="1806" y="1588"/>
                    </a:lnTo>
                    <a:lnTo>
                      <a:pt x="1806" y="1547"/>
                    </a:lnTo>
                    <a:lnTo>
                      <a:pt x="1810" y="1588"/>
                    </a:lnTo>
                    <a:lnTo>
                      <a:pt x="1814" y="1588"/>
                    </a:lnTo>
                    <a:lnTo>
                      <a:pt x="1818" y="1584"/>
                    </a:lnTo>
                    <a:lnTo>
                      <a:pt x="1818" y="1588"/>
                    </a:lnTo>
                    <a:lnTo>
                      <a:pt x="1818" y="1584"/>
                    </a:lnTo>
                    <a:lnTo>
                      <a:pt x="1822" y="1588"/>
                    </a:lnTo>
                    <a:lnTo>
                      <a:pt x="1822" y="1580"/>
                    </a:lnTo>
                    <a:lnTo>
                      <a:pt x="1826" y="1560"/>
                    </a:lnTo>
                    <a:lnTo>
                      <a:pt x="1826" y="1307"/>
                    </a:lnTo>
                    <a:lnTo>
                      <a:pt x="1831" y="1466"/>
                    </a:lnTo>
                    <a:lnTo>
                      <a:pt x="1831" y="1576"/>
                    </a:lnTo>
                    <a:lnTo>
                      <a:pt x="1831" y="1466"/>
                    </a:lnTo>
                    <a:lnTo>
                      <a:pt x="1831" y="1576"/>
                    </a:lnTo>
                    <a:lnTo>
                      <a:pt x="1835" y="1588"/>
                    </a:lnTo>
                    <a:lnTo>
                      <a:pt x="1843" y="1588"/>
                    </a:lnTo>
                    <a:lnTo>
                      <a:pt x="1843" y="1580"/>
                    </a:lnTo>
                    <a:lnTo>
                      <a:pt x="1847" y="1588"/>
                    </a:lnTo>
                    <a:lnTo>
                      <a:pt x="1847" y="1576"/>
                    </a:lnTo>
                    <a:lnTo>
                      <a:pt x="1851" y="1547"/>
                    </a:lnTo>
                    <a:lnTo>
                      <a:pt x="1851" y="1343"/>
                    </a:lnTo>
                    <a:lnTo>
                      <a:pt x="1855" y="1523"/>
                    </a:lnTo>
                    <a:lnTo>
                      <a:pt x="1855" y="1584"/>
                    </a:lnTo>
                    <a:lnTo>
                      <a:pt x="1855" y="1523"/>
                    </a:lnTo>
                    <a:lnTo>
                      <a:pt x="1855" y="1584"/>
                    </a:lnTo>
                    <a:lnTo>
                      <a:pt x="1859" y="1588"/>
                    </a:lnTo>
                    <a:lnTo>
                      <a:pt x="1867" y="1588"/>
                    </a:lnTo>
                    <a:lnTo>
                      <a:pt x="1867" y="1584"/>
                    </a:lnTo>
                    <a:lnTo>
                      <a:pt x="1871" y="1588"/>
                    </a:lnTo>
                    <a:lnTo>
                      <a:pt x="1875" y="1588"/>
                    </a:lnTo>
                    <a:lnTo>
                      <a:pt x="1875" y="1515"/>
                    </a:lnTo>
                    <a:lnTo>
                      <a:pt x="1879" y="1539"/>
                    </a:lnTo>
                    <a:lnTo>
                      <a:pt x="1879" y="1584"/>
                    </a:lnTo>
                    <a:lnTo>
                      <a:pt x="1879" y="1539"/>
                    </a:lnTo>
                    <a:lnTo>
                      <a:pt x="1879" y="1584"/>
                    </a:lnTo>
                    <a:lnTo>
                      <a:pt x="1883" y="1588"/>
                    </a:lnTo>
                    <a:lnTo>
                      <a:pt x="1892" y="1588"/>
                    </a:lnTo>
                    <a:lnTo>
                      <a:pt x="1892" y="1568"/>
                    </a:lnTo>
                    <a:lnTo>
                      <a:pt x="1896" y="1572"/>
                    </a:lnTo>
                    <a:lnTo>
                      <a:pt x="1896" y="1588"/>
                    </a:lnTo>
                    <a:lnTo>
                      <a:pt x="1896" y="1572"/>
                    </a:lnTo>
                    <a:lnTo>
                      <a:pt x="1900" y="1588"/>
                    </a:lnTo>
                    <a:lnTo>
                      <a:pt x="1900" y="1584"/>
                    </a:lnTo>
                    <a:lnTo>
                      <a:pt x="1904" y="1580"/>
                    </a:lnTo>
                    <a:lnTo>
                      <a:pt x="1904" y="1576"/>
                    </a:lnTo>
                    <a:lnTo>
                      <a:pt x="1908" y="1584"/>
                    </a:lnTo>
                    <a:lnTo>
                      <a:pt x="1908" y="1588"/>
                    </a:lnTo>
                    <a:lnTo>
                      <a:pt x="1908" y="1584"/>
                    </a:lnTo>
                    <a:lnTo>
                      <a:pt x="1912" y="1588"/>
                    </a:lnTo>
                    <a:lnTo>
                      <a:pt x="1916" y="1588"/>
                    </a:lnTo>
                    <a:lnTo>
                      <a:pt x="1916" y="1584"/>
                    </a:lnTo>
                    <a:lnTo>
                      <a:pt x="1920" y="1584"/>
                    </a:lnTo>
                    <a:lnTo>
                      <a:pt x="1920" y="1588"/>
                    </a:lnTo>
                    <a:lnTo>
                      <a:pt x="1920" y="1584"/>
                    </a:lnTo>
                    <a:lnTo>
                      <a:pt x="1924" y="1588"/>
                    </a:lnTo>
                    <a:lnTo>
                      <a:pt x="1928" y="1588"/>
                    </a:lnTo>
                    <a:lnTo>
                      <a:pt x="1928" y="1568"/>
                    </a:lnTo>
                    <a:lnTo>
                      <a:pt x="1932" y="1580"/>
                    </a:lnTo>
                    <a:lnTo>
                      <a:pt x="1932" y="1588"/>
                    </a:lnTo>
                    <a:lnTo>
                      <a:pt x="1932" y="1580"/>
                    </a:lnTo>
                    <a:lnTo>
                      <a:pt x="1936" y="1588"/>
                    </a:lnTo>
                    <a:lnTo>
                      <a:pt x="1948" y="1588"/>
                    </a:lnTo>
                    <a:lnTo>
                      <a:pt x="1953" y="1584"/>
                    </a:lnTo>
                    <a:lnTo>
                      <a:pt x="1953" y="1572"/>
                    </a:lnTo>
                    <a:lnTo>
                      <a:pt x="1957" y="1572"/>
                    </a:lnTo>
                    <a:lnTo>
                      <a:pt x="1957" y="1588"/>
                    </a:lnTo>
                    <a:lnTo>
                      <a:pt x="1957" y="1572"/>
                    </a:lnTo>
                    <a:lnTo>
                      <a:pt x="1961" y="1588"/>
                    </a:lnTo>
                    <a:lnTo>
                      <a:pt x="1965" y="1588"/>
                    </a:lnTo>
                    <a:lnTo>
                      <a:pt x="1965" y="1580"/>
                    </a:lnTo>
                    <a:lnTo>
                      <a:pt x="1969" y="1576"/>
                    </a:lnTo>
                    <a:lnTo>
                      <a:pt x="1969" y="1588"/>
                    </a:lnTo>
                    <a:lnTo>
                      <a:pt x="1969" y="1576"/>
                    </a:lnTo>
                    <a:lnTo>
                      <a:pt x="1973" y="1588"/>
                    </a:lnTo>
                    <a:lnTo>
                      <a:pt x="1977" y="1588"/>
                    </a:lnTo>
                    <a:lnTo>
                      <a:pt x="1977" y="1572"/>
                    </a:lnTo>
                    <a:lnTo>
                      <a:pt x="1981" y="1572"/>
                    </a:lnTo>
                    <a:lnTo>
                      <a:pt x="1981" y="1588"/>
                    </a:lnTo>
                    <a:lnTo>
                      <a:pt x="1981" y="1572"/>
                    </a:lnTo>
                    <a:lnTo>
                      <a:pt x="1985" y="1588"/>
                    </a:lnTo>
                    <a:lnTo>
                      <a:pt x="1989" y="1588"/>
                    </a:lnTo>
                    <a:lnTo>
                      <a:pt x="1989" y="1580"/>
                    </a:lnTo>
                    <a:lnTo>
                      <a:pt x="1993" y="1572"/>
                    </a:lnTo>
                    <a:lnTo>
                      <a:pt x="1993" y="1588"/>
                    </a:lnTo>
                    <a:lnTo>
                      <a:pt x="1993" y="1572"/>
                    </a:lnTo>
                    <a:lnTo>
                      <a:pt x="1997" y="1588"/>
                    </a:lnTo>
                    <a:lnTo>
                      <a:pt x="2001" y="1588"/>
                    </a:lnTo>
                    <a:lnTo>
                      <a:pt x="2001" y="1580"/>
                    </a:lnTo>
                    <a:lnTo>
                      <a:pt x="2005" y="1572"/>
                    </a:lnTo>
                    <a:lnTo>
                      <a:pt x="2005" y="1588"/>
                    </a:lnTo>
                    <a:lnTo>
                      <a:pt x="2005" y="1572"/>
                    </a:lnTo>
                    <a:lnTo>
                      <a:pt x="2009" y="1588"/>
                    </a:lnTo>
                    <a:lnTo>
                      <a:pt x="2014" y="1588"/>
                    </a:lnTo>
                    <a:lnTo>
                      <a:pt x="2018" y="1584"/>
                    </a:lnTo>
                    <a:lnTo>
                      <a:pt x="2018" y="1588"/>
                    </a:lnTo>
                    <a:lnTo>
                      <a:pt x="2018" y="1584"/>
                    </a:lnTo>
                    <a:lnTo>
                      <a:pt x="2022" y="1588"/>
                    </a:lnTo>
                    <a:lnTo>
                      <a:pt x="2026" y="1588"/>
                    </a:lnTo>
                    <a:lnTo>
                      <a:pt x="2026" y="1584"/>
                    </a:lnTo>
                    <a:lnTo>
                      <a:pt x="2030" y="1576"/>
                    </a:lnTo>
                    <a:lnTo>
                      <a:pt x="2030" y="1588"/>
                    </a:lnTo>
                    <a:lnTo>
                      <a:pt x="2030" y="1560"/>
                    </a:lnTo>
                    <a:lnTo>
                      <a:pt x="2034" y="1588"/>
                    </a:lnTo>
                    <a:lnTo>
                      <a:pt x="2050" y="1588"/>
                    </a:lnTo>
                    <a:lnTo>
                      <a:pt x="2050" y="1584"/>
                    </a:lnTo>
                    <a:lnTo>
                      <a:pt x="2054" y="1576"/>
                    </a:lnTo>
                    <a:lnTo>
                      <a:pt x="2054" y="1560"/>
                    </a:lnTo>
                    <a:lnTo>
                      <a:pt x="2054" y="1576"/>
                    </a:lnTo>
                    <a:lnTo>
                      <a:pt x="2058" y="1584"/>
                    </a:lnTo>
                    <a:lnTo>
                      <a:pt x="2058" y="1588"/>
                    </a:lnTo>
                    <a:lnTo>
                      <a:pt x="2058" y="1584"/>
                    </a:lnTo>
                    <a:lnTo>
                      <a:pt x="2062" y="1588"/>
                    </a:lnTo>
                    <a:lnTo>
                      <a:pt x="2066" y="1588"/>
                    </a:lnTo>
                    <a:lnTo>
                      <a:pt x="2066" y="1584"/>
                    </a:lnTo>
                    <a:lnTo>
                      <a:pt x="2070" y="1588"/>
                    </a:lnTo>
                    <a:lnTo>
                      <a:pt x="2075" y="1588"/>
                    </a:lnTo>
                    <a:lnTo>
                      <a:pt x="2079" y="1584"/>
                    </a:lnTo>
                    <a:lnTo>
                      <a:pt x="2079" y="1560"/>
                    </a:lnTo>
                    <a:lnTo>
                      <a:pt x="2083" y="1580"/>
                    </a:lnTo>
                    <a:lnTo>
                      <a:pt x="2083" y="1588"/>
                    </a:lnTo>
                    <a:lnTo>
                      <a:pt x="2083" y="1580"/>
                    </a:lnTo>
                    <a:lnTo>
                      <a:pt x="2087" y="1588"/>
                    </a:lnTo>
                    <a:lnTo>
                      <a:pt x="2091" y="1588"/>
                    </a:lnTo>
                    <a:lnTo>
                      <a:pt x="2091" y="1584"/>
                    </a:lnTo>
                    <a:lnTo>
                      <a:pt x="2095" y="1588"/>
                    </a:lnTo>
                    <a:lnTo>
                      <a:pt x="2103" y="1588"/>
                    </a:lnTo>
                    <a:lnTo>
                      <a:pt x="2103" y="1584"/>
                    </a:lnTo>
                    <a:lnTo>
                      <a:pt x="2107" y="1588"/>
                    </a:lnTo>
                    <a:lnTo>
                      <a:pt x="2115" y="1588"/>
                    </a:lnTo>
                    <a:lnTo>
                      <a:pt x="2115" y="1584"/>
                    </a:lnTo>
                    <a:lnTo>
                      <a:pt x="2119" y="1588"/>
                    </a:lnTo>
                    <a:lnTo>
                      <a:pt x="2127" y="1588"/>
                    </a:lnTo>
                    <a:lnTo>
                      <a:pt x="2127" y="1576"/>
                    </a:lnTo>
                    <a:lnTo>
                      <a:pt x="2132" y="1576"/>
                    </a:lnTo>
                    <a:lnTo>
                      <a:pt x="2132" y="1588"/>
                    </a:lnTo>
                    <a:lnTo>
                      <a:pt x="2132" y="1576"/>
                    </a:lnTo>
                    <a:lnTo>
                      <a:pt x="2136" y="1588"/>
                    </a:lnTo>
                    <a:lnTo>
                      <a:pt x="2140" y="1588"/>
                    </a:lnTo>
                    <a:lnTo>
                      <a:pt x="2140" y="1556"/>
                    </a:lnTo>
                    <a:lnTo>
                      <a:pt x="2144" y="1576"/>
                    </a:lnTo>
                    <a:lnTo>
                      <a:pt x="2144" y="1588"/>
                    </a:lnTo>
                    <a:lnTo>
                      <a:pt x="2144" y="1576"/>
                    </a:lnTo>
                    <a:lnTo>
                      <a:pt x="2148" y="1588"/>
                    </a:lnTo>
                    <a:lnTo>
                      <a:pt x="2152" y="1588"/>
                    </a:lnTo>
                    <a:lnTo>
                      <a:pt x="2152" y="1572"/>
                    </a:lnTo>
                    <a:lnTo>
                      <a:pt x="2156" y="1572"/>
                    </a:lnTo>
                    <a:lnTo>
                      <a:pt x="2156" y="1588"/>
                    </a:lnTo>
                    <a:lnTo>
                      <a:pt x="2156" y="1572"/>
                    </a:lnTo>
                    <a:lnTo>
                      <a:pt x="2160" y="1588"/>
                    </a:lnTo>
                    <a:lnTo>
                      <a:pt x="2164" y="1584"/>
                    </a:lnTo>
                    <a:lnTo>
                      <a:pt x="2164" y="1531"/>
                    </a:lnTo>
                    <a:lnTo>
                      <a:pt x="2168" y="1519"/>
                    </a:lnTo>
                    <a:lnTo>
                      <a:pt x="2168" y="1588"/>
                    </a:lnTo>
                    <a:lnTo>
                      <a:pt x="2168" y="1519"/>
                    </a:lnTo>
                    <a:lnTo>
                      <a:pt x="2172" y="1588"/>
                    </a:lnTo>
                    <a:lnTo>
                      <a:pt x="2176" y="1588"/>
                    </a:lnTo>
                    <a:lnTo>
                      <a:pt x="2176" y="1572"/>
                    </a:lnTo>
                    <a:lnTo>
                      <a:pt x="2180" y="1568"/>
                    </a:lnTo>
                    <a:lnTo>
                      <a:pt x="2180" y="1588"/>
                    </a:lnTo>
                    <a:lnTo>
                      <a:pt x="2180" y="1568"/>
                    </a:lnTo>
                    <a:lnTo>
                      <a:pt x="2184" y="1588"/>
                    </a:lnTo>
                    <a:lnTo>
                      <a:pt x="2188" y="1588"/>
                    </a:lnTo>
                    <a:lnTo>
                      <a:pt x="2193" y="1584"/>
                    </a:lnTo>
                    <a:lnTo>
                      <a:pt x="2193" y="1588"/>
                    </a:lnTo>
                    <a:lnTo>
                      <a:pt x="2193" y="1584"/>
                    </a:lnTo>
                    <a:lnTo>
                      <a:pt x="2197" y="1588"/>
                    </a:lnTo>
                    <a:lnTo>
                      <a:pt x="2201" y="1588"/>
                    </a:lnTo>
                    <a:lnTo>
                      <a:pt x="2201" y="1584"/>
                    </a:lnTo>
                    <a:lnTo>
                      <a:pt x="2205" y="1580"/>
                    </a:lnTo>
                    <a:lnTo>
                      <a:pt x="2205" y="1588"/>
                    </a:lnTo>
                    <a:lnTo>
                      <a:pt x="2205" y="1576"/>
                    </a:lnTo>
                    <a:lnTo>
                      <a:pt x="2209" y="1588"/>
                    </a:lnTo>
                    <a:lnTo>
                      <a:pt x="2217" y="1588"/>
                    </a:lnTo>
                    <a:lnTo>
                      <a:pt x="2217" y="1584"/>
                    </a:lnTo>
                    <a:lnTo>
                      <a:pt x="2221" y="1588"/>
                    </a:lnTo>
                    <a:lnTo>
                      <a:pt x="2225" y="1588"/>
                    </a:lnTo>
                    <a:lnTo>
                      <a:pt x="2229" y="1584"/>
                    </a:lnTo>
                    <a:lnTo>
                      <a:pt x="2229" y="1588"/>
                    </a:lnTo>
                    <a:lnTo>
                      <a:pt x="2229" y="1572"/>
                    </a:lnTo>
                    <a:lnTo>
                      <a:pt x="2233" y="1588"/>
                    </a:lnTo>
                    <a:lnTo>
                      <a:pt x="2249" y="1588"/>
                    </a:lnTo>
                    <a:lnTo>
                      <a:pt x="2254" y="1584"/>
                    </a:lnTo>
                    <a:lnTo>
                      <a:pt x="2254" y="1580"/>
                    </a:lnTo>
                    <a:lnTo>
                      <a:pt x="2254" y="1584"/>
                    </a:lnTo>
                    <a:lnTo>
                      <a:pt x="2258" y="1588"/>
                    </a:lnTo>
                    <a:lnTo>
                      <a:pt x="2278" y="1588"/>
                    </a:lnTo>
                    <a:lnTo>
                      <a:pt x="2278" y="1580"/>
                    </a:lnTo>
                    <a:lnTo>
                      <a:pt x="2282" y="1588"/>
                    </a:lnTo>
                    <a:lnTo>
                      <a:pt x="2302" y="1588"/>
                    </a:lnTo>
                    <a:lnTo>
                      <a:pt x="2302" y="1572"/>
                    </a:lnTo>
                    <a:lnTo>
                      <a:pt x="2306" y="1580"/>
                    </a:lnTo>
                    <a:lnTo>
                      <a:pt x="2306" y="1588"/>
                    </a:lnTo>
                    <a:lnTo>
                      <a:pt x="2306" y="1580"/>
                    </a:lnTo>
                    <a:lnTo>
                      <a:pt x="2310" y="1588"/>
                    </a:lnTo>
                    <a:lnTo>
                      <a:pt x="2315" y="1588"/>
                    </a:lnTo>
                    <a:lnTo>
                      <a:pt x="2315" y="1576"/>
                    </a:lnTo>
                    <a:lnTo>
                      <a:pt x="2319" y="1580"/>
                    </a:lnTo>
                    <a:lnTo>
                      <a:pt x="2319" y="1588"/>
                    </a:lnTo>
                    <a:lnTo>
                      <a:pt x="2319" y="1580"/>
                    </a:lnTo>
                    <a:lnTo>
                      <a:pt x="2323" y="1588"/>
                    </a:lnTo>
                    <a:lnTo>
                      <a:pt x="2327" y="1588"/>
                    </a:lnTo>
                    <a:lnTo>
                      <a:pt x="2327" y="1576"/>
                    </a:lnTo>
                    <a:lnTo>
                      <a:pt x="2331" y="1580"/>
                    </a:lnTo>
                    <a:lnTo>
                      <a:pt x="2331" y="1588"/>
                    </a:lnTo>
                    <a:lnTo>
                      <a:pt x="2331" y="1580"/>
                    </a:lnTo>
                    <a:lnTo>
                      <a:pt x="2335" y="1588"/>
                    </a:lnTo>
                    <a:lnTo>
                      <a:pt x="2339" y="1588"/>
                    </a:lnTo>
                    <a:lnTo>
                      <a:pt x="2339" y="1568"/>
                    </a:lnTo>
                    <a:lnTo>
                      <a:pt x="2343" y="1572"/>
                    </a:lnTo>
                    <a:lnTo>
                      <a:pt x="2343" y="1588"/>
                    </a:lnTo>
                    <a:lnTo>
                      <a:pt x="2343" y="1572"/>
                    </a:lnTo>
                    <a:lnTo>
                      <a:pt x="2347" y="1588"/>
                    </a:lnTo>
                    <a:lnTo>
                      <a:pt x="2351" y="1588"/>
                    </a:lnTo>
                    <a:lnTo>
                      <a:pt x="2351" y="1568"/>
                    </a:lnTo>
                    <a:lnTo>
                      <a:pt x="2355" y="1564"/>
                    </a:lnTo>
                    <a:lnTo>
                      <a:pt x="2355" y="1588"/>
                    </a:lnTo>
                    <a:lnTo>
                      <a:pt x="2355" y="1564"/>
                    </a:lnTo>
                    <a:lnTo>
                      <a:pt x="2359" y="1588"/>
                    </a:lnTo>
                    <a:lnTo>
                      <a:pt x="2363" y="1588"/>
                    </a:lnTo>
                    <a:lnTo>
                      <a:pt x="2367" y="1584"/>
                    </a:lnTo>
                    <a:lnTo>
                      <a:pt x="2367" y="1588"/>
                    </a:lnTo>
                    <a:lnTo>
                      <a:pt x="2367" y="1584"/>
                    </a:lnTo>
                    <a:lnTo>
                      <a:pt x="2371" y="1588"/>
                    </a:lnTo>
                    <a:lnTo>
                      <a:pt x="2376" y="1588"/>
                    </a:lnTo>
                    <a:lnTo>
                      <a:pt x="2376" y="1572"/>
                    </a:lnTo>
                    <a:lnTo>
                      <a:pt x="2380" y="1568"/>
                    </a:lnTo>
                    <a:lnTo>
                      <a:pt x="2380" y="1588"/>
                    </a:lnTo>
                    <a:lnTo>
                      <a:pt x="2380" y="1568"/>
                    </a:lnTo>
                    <a:lnTo>
                      <a:pt x="2384" y="1588"/>
                    </a:lnTo>
                    <a:lnTo>
                      <a:pt x="2392" y="1588"/>
                    </a:lnTo>
                    <a:lnTo>
                      <a:pt x="2392" y="1580"/>
                    </a:lnTo>
                    <a:lnTo>
                      <a:pt x="2396" y="1588"/>
                    </a:lnTo>
                    <a:lnTo>
                      <a:pt x="2400" y="1588"/>
                    </a:lnTo>
                    <a:lnTo>
                      <a:pt x="2400" y="1584"/>
                    </a:lnTo>
                    <a:lnTo>
                      <a:pt x="2404" y="1576"/>
                    </a:lnTo>
                    <a:lnTo>
                      <a:pt x="2404" y="1584"/>
                    </a:lnTo>
                    <a:lnTo>
                      <a:pt x="2404" y="1572"/>
                    </a:lnTo>
                    <a:lnTo>
                      <a:pt x="2404" y="1584"/>
                    </a:lnTo>
                    <a:lnTo>
                      <a:pt x="2408" y="1588"/>
                    </a:lnTo>
                    <a:lnTo>
                      <a:pt x="2412" y="1588"/>
                    </a:lnTo>
                    <a:lnTo>
                      <a:pt x="2416" y="1584"/>
                    </a:lnTo>
                    <a:lnTo>
                      <a:pt x="2416" y="1588"/>
                    </a:lnTo>
                    <a:lnTo>
                      <a:pt x="2416" y="1584"/>
                    </a:lnTo>
                    <a:lnTo>
                      <a:pt x="2420" y="1588"/>
                    </a:lnTo>
                    <a:lnTo>
                      <a:pt x="2424" y="1588"/>
                    </a:lnTo>
                    <a:lnTo>
                      <a:pt x="2424" y="1584"/>
                    </a:lnTo>
                    <a:lnTo>
                      <a:pt x="2428" y="1580"/>
                    </a:lnTo>
                    <a:lnTo>
                      <a:pt x="2428" y="1588"/>
                    </a:lnTo>
                    <a:lnTo>
                      <a:pt x="2428" y="1572"/>
                    </a:lnTo>
                    <a:lnTo>
                      <a:pt x="2432" y="1588"/>
                    </a:lnTo>
                    <a:lnTo>
                      <a:pt x="2441" y="1588"/>
                    </a:lnTo>
                    <a:lnTo>
                      <a:pt x="2441" y="1584"/>
                    </a:lnTo>
                    <a:lnTo>
                      <a:pt x="2445" y="1588"/>
                    </a:lnTo>
                    <a:lnTo>
                      <a:pt x="2453" y="1588"/>
                    </a:lnTo>
                    <a:lnTo>
                      <a:pt x="2453" y="1584"/>
                    </a:lnTo>
                    <a:lnTo>
                      <a:pt x="2457" y="1588"/>
                    </a:lnTo>
                    <a:lnTo>
                      <a:pt x="2477" y="1588"/>
                    </a:lnTo>
                    <a:lnTo>
                      <a:pt x="2477" y="1564"/>
                    </a:lnTo>
                    <a:lnTo>
                      <a:pt x="2481" y="1568"/>
                    </a:lnTo>
                    <a:lnTo>
                      <a:pt x="2481" y="1588"/>
                    </a:lnTo>
                    <a:lnTo>
                      <a:pt x="2481" y="1568"/>
                    </a:lnTo>
                    <a:lnTo>
                      <a:pt x="2485" y="1588"/>
                    </a:lnTo>
                    <a:lnTo>
                      <a:pt x="2489" y="1588"/>
                    </a:lnTo>
                  </a:path>
                </a:pathLst>
              </a:custGeom>
              <a:noFill/>
              <a:ln w="6350" cap="flat">
                <a:solidFill>
                  <a:srgbClr val="22B14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 dirty="0"/>
              </a:p>
            </p:txBody>
          </p:sp>
          <p:sp>
            <p:nvSpPr>
              <p:cNvPr id="94" name="Rectangle 290"/>
              <p:cNvSpPr>
                <a:spLocks noChangeArrowheads="1"/>
              </p:cNvSpPr>
              <p:nvPr/>
            </p:nvSpPr>
            <p:spPr bwMode="auto">
              <a:xfrm>
                <a:off x="7365403" y="4809833"/>
                <a:ext cx="141808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</a:rPr>
                  <a:t>81</a:t>
                </a:r>
                <a:endParaRPr kumimoji="0" lang="de-DE" altLang="de-DE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7" name="Rectangle 293"/>
              <p:cNvSpPr>
                <a:spLocks noChangeArrowheads="1"/>
              </p:cNvSpPr>
              <p:nvPr/>
            </p:nvSpPr>
            <p:spPr bwMode="auto">
              <a:xfrm>
                <a:off x="7694454" y="3630275"/>
                <a:ext cx="212712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</a:rPr>
                  <a:t>119</a:t>
                </a:r>
                <a:endParaRPr kumimoji="0" lang="de-DE" altLang="de-DE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9" name="Rectangle 295"/>
              <p:cNvSpPr>
                <a:spLocks noChangeArrowheads="1"/>
              </p:cNvSpPr>
              <p:nvPr/>
            </p:nvSpPr>
            <p:spPr bwMode="auto">
              <a:xfrm>
                <a:off x="8593228" y="3927334"/>
                <a:ext cx="212712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</a:rPr>
                  <a:t>141</a:t>
                </a:r>
                <a:endParaRPr kumimoji="0" lang="de-DE" altLang="de-DE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8" name="Rectangle 304"/>
              <p:cNvSpPr>
                <a:spLocks noChangeArrowheads="1"/>
              </p:cNvSpPr>
              <p:nvPr/>
            </p:nvSpPr>
            <p:spPr bwMode="auto">
              <a:xfrm>
                <a:off x="6793407" y="3585413"/>
                <a:ext cx="3907362" cy="2093961"/>
              </a:xfrm>
              <a:prstGeom prst="rect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09" name="Line 305"/>
              <p:cNvSpPr>
                <a:spLocks noChangeShapeType="1"/>
              </p:cNvSpPr>
              <p:nvPr/>
            </p:nvSpPr>
            <p:spPr bwMode="auto">
              <a:xfrm>
                <a:off x="6762272" y="5674524"/>
                <a:ext cx="31134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10" name="Rectangle 306"/>
              <p:cNvSpPr>
                <a:spLocks noChangeArrowheads="1"/>
              </p:cNvSpPr>
              <p:nvPr/>
            </p:nvSpPr>
            <p:spPr bwMode="auto">
              <a:xfrm>
                <a:off x="6605044" y="5640575"/>
                <a:ext cx="151759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</a:t>
                </a:r>
                <a:endParaRPr kumimoji="0" lang="de-DE" altLang="de-DE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1" name="Line 307"/>
              <p:cNvSpPr>
                <a:spLocks noChangeShapeType="1"/>
              </p:cNvSpPr>
              <p:nvPr/>
            </p:nvSpPr>
            <p:spPr bwMode="auto">
              <a:xfrm>
                <a:off x="6774726" y="5605413"/>
                <a:ext cx="1868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12" name="Line 308"/>
              <p:cNvSpPr>
                <a:spLocks noChangeShapeType="1"/>
              </p:cNvSpPr>
              <p:nvPr/>
            </p:nvSpPr>
            <p:spPr bwMode="auto">
              <a:xfrm>
                <a:off x="6774726" y="5536301"/>
                <a:ext cx="1868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13" name="Line 309"/>
              <p:cNvSpPr>
                <a:spLocks noChangeShapeType="1"/>
              </p:cNvSpPr>
              <p:nvPr/>
            </p:nvSpPr>
            <p:spPr bwMode="auto">
              <a:xfrm>
                <a:off x="6774726" y="5467189"/>
                <a:ext cx="1868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14" name="Line 310"/>
              <p:cNvSpPr>
                <a:spLocks noChangeShapeType="1"/>
              </p:cNvSpPr>
              <p:nvPr/>
            </p:nvSpPr>
            <p:spPr bwMode="auto">
              <a:xfrm>
                <a:off x="6774726" y="5402928"/>
                <a:ext cx="1868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15" name="Line 311"/>
              <p:cNvSpPr>
                <a:spLocks noChangeShapeType="1"/>
              </p:cNvSpPr>
              <p:nvPr/>
            </p:nvSpPr>
            <p:spPr bwMode="auto">
              <a:xfrm>
                <a:off x="6762272" y="5332604"/>
                <a:ext cx="31134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16" name="Rectangle 312"/>
              <p:cNvSpPr>
                <a:spLocks noChangeArrowheads="1"/>
              </p:cNvSpPr>
              <p:nvPr/>
            </p:nvSpPr>
            <p:spPr bwMode="auto">
              <a:xfrm>
                <a:off x="6605044" y="5298654"/>
                <a:ext cx="151759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5</a:t>
                </a:r>
                <a:endParaRPr kumimoji="0" lang="de-DE" altLang="de-DE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7" name="Line 313"/>
              <p:cNvSpPr>
                <a:spLocks noChangeShapeType="1"/>
              </p:cNvSpPr>
              <p:nvPr/>
            </p:nvSpPr>
            <p:spPr bwMode="auto">
              <a:xfrm>
                <a:off x="6774726" y="5263492"/>
                <a:ext cx="1868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18" name="Line 314"/>
              <p:cNvSpPr>
                <a:spLocks noChangeShapeType="1"/>
              </p:cNvSpPr>
              <p:nvPr/>
            </p:nvSpPr>
            <p:spPr bwMode="auto">
              <a:xfrm>
                <a:off x="6774726" y="5194380"/>
                <a:ext cx="1868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19" name="Line 315"/>
              <p:cNvSpPr>
                <a:spLocks noChangeShapeType="1"/>
              </p:cNvSpPr>
              <p:nvPr/>
            </p:nvSpPr>
            <p:spPr bwMode="auto">
              <a:xfrm>
                <a:off x="6774726" y="5125269"/>
                <a:ext cx="1868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20" name="Line 316"/>
              <p:cNvSpPr>
                <a:spLocks noChangeShapeType="1"/>
              </p:cNvSpPr>
              <p:nvPr/>
            </p:nvSpPr>
            <p:spPr bwMode="auto">
              <a:xfrm>
                <a:off x="6774726" y="5056157"/>
                <a:ext cx="1868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21" name="Line 317"/>
              <p:cNvSpPr>
                <a:spLocks noChangeShapeType="1"/>
              </p:cNvSpPr>
              <p:nvPr/>
            </p:nvSpPr>
            <p:spPr bwMode="auto">
              <a:xfrm>
                <a:off x="6762272" y="4991895"/>
                <a:ext cx="31134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22" name="Rectangle 318"/>
              <p:cNvSpPr>
                <a:spLocks noChangeArrowheads="1"/>
              </p:cNvSpPr>
              <p:nvPr/>
            </p:nvSpPr>
            <p:spPr bwMode="auto">
              <a:xfrm>
                <a:off x="6605044" y="4956733"/>
                <a:ext cx="151759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.0</a:t>
                </a:r>
                <a:endParaRPr kumimoji="0" lang="de-DE" altLang="de-DE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3" name="Line 319"/>
              <p:cNvSpPr>
                <a:spLocks noChangeShapeType="1"/>
              </p:cNvSpPr>
              <p:nvPr/>
            </p:nvSpPr>
            <p:spPr bwMode="auto">
              <a:xfrm>
                <a:off x="6774726" y="4922784"/>
                <a:ext cx="1868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24" name="Line 320"/>
              <p:cNvSpPr>
                <a:spLocks noChangeShapeType="1"/>
              </p:cNvSpPr>
              <p:nvPr/>
            </p:nvSpPr>
            <p:spPr bwMode="auto">
              <a:xfrm>
                <a:off x="6774726" y="4852460"/>
                <a:ext cx="1868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25" name="Line 321"/>
              <p:cNvSpPr>
                <a:spLocks noChangeShapeType="1"/>
              </p:cNvSpPr>
              <p:nvPr/>
            </p:nvSpPr>
            <p:spPr bwMode="auto">
              <a:xfrm>
                <a:off x="6774726" y="4783348"/>
                <a:ext cx="1868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26" name="Line 322"/>
              <p:cNvSpPr>
                <a:spLocks noChangeShapeType="1"/>
              </p:cNvSpPr>
              <p:nvPr/>
            </p:nvSpPr>
            <p:spPr bwMode="auto">
              <a:xfrm>
                <a:off x="6774726" y="4714236"/>
                <a:ext cx="1868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27" name="Line 323"/>
              <p:cNvSpPr>
                <a:spLocks noChangeShapeType="1"/>
              </p:cNvSpPr>
              <p:nvPr/>
            </p:nvSpPr>
            <p:spPr bwMode="auto">
              <a:xfrm>
                <a:off x="6762272" y="4645125"/>
                <a:ext cx="31134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28" name="Rectangle 324"/>
              <p:cNvSpPr>
                <a:spLocks noChangeArrowheads="1"/>
              </p:cNvSpPr>
              <p:nvPr/>
            </p:nvSpPr>
            <p:spPr bwMode="auto">
              <a:xfrm>
                <a:off x="6605044" y="4609963"/>
                <a:ext cx="151759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.5</a:t>
                </a:r>
                <a:endParaRPr kumimoji="0" lang="de-DE" altLang="de-DE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9" name="Line 325"/>
              <p:cNvSpPr>
                <a:spLocks noChangeShapeType="1"/>
              </p:cNvSpPr>
              <p:nvPr/>
            </p:nvSpPr>
            <p:spPr bwMode="auto">
              <a:xfrm>
                <a:off x="6774726" y="4576013"/>
                <a:ext cx="1868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30" name="Line 326"/>
              <p:cNvSpPr>
                <a:spLocks noChangeShapeType="1"/>
              </p:cNvSpPr>
              <p:nvPr/>
            </p:nvSpPr>
            <p:spPr bwMode="auto">
              <a:xfrm>
                <a:off x="6774726" y="4511751"/>
                <a:ext cx="1868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31" name="Line 327"/>
              <p:cNvSpPr>
                <a:spLocks noChangeShapeType="1"/>
              </p:cNvSpPr>
              <p:nvPr/>
            </p:nvSpPr>
            <p:spPr bwMode="auto">
              <a:xfrm>
                <a:off x="6774726" y="4442640"/>
                <a:ext cx="1868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32" name="Line 328"/>
              <p:cNvSpPr>
                <a:spLocks noChangeShapeType="1"/>
              </p:cNvSpPr>
              <p:nvPr/>
            </p:nvSpPr>
            <p:spPr bwMode="auto">
              <a:xfrm>
                <a:off x="6774726" y="4372316"/>
                <a:ext cx="1868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33" name="Line 329"/>
              <p:cNvSpPr>
                <a:spLocks noChangeShapeType="1"/>
              </p:cNvSpPr>
              <p:nvPr/>
            </p:nvSpPr>
            <p:spPr bwMode="auto">
              <a:xfrm>
                <a:off x="6762272" y="4303204"/>
                <a:ext cx="31134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34" name="Rectangle 330"/>
              <p:cNvSpPr>
                <a:spLocks noChangeArrowheads="1"/>
              </p:cNvSpPr>
              <p:nvPr/>
            </p:nvSpPr>
            <p:spPr bwMode="auto">
              <a:xfrm>
                <a:off x="6605044" y="4269254"/>
                <a:ext cx="151759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.0</a:t>
                </a:r>
                <a:endParaRPr kumimoji="0" lang="de-DE" altLang="de-DE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5" name="Line 331"/>
              <p:cNvSpPr>
                <a:spLocks noChangeShapeType="1"/>
              </p:cNvSpPr>
              <p:nvPr/>
            </p:nvSpPr>
            <p:spPr bwMode="auto">
              <a:xfrm>
                <a:off x="6774726" y="4234092"/>
                <a:ext cx="1868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36" name="Line 332"/>
              <p:cNvSpPr>
                <a:spLocks noChangeShapeType="1"/>
              </p:cNvSpPr>
              <p:nvPr/>
            </p:nvSpPr>
            <p:spPr bwMode="auto">
              <a:xfrm>
                <a:off x="6774726" y="4164981"/>
                <a:ext cx="1868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37" name="Line 333"/>
              <p:cNvSpPr>
                <a:spLocks noChangeShapeType="1"/>
              </p:cNvSpPr>
              <p:nvPr/>
            </p:nvSpPr>
            <p:spPr bwMode="auto">
              <a:xfrm>
                <a:off x="6774726" y="4095869"/>
                <a:ext cx="1868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38" name="Line 334"/>
              <p:cNvSpPr>
                <a:spLocks noChangeShapeType="1"/>
              </p:cNvSpPr>
              <p:nvPr/>
            </p:nvSpPr>
            <p:spPr bwMode="auto">
              <a:xfrm>
                <a:off x="6774726" y="4031607"/>
                <a:ext cx="1868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39" name="Line 335"/>
              <p:cNvSpPr>
                <a:spLocks noChangeShapeType="1"/>
              </p:cNvSpPr>
              <p:nvPr/>
            </p:nvSpPr>
            <p:spPr bwMode="auto">
              <a:xfrm>
                <a:off x="6762272" y="3962496"/>
                <a:ext cx="31134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40" name="Rectangle 336"/>
              <p:cNvSpPr>
                <a:spLocks noChangeArrowheads="1"/>
              </p:cNvSpPr>
              <p:nvPr/>
            </p:nvSpPr>
            <p:spPr bwMode="auto">
              <a:xfrm>
                <a:off x="6605044" y="3927334"/>
                <a:ext cx="151759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.5</a:t>
                </a:r>
                <a:endParaRPr kumimoji="0" lang="de-DE" altLang="de-DE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1" name="Line 337"/>
              <p:cNvSpPr>
                <a:spLocks noChangeShapeType="1"/>
              </p:cNvSpPr>
              <p:nvPr/>
            </p:nvSpPr>
            <p:spPr bwMode="auto">
              <a:xfrm>
                <a:off x="6774726" y="3892172"/>
                <a:ext cx="1868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42" name="Line 338"/>
              <p:cNvSpPr>
                <a:spLocks noChangeShapeType="1"/>
              </p:cNvSpPr>
              <p:nvPr/>
            </p:nvSpPr>
            <p:spPr bwMode="auto">
              <a:xfrm>
                <a:off x="6774726" y="3823060"/>
                <a:ext cx="1868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43" name="Line 339"/>
              <p:cNvSpPr>
                <a:spLocks noChangeShapeType="1"/>
              </p:cNvSpPr>
              <p:nvPr/>
            </p:nvSpPr>
            <p:spPr bwMode="auto">
              <a:xfrm>
                <a:off x="6774726" y="3753948"/>
                <a:ext cx="1868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44" name="Line 340"/>
              <p:cNvSpPr>
                <a:spLocks noChangeShapeType="1"/>
              </p:cNvSpPr>
              <p:nvPr/>
            </p:nvSpPr>
            <p:spPr bwMode="auto">
              <a:xfrm>
                <a:off x="6774726" y="3684837"/>
                <a:ext cx="1868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45" name="Line 341"/>
              <p:cNvSpPr>
                <a:spLocks noChangeShapeType="1"/>
              </p:cNvSpPr>
              <p:nvPr/>
            </p:nvSpPr>
            <p:spPr bwMode="auto">
              <a:xfrm>
                <a:off x="6762272" y="3620575"/>
                <a:ext cx="31134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46" name="Rectangle 342"/>
              <p:cNvSpPr>
                <a:spLocks noChangeArrowheads="1"/>
              </p:cNvSpPr>
              <p:nvPr/>
            </p:nvSpPr>
            <p:spPr bwMode="auto">
              <a:xfrm>
                <a:off x="6679766" y="3630275"/>
                <a:ext cx="60953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</a:t>
                </a:r>
                <a:endParaRPr kumimoji="0" lang="de-DE" altLang="de-DE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7" name="Rectangle 343"/>
              <p:cNvSpPr>
                <a:spLocks noChangeArrowheads="1"/>
              </p:cNvSpPr>
              <p:nvPr/>
            </p:nvSpPr>
            <p:spPr bwMode="auto">
              <a:xfrm>
                <a:off x="6497871" y="3684837"/>
                <a:ext cx="17663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x10</a:t>
                </a:r>
                <a:endParaRPr kumimoji="0" lang="de-DE" altLang="de-DE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8" name="Rectangle 344"/>
              <p:cNvSpPr>
                <a:spLocks noChangeArrowheads="1"/>
              </p:cNvSpPr>
              <p:nvPr/>
            </p:nvSpPr>
            <p:spPr bwMode="auto">
              <a:xfrm>
                <a:off x="6515942" y="3330753"/>
                <a:ext cx="517475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4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Intens</a:t>
                </a:r>
                <a:r>
                  <a:rPr lang="de-DE" altLang="de-DE" sz="1400" dirty="0" err="1" smtClean="0">
                    <a:solidFill>
                      <a:srgbClr val="000000"/>
                    </a:solidFill>
                    <a:latin typeface="Arial" panose="020B0604020202020204" pitchFamily="34" charset="0"/>
                  </a:rPr>
                  <a:t>ity</a:t>
                </a:r>
                <a:endParaRPr kumimoji="0" lang="de-DE" altLang="de-DE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9" name="Line 345"/>
              <p:cNvSpPr>
                <a:spLocks noChangeShapeType="1"/>
              </p:cNvSpPr>
              <p:nvPr/>
            </p:nvSpPr>
            <p:spPr bwMode="auto">
              <a:xfrm>
                <a:off x="6793407" y="5679374"/>
                <a:ext cx="0" cy="1576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50" name="Line 346"/>
              <p:cNvSpPr>
                <a:spLocks noChangeShapeType="1"/>
              </p:cNvSpPr>
              <p:nvPr/>
            </p:nvSpPr>
            <p:spPr bwMode="auto">
              <a:xfrm>
                <a:off x="6989553" y="5679374"/>
                <a:ext cx="0" cy="2546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51" name="Rectangle 347"/>
              <p:cNvSpPr>
                <a:spLocks noChangeArrowheads="1"/>
              </p:cNvSpPr>
              <p:nvPr/>
            </p:nvSpPr>
            <p:spPr bwMode="auto">
              <a:xfrm>
                <a:off x="6931955" y="5704836"/>
                <a:ext cx="121905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</a:t>
                </a:r>
                <a:endParaRPr kumimoji="0" lang="de-DE" altLang="de-DE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2" name="Line 348"/>
              <p:cNvSpPr>
                <a:spLocks noChangeShapeType="1"/>
              </p:cNvSpPr>
              <p:nvPr/>
            </p:nvSpPr>
            <p:spPr bwMode="auto">
              <a:xfrm>
                <a:off x="7179473" y="5679374"/>
                <a:ext cx="0" cy="1576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53" name="Line 349"/>
              <p:cNvSpPr>
                <a:spLocks noChangeShapeType="1"/>
              </p:cNvSpPr>
              <p:nvPr/>
            </p:nvSpPr>
            <p:spPr bwMode="auto">
              <a:xfrm>
                <a:off x="7377176" y="5679374"/>
                <a:ext cx="0" cy="2546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54" name="Rectangle 350"/>
              <p:cNvSpPr>
                <a:spLocks noChangeArrowheads="1"/>
              </p:cNvSpPr>
              <p:nvPr/>
            </p:nvSpPr>
            <p:spPr bwMode="auto">
              <a:xfrm>
                <a:off x="7319577" y="5704836"/>
                <a:ext cx="121905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0</a:t>
                </a:r>
                <a:endParaRPr kumimoji="0" lang="de-DE" altLang="de-DE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5" name="Line 351"/>
              <p:cNvSpPr>
                <a:spLocks noChangeShapeType="1"/>
              </p:cNvSpPr>
              <p:nvPr/>
            </p:nvSpPr>
            <p:spPr bwMode="auto">
              <a:xfrm>
                <a:off x="7573323" y="5679374"/>
                <a:ext cx="0" cy="1576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56" name="Line 352"/>
              <p:cNvSpPr>
                <a:spLocks noChangeShapeType="1"/>
              </p:cNvSpPr>
              <p:nvPr/>
            </p:nvSpPr>
            <p:spPr bwMode="auto">
              <a:xfrm>
                <a:off x="7763242" y="5679374"/>
                <a:ext cx="0" cy="2546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57" name="Rectangle 353"/>
              <p:cNvSpPr>
                <a:spLocks noChangeArrowheads="1"/>
              </p:cNvSpPr>
              <p:nvPr/>
            </p:nvSpPr>
            <p:spPr bwMode="auto">
              <a:xfrm>
                <a:off x="7683849" y="5704836"/>
                <a:ext cx="18285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0</a:t>
                </a:r>
                <a:endParaRPr kumimoji="0" lang="de-DE" altLang="de-DE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8" name="Line 354"/>
              <p:cNvSpPr>
                <a:spLocks noChangeShapeType="1"/>
              </p:cNvSpPr>
              <p:nvPr/>
            </p:nvSpPr>
            <p:spPr bwMode="auto">
              <a:xfrm>
                <a:off x="7959389" y="5679374"/>
                <a:ext cx="0" cy="1576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59" name="Line 355"/>
              <p:cNvSpPr>
                <a:spLocks noChangeShapeType="1"/>
              </p:cNvSpPr>
              <p:nvPr/>
            </p:nvSpPr>
            <p:spPr bwMode="auto">
              <a:xfrm>
                <a:off x="8149308" y="5679374"/>
                <a:ext cx="0" cy="2546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60" name="Rectangle 356"/>
              <p:cNvSpPr>
                <a:spLocks noChangeArrowheads="1"/>
              </p:cNvSpPr>
              <p:nvPr/>
            </p:nvSpPr>
            <p:spPr bwMode="auto">
              <a:xfrm>
                <a:off x="8069916" y="5704836"/>
                <a:ext cx="18285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20</a:t>
                </a:r>
                <a:endParaRPr kumimoji="0" lang="de-DE" altLang="de-DE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1" name="Line 357"/>
              <p:cNvSpPr>
                <a:spLocks noChangeShapeType="1"/>
              </p:cNvSpPr>
              <p:nvPr/>
            </p:nvSpPr>
            <p:spPr bwMode="auto">
              <a:xfrm>
                <a:off x="8345455" y="5679374"/>
                <a:ext cx="0" cy="1576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62" name="Line 358"/>
              <p:cNvSpPr>
                <a:spLocks noChangeShapeType="1"/>
              </p:cNvSpPr>
              <p:nvPr/>
            </p:nvSpPr>
            <p:spPr bwMode="auto">
              <a:xfrm>
                <a:off x="8541601" y="5679374"/>
                <a:ext cx="0" cy="2546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63" name="Rectangle 359"/>
              <p:cNvSpPr>
                <a:spLocks noChangeArrowheads="1"/>
              </p:cNvSpPr>
              <p:nvPr/>
            </p:nvSpPr>
            <p:spPr bwMode="auto">
              <a:xfrm>
                <a:off x="8462209" y="5704836"/>
                <a:ext cx="18285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40</a:t>
                </a:r>
                <a:endParaRPr kumimoji="0" lang="de-DE" altLang="de-DE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4" name="Line 360"/>
              <p:cNvSpPr>
                <a:spLocks noChangeShapeType="1"/>
              </p:cNvSpPr>
              <p:nvPr/>
            </p:nvSpPr>
            <p:spPr bwMode="auto">
              <a:xfrm>
                <a:off x="8731521" y="5679374"/>
                <a:ext cx="0" cy="1576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65" name="Line 361"/>
              <p:cNvSpPr>
                <a:spLocks noChangeShapeType="1"/>
              </p:cNvSpPr>
              <p:nvPr/>
            </p:nvSpPr>
            <p:spPr bwMode="auto">
              <a:xfrm>
                <a:off x="8927667" y="5679374"/>
                <a:ext cx="0" cy="2546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66" name="Rectangle 362"/>
              <p:cNvSpPr>
                <a:spLocks noChangeArrowheads="1"/>
              </p:cNvSpPr>
              <p:nvPr/>
            </p:nvSpPr>
            <p:spPr bwMode="auto">
              <a:xfrm>
                <a:off x="8848275" y="5704836"/>
                <a:ext cx="18285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60</a:t>
                </a:r>
                <a:endParaRPr kumimoji="0" lang="de-DE" altLang="de-DE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7" name="Line 363"/>
              <p:cNvSpPr>
                <a:spLocks noChangeShapeType="1"/>
              </p:cNvSpPr>
              <p:nvPr/>
            </p:nvSpPr>
            <p:spPr bwMode="auto">
              <a:xfrm>
                <a:off x="9123814" y="5679374"/>
                <a:ext cx="0" cy="1576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68" name="Line 364"/>
              <p:cNvSpPr>
                <a:spLocks noChangeShapeType="1"/>
              </p:cNvSpPr>
              <p:nvPr/>
            </p:nvSpPr>
            <p:spPr bwMode="auto">
              <a:xfrm>
                <a:off x="9313733" y="5679374"/>
                <a:ext cx="0" cy="2546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69" name="Rectangle 365"/>
              <p:cNvSpPr>
                <a:spLocks noChangeArrowheads="1"/>
              </p:cNvSpPr>
              <p:nvPr/>
            </p:nvSpPr>
            <p:spPr bwMode="auto">
              <a:xfrm>
                <a:off x="9234341" y="5704836"/>
                <a:ext cx="18285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80</a:t>
                </a:r>
                <a:endParaRPr kumimoji="0" lang="de-DE" altLang="de-DE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0" name="Line 366"/>
              <p:cNvSpPr>
                <a:spLocks noChangeShapeType="1"/>
              </p:cNvSpPr>
              <p:nvPr/>
            </p:nvSpPr>
            <p:spPr bwMode="auto">
              <a:xfrm>
                <a:off x="9509880" y="5679374"/>
                <a:ext cx="0" cy="1576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71" name="Line 367"/>
              <p:cNvSpPr>
                <a:spLocks noChangeShapeType="1"/>
              </p:cNvSpPr>
              <p:nvPr/>
            </p:nvSpPr>
            <p:spPr bwMode="auto">
              <a:xfrm>
                <a:off x="9699799" y="5679374"/>
                <a:ext cx="0" cy="2546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72" name="Rectangle 368"/>
              <p:cNvSpPr>
                <a:spLocks noChangeArrowheads="1"/>
              </p:cNvSpPr>
              <p:nvPr/>
            </p:nvSpPr>
            <p:spPr bwMode="auto">
              <a:xfrm>
                <a:off x="9620407" y="5704836"/>
                <a:ext cx="18285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0</a:t>
                </a:r>
                <a:endParaRPr kumimoji="0" lang="de-DE" altLang="de-DE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3" name="Line 369"/>
              <p:cNvSpPr>
                <a:spLocks noChangeShapeType="1"/>
              </p:cNvSpPr>
              <p:nvPr/>
            </p:nvSpPr>
            <p:spPr bwMode="auto">
              <a:xfrm>
                <a:off x="9895946" y="5679374"/>
                <a:ext cx="0" cy="1576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74" name="Line 370"/>
              <p:cNvSpPr>
                <a:spLocks noChangeShapeType="1"/>
              </p:cNvSpPr>
              <p:nvPr/>
            </p:nvSpPr>
            <p:spPr bwMode="auto">
              <a:xfrm>
                <a:off x="10092092" y="5679374"/>
                <a:ext cx="0" cy="2546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75" name="Rectangle 371"/>
              <p:cNvSpPr>
                <a:spLocks noChangeArrowheads="1"/>
              </p:cNvSpPr>
              <p:nvPr/>
            </p:nvSpPr>
            <p:spPr bwMode="auto">
              <a:xfrm>
                <a:off x="10012700" y="5704836"/>
                <a:ext cx="18285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20</a:t>
                </a:r>
                <a:endParaRPr kumimoji="0" lang="de-DE" altLang="de-DE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6" name="Line 372"/>
              <p:cNvSpPr>
                <a:spLocks noChangeShapeType="1"/>
              </p:cNvSpPr>
              <p:nvPr/>
            </p:nvSpPr>
            <p:spPr bwMode="auto">
              <a:xfrm>
                <a:off x="10282012" y="5679374"/>
                <a:ext cx="0" cy="1576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77" name="Line 373"/>
              <p:cNvSpPr>
                <a:spLocks noChangeShapeType="1"/>
              </p:cNvSpPr>
              <p:nvPr/>
            </p:nvSpPr>
            <p:spPr bwMode="auto">
              <a:xfrm>
                <a:off x="10478158" y="5679374"/>
                <a:ext cx="0" cy="2546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78" name="Rectangle 374"/>
              <p:cNvSpPr>
                <a:spLocks noChangeArrowheads="1"/>
              </p:cNvSpPr>
              <p:nvPr/>
            </p:nvSpPr>
            <p:spPr bwMode="auto">
              <a:xfrm>
                <a:off x="10398766" y="5704836"/>
                <a:ext cx="18285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40</a:t>
                </a:r>
                <a:endParaRPr kumimoji="0" lang="de-DE" altLang="de-DE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9" name="Line 375"/>
              <p:cNvSpPr>
                <a:spLocks noChangeShapeType="1"/>
              </p:cNvSpPr>
              <p:nvPr/>
            </p:nvSpPr>
            <p:spPr bwMode="auto">
              <a:xfrm>
                <a:off x="10675862" y="5679374"/>
                <a:ext cx="0" cy="1576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de-DE" sz="1400"/>
              </a:p>
            </p:txBody>
          </p:sp>
          <p:sp>
            <p:nvSpPr>
              <p:cNvPr id="180" name="Rectangle 376"/>
              <p:cNvSpPr>
                <a:spLocks noChangeArrowheads="1"/>
              </p:cNvSpPr>
              <p:nvPr/>
            </p:nvSpPr>
            <p:spPr bwMode="auto">
              <a:xfrm>
                <a:off x="10504647" y="5909867"/>
                <a:ext cx="223908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4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m/z</a:t>
                </a:r>
                <a:endParaRPr kumimoji="0" lang="de-DE" altLang="de-DE" sz="14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383" name="Textfeld 382"/>
            <p:cNvSpPr txBox="1"/>
            <p:nvPr/>
          </p:nvSpPr>
          <p:spPr>
            <a:xfrm>
              <a:off x="7967281" y="3792000"/>
              <a:ext cx="6479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 smtClean="0"/>
                <a:t>MH</a:t>
              </a:r>
              <a:r>
                <a:rPr lang="de-DE" b="1" dirty="0" smtClean="0"/>
                <a:t>+</a:t>
              </a:r>
              <a:endParaRPr lang="de-DE" b="1" dirty="0"/>
            </a:p>
          </p:txBody>
        </p:sp>
        <p:sp>
          <p:nvSpPr>
            <p:cNvPr id="384" name="Textfeld 383"/>
            <p:cNvSpPr txBox="1"/>
            <p:nvPr/>
          </p:nvSpPr>
          <p:spPr>
            <a:xfrm>
              <a:off x="9132062" y="4133923"/>
              <a:ext cx="7681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 err="1" smtClean="0"/>
                <a:t>MNa</a:t>
              </a:r>
              <a:r>
                <a:rPr lang="de-DE" b="1" dirty="0" smtClean="0"/>
                <a:t>+</a:t>
              </a:r>
              <a:endParaRPr lang="de-DE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5756453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9</Words>
  <Application>Microsoft Office PowerPoint</Application>
  <PresentationFormat>Widescreen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ndreas Kiontke</dc:creator>
  <cp:lastModifiedBy>Birkemeyer</cp:lastModifiedBy>
  <cp:revision>11</cp:revision>
  <dcterms:created xsi:type="dcterms:W3CDTF">2016-05-20T08:07:26Z</dcterms:created>
  <dcterms:modified xsi:type="dcterms:W3CDTF">2016-10-26T14:36:18Z</dcterms:modified>
</cp:coreProperties>
</file>